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43200638" cy="35999738"/>
  <p:notesSz cx="6858000" cy="9144000"/>
  <p:defaultTextStyle>
    <a:defPPr>
      <a:defRPr lang="en-US"/>
    </a:defPPr>
    <a:lvl1pPr marL="0" algn="l" defTabSz="3278981" rtl="0" eaLnBrk="1" latinLnBrk="0" hangingPunct="1">
      <a:defRPr sz="6500" kern="1200">
        <a:solidFill>
          <a:schemeClr val="tx1"/>
        </a:solidFill>
        <a:latin typeface="+mn-lt"/>
        <a:ea typeface="+mn-ea"/>
        <a:cs typeface="+mn-cs"/>
      </a:defRPr>
    </a:lvl1pPr>
    <a:lvl2pPr marL="1639491" algn="l" defTabSz="3278981" rtl="0" eaLnBrk="1" latinLnBrk="0" hangingPunct="1">
      <a:defRPr sz="6500" kern="1200">
        <a:solidFill>
          <a:schemeClr val="tx1"/>
        </a:solidFill>
        <a:latin typeface="+mn-lt"/>
        <a:ea typeface="+mn-ea"/>
        <a:cs typeface="+mn-cs"/>
      </a:defRPr>
    </a:lvl2pPr>
    <a:lvl3pPr marL="3278981" algn="l" defTabSz="3278981" rtl="0" eaLnBrk="1" latinLnBrk="0" hangingPunct="1">
      <a:defRPr sz="6500" kern="1200">
        <a:solidFill>
          <a:schemeClr val="tx1"/>
        </a:solidFill>
        <a:latin typeface="+mn-lt"/>
        <a:ea typeface="+mn-ea"/>
        <a:cs typeface="+mn-cs"/>
      </a:defRPr>
    </a:lvl3pPr>
    <a:lvl4pPr marL="4918472" algn="l" defTabSz="3278981" rtl="0" eaLnBrk="1" latinLnBrk="0" hangingPunct="1">
      <a:defRPr sz="6500" kern="1200">
        <a:solidFill>
          <a:schemeClr val="tx1"/>
        </a:solidFill>
        <a:latin typeface="+mn-lt"/>
        <a:ea typeface="+mn-ea"/>
        <a:cs typeface="+mn-cs"/>
      </a:defRPr>
    </a:lvl4pPr>
    <a:lvl5pPr marL="6557963" algn="l" defTabSz="3278981" rtl="0" eaLnBrk="1" latinLnBrk="0" hangingPunct="1">
      <a:defRPr sz="6500" kern="1200">
        <a:solidFill>
          <a:schemeClr val="tx1"/>
        </a:solidFill>
        <a:latin typeface="+mn-lt"/>
        <a:ea typeface="+mn-ea"/>
        <a:cs typeface="+mn-cs"/>
      </a:defRPr>
    </a:lvl5pPr>
    <a:lvl6pPr marL="8197453" algn="l" defTabSz="3278981" rtl="0" eaLnBrk="1" latinLnBrk="0" hangingPunct="1">
      <a:defRPr sz="6500" kern="1200">
        <a:solidFill>
          <a:schemeClr val="tx1"/>
        </a:solidFill>
        <a:latin typeface="+mn-lt"/>
        <a:ea typeface="+mn-ea"/>
        <a:cs typeface="+mn-cs"/>
      </a:defRPr>
    </a:lvl6pPr>
    <a:lvl7pPr marL="9836944" algn="l" defTabSz="3278981" rtl="0" eaLnBrk="1" latinLnBrk="0" hangingPunct="1">
      <a:defRPr sz="6500" kern="1200">
        <a:solidFill>
          <a:schemeClr val="tx1"/>
        </a:solidFill>
        <a:latin typeface="+mn-lt"/>
        <a:ea typeface="+mn-ea"/>
        <a:cs typeface="+mn-cs"/>
      </a:defRPr>
    </a:lvl7pPr>
    <a:lvl8pPr marL="11476434" algn="l" defTabSz="3278981" rtl="0" eaLnBrk="1" latinLnBrk="0" hangingPunct="1">
      <a:defRPr sz="6500" kern="1200">
        <a:solidFill>
          <a:schemeClr val="tx1"/>
        </a:solidFill>
        <a:latin typeface="+mn-lt"/>
        <a:ea typeface="+mn-ea"/>
        <a:cs typeface="+mn-cs"/>
      </a:defRPr>
    </a:lvl8pPr>
    <a:lvl9pPr marL="13115925" algn="l" defTabSz="3278981" rtl="0" eaLnBrk="1" latinLnBrk="0" hangingPunct="1">
      <a:defRPr sz="65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339" userDrawn="1">
          <p15:clr>
            <a:srgbClr val="A4A3A4"/>
          </p15:clr>
        </p15:guide>
        <p15:guide id="2" pos="1360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B9C44EB-507D-404B-B200-37955C3B5627}" v="140" dt="2025-01-19T11:52:53.43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5" d="100"/>
          <a:sy n="15" d="100"/>
        </p:scale>
        <p:origin x="1786" y="48"/>
      </p:cViewPr>
      <p:guideLst>
        <p:guide orient="horz" pos="11339"/>
        <p:guide pos="1360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Yuki Yoshimatsu" userId="ba50b75ca1f18b98" providerId="LiveId" clId="{0B9C44EB-507D-404B-B200-37955C3B5627}"/>
    <pc:docChg chg="undo custSel addSld delSld modSld">
      <pc:chgData name="Yuki Yoshimatsu" userId="ba50b75ca1f18b98" providerId="LiveId" clId="{0B9C44EB-507D-404B-B200-37955C3B5627}" dt="2025-01-19T11:53:11.424" v="405" actId="1076"/>
      <pc:docMkLst>
        <pc:docMk/>
      </pc:docMkLst>
      <pc:sldChg chg="addSp delSp modSp mod">
        <pc:chgData name="Yuki Yoshimatsu" userId="ba50b75ca1f18b98" providerId="LiveId" clId="{0B9C44EB-507D-404B-B200-37955C3B5627}" dt="2025-01-19T11:14:20.273" v="185" actId="1076"/>
        <pc:sldMkLst>
          <pc:docMk/>
          <pc:sldMk cId="3121883639" sldId="256"/>
        </pc:sldMkLst>
        <pc:spChg chg="add del mod">
          <ac:chgData name="Yuki Yoshimatsu" userId="ba50b75ca1f18b98" providerId="LiveId" clId="{0B9C44EB-507D-404B-B200-37955C3B5627}" dt="2025-01-19T07:29:36.566" v="6" actId="478"/>
          <ac:spMkLst>
            <pc:docMk/>
            <pc:sldMk cId="3121883639" sldId="256"/>
            <ac:spMk id="3" creationId="{12AA994D-F6E6-592D-FB7A-4F2B722A7BC8}"/>
          </ac:spMkLst>
        </pc:spChg>
        <pc:spChg chg="add del mod">
          <ac:chgData name="Yuki Yoshimatsu" userId="ba50b75ca1f18b98" providerId="LiveId" clId="{0B9C44EB-507D-404B-B200-37955C3B5627}" dt="2025-01-19T07:29:36.566" v="6" actId="478"/>
          <ac:spMkLst>
            <pc:docMk/>
            <pc:sldMk cId="3121883639" sldId="256"/>
            <ac:spMk id="4" creationId="{1E726915-7221-20C2-0CF3-84AC6A4888AC}"/>
          </ac:spMkLst>
        </pc:spChg>
        <pc:spChg chg="add del mod">
          <ac:chgData name="Yuki Yoshimatsu" userId="ba50b75ca1f18b98" providerId="LiveId" clId="{0B9C44EB-507D-404B-B200-37955C3B5627}" dt="2025-01-19T07:29:36.566" v="6" actId="478"/>
          <ac:spMkLst>
            <pc:docMk/>
            <pc:sldMk cId="3121883639" sldId="256"/>
            <ac:spMk id="5" creationId="{7E2F2E28-8688-CAE0-AB08-C81DB3998974}"/>
          </ac:spMkLst>
        </pc:spChg>
        <pc:spChg chg="add del mod">
          <ac:chgData name="Yuki Yoshimatsu" userId="ba50b75ca1f18b98" providerId="LiveId" clId="{0B9C44EB-507D-404B-B200-37955C3B5627}" dt="2025-01-19T07:29:36.566" v="6" actId="478"/>
          <ac:spMkLst>
            <pc:docMk/>
            <pc:sldMk cId="3121883639" sldId="256"/>
            <ac:spMk id="6" creationId="{94AC549A-0990-6566-83F3-AF8728A456C7}"/>
          </ac:spMkLst>
        </pc:spChg>
        <pc:spChg chg="add del mod">
          <ac:chgData name="Yuki Yoshimatsu" userId="ba50b75ca1f18b98" providerId="LiveId" clId="{0B9C44EB-507D-404B-B200-37955C3B5627}" dt="2025-01-19T07:29:36.566" v="6" actId="478"/>
          <ac:spMkLst>
            <pc:docMk/>
            <pc:sldMk cId="3121883639" sldId="256"/>
            <ac:spMk id="7" creationId="{A673F360-13A5-BDD1-2298-22303FA2ACDA}"/>
          </ac:spMkLst>
        </pc:spChg>
        <pc:spChg chg="add del mod">
          <ac:chgData name="Yuki Yoshimatsu" userId="ba50b75ca1f18b98" providerId="LiveId" clId="{0B9C44EB-507D-404B-B200-37955C3B5627}" dt="2025-01-19T07:29:25.893" v="5" actId="478"/>
          <ac:spMkLst>
            <pc:docMk/>
            <pc:sldMk cId="3121883639" sldId="256"/>
            <ac:spMk id="8" creationId="{320E1ECC-EAD5-A5BC-ACB5-712F84BF9B6C}"/>
          </ac:spMkLst>
        </pc:spChg>
        <pc:spChg chg="add del mod">
          <ac:chgData name="Yuki Yoshimatsu" userId="ba50b75ca1f18b98" providerId="LiveId" clId="{0B9C44EB-507D-404B-B200-37955C3B5627}" dt="2025-01-19T07:29:25.893" v="5" actId="478"/>
          <ac:spMkLst>
            <pc:docMk/>
            <pc:sldMk cId="3121883639" sldId="256"/>
            <ac:spMk id="9" creationId="{A1D06C8A-A1B2-44F2-AA59-666C0E0267C4}"/>
          </ac:spMkLst>
        </pc:spChg>
        <pc:spChg chg="add del mod">
          <ac:chgData name="Yuki Yoshimatsu" userId="ba50b75ca1f18b98" providerId="LiveId" clId="{0B9C44EB-507D-404B-B200-37955C3B5627}" dt="2025-01-19T07:29:25.893" v="5" actId="478"/>
          <ac:spMkLst>
            <pc:docMk/>
            <pc:sldMk cId="3121883639" sldId="256"/>
            <ac:spMk id="10" creationId="{CA4929FB-0E22-1D47-FCA5-F1823EA93B64}"/>
          </ac:spMkLst>
        </pc:spChg>
        <pc:spChg chg="add del mod">
          <ac:chgData name="Yuki Yoshimatsu" userId="ba50b75ca1f18b98" providerId="LiveId" clId="{0B9C44EB-507D-404B-B200-37955C3B5627}" dt="2025-01-19T07:29:25.893" v="5" actId="478"/>
          <ac:spMkLst>
            <pc:docMk/>
            <pc:sldMk cId="3121883639" sldId="256"/>
            <ac:spMk id="11" creationId="{1230D555-E930-DC9C-1154-51DAA8AC1E4A}"/>
          </ac:spMkLst>
        </pc:spChg>
        <pc:spChg chg="mod">
          <ac:chgData name="Yuki Yoshimatsu" userId="ba50b75ca1f18b98" providerId="LiveId" clId="{0B9C44EB-507D-404B-B200-37955C3B5627}" dt="2025-01-19T07:29:36.965" v="7"/>
          <ac:spMkLst>
            <pc:docMk/>
            <pc:sldMk cId="3121883639" sldId="256"/>
            <ac:spMk id="13" creationId="{D6A25BE4-9E44-E450-C975-FFD6041DA143}"/>
          </ac:spMkLst>
        </pc:spChg>
        <pc:spChg chg="mod">
          <ac:chgData name="Yuki Yoshimatsu" userId="ba50b75ca1f18b98" providerId="LiveId" clId="{0B9C44EB-507D-404B-B200-37955C3B5627}" dt="2025-01-19T07:29:36.965" v="7"/>
          <ac:spMkLst>
            <pc:docMk/>
            <pc:sldMk cId="3121883639" sldId="256"/>
            <ac:spMk id="14" creationId="{AD620059-F1C6-2501-A215-76B78195FDCB}"/>
          </ac:spMkLst>
        </pc:spChg>
        <pc:spChg chg="mod">
          <ac:chgData name="Yuki Yoshimatsu" userId="ba50b75ca1f18b98" providerId="LiveId" clId="{0B9C44EB-507D-404B-B200-37955C3B5627}" dt="2025-01-19T07:29:36.965" v="7"/>
          <ac:spMkLst>
            <pc:docMk/>
            <pc:sldMk cId="3121883639" sldId="256"/>
            <ac:spMk id="15" creationId="{C71D1B88-E085-CA43-53C4-84D13917EFFC}"/>
          </ac:spMkLst>
        </pc:spChg>
        <pc:spChg chg="mod">
          <ac:chgData name="Yuki Yoshimatsu" userId="ba50b75ca1f18b98" providerId="LiveId" clId="{0B9C44EB-507D-404B-B200-37955C3B5627}" dt="2025-01-19T07:29:36.965" v="7"/>
          <ac:spMkLst>
            <pc:docMk/>
            <pc:sldMk cId="3121883639" sldId="256"/>
            <ac:spMk id="16" creationId="{8320F7D0-DC70-DF44-BCF6-CC50CCACDA74}"/>
          </ac:spMkLst>
        </pc:spChg>
        <pc:spChg chg="mod">
          <ac:chgData name="Yuki Yoshimatsu" userId="ba50b75ca1f18b98" providerId="LiveId" clId="{0B9C44EB-507D-404B-B200-37955C3B5627}" dt="2025-01-19T07:29:36.965" v="7"/>
          <ac:spMkLst>
            <pc:docMk/>
            <pc:sldMk cId="3121883639" sldId="256"/>
            <ac:spMk id="17" creationId="{1DD7F2F7-2797-CAC5-7111-B917CB861BA2}"/>
          </ac:spMkLst>
        </pc:spChg>
        <pc:spChg chg="add mod">
          <ac:chgData name="Yuki Yoshimatsu" userId="ba50b75ca1f18b98" providerId="LiveId" clId="{0B9C44EB-507D-404B-B200-37955C3B5627}" dt="2025-01-19T11:14:16.015" v="184" actId="1076"/>
          <ac:spMkLst>
            <pc:docMk/>
            <pc:sldMk cId="3121883639" sldId="256"/>
            <ac:spMk id="19" creationId="{70FABFE4-ED78-0614-E5BF-74F69C79169F}"/>
          </ac:spMkLst>
        </pc:spChg>
        <pc:spChg chg="add mod">
          <ac:chgData name="Yuki Yoshimatsu" userId="ba50b75ca1f18b98" providerId="LiveId" clId="{0B9C44EB-507D-404B-B200-37955C3B5627}" dt="2025-01-19T11:14:16.015" v="184" actId="1076"/>
          <ac:spMkLst>
            <pc:docMk/>
            <pc:sldMk cId="3121883639" sldId="256"/>
            <ac:spMk id="20" creationId="{7F20C277-C220-7E3E-8673-3E695ECD6B3E}"/>
          </ac:spMkLst>
        </pc:spChg>
        <pc:spChg chg="add mod">
          <ac:chgData name="Yuki Yoshimatsu" userId="ba50b75ca1f18b98" providerId="LiveId" clId="{0B9C44EB-507D-404B-B200-37955C3B5627}" dt="2025-01-19T11:14:16.015" v="184" actId="1076"/>
          <ac:spMkLst>
            <pc:docMk/>
            <pc:sldMk cId="3121883639" sldId="256"/>
            <ac:spMk id="21" creationId="{D55E924F-4B19-FA80-CBAA-5655859020CA}"/>
          </ac:spMkLst>
        </pc:spChg>
        <pc:spChg chg="add mod">
          <ac:chgData name="Yuki Yoshimatsu" userId="ba50b75ca1f18b98" providerId="LiveId" clId="{0B9C44EB-507D-404B-B200-37955C3B5627}" dt="2025-01-19T11:14:16.015" v="184" actId="1076"/>
          <ac:spMkLst>
            <pc:docMk/>
            <pc:sldMk cId="3121883639" sldId="256"/>
            <ac:spMk id="22" creationId="{9CB11224-719D-EB97-DDE9-658A73800BAD}"/>
          </ac:spMkLst>
        </pc:spChg>
        <pc:spChg chg="add mod">
          <ac:chgData name="Yuki Yoshimatsu" userId="ba50b75ca1f18b98" providerId="LiveId" clId="{0B9C44EB-507D-404B-B200-37955C3B5627}" dt="2025-01-19T11:14:16.015" v="184" actId="1076"/>
          <ac:spMkLst>
            <pc:docMk/>
            <pc:sldMk cId="3121883639" sldId="256"/>
            <ac:spMk id="23" creationId="{C01AFDBA-5ABD-03E4-FDE7-B25B61FDF3EF}"/>
          </ac:spMkLst>
        </pc:spChg>
        <pc:spChg chg="add mod">
          <ac:chgData name="Yuki Yoshimatsu" userId="ba50b75ca1f18b98" providerId="LiveId" clId="{0B9C44EB-507D-404B-B200-37955C3B5627}" dt="2025-01-19T07:31:46.756" v="35"/>
          <ac:spMkLst>
            <pc:docMk/>
            <pc:sldMk cId="3121883639" sldId="256"/>
            <ac:spMk id="24" creationId="{52C31C63-6A37-0631-8368-AD51BD360B6E}"/>
          </ac:spMkLst>
        </pc:spChg>
        <pc:spChg chg="add mod">
          <ac:chgData name="Yuki Yoshimatsu" userId="ba50b75ca1f18b98" providerId="LiveId" clId="{0B9C44EB-507D-404B-B200-37955C3B5627}" dt="2025-01-19T07:31:46.756" v="35"/>
          <ac:spMkLst>
            <pc:docMk/>
            <pc:sldMk cId="3121883639" sldId="256"/>
            <ac:spMk id="25" creationId="{4FA56F2A-C4F9-DE63-2BE6-4DE5CA2AD164}"/>
          </ac:spMkLst>
        </pc:spChg>
        <pc:spChg chg="add mod">
          <ac:chgData name="Yuki Yoshimatsu" userId="ba50b75ca1f18b98" providerId="LiveId" clId="{0B9C44EB-507D-404B-B200-37955C3B5627}" dt="2025-01-19T07:31:46.756" v="35"/>
          <ac:spMkLst>
            <pc:docMk/>
            <pc:sldMk cId="3121883639" sldId="256"/>
            <ac:spMk id="26" creationId="{C5C02815-A8E9-3C14-4DCB-D74CFA1E9913}"/>
          </ac:spMkLst>
        </pc:spChg>
        <pc:spChg chg="add mod">
          <ac:chgData name="Yuki Yoshimatsu" userId="ba50b75ca1f18b98" providerId="LiveId" clId="{0B9C44EB-507D-404B-B200-37955C3B5627}" dt="2025-01-19T07:31:46.756" v="35"/>
          <ac:spMkLst>
            <pc:docMk/>
            <pc:sldMk cId="3121883639" sldId="256"/>
            <ac:spMk id="27" creationId="{803177C7-F302-F07B-86F0-254DA4A963EF}"/>
          </ac:spMkLst>
        </pc:spChg>
        <pc:spChg chg="add mod">
          <ac:chgData name="Yuki Yoshimatsu" userId="ba50b75ca1f18b98" providerId="LiveId" clId="{0B9C44EB-507D-404B-B200-37955C3B5627}" dt="2025-01-19T11:14:16.015" v="184" actId="1076"/>
          <ac:spMkLst>
            <pc:docMk/>
            <pc:sldMk cId="3121883639" sldId="256"/>
            <ac:spMk id="28" creationId="{B3426910-BB0C-C5C0-A925-06FFFC5D26AF}"/>
          </ac:spMkLst>
        </pc:spChg>
        <pc:spChg chg="add mod">
          <ac:chgData name="Yuki Yoshimatsu" userId="ba50b75ca1f18b98" providerId="LiveId" clId="{0B9C44EB-507D-404B-B200-37955C3B5627}" dt="2025-01-19T11:14:16.015" v="184" actId="1076"/>
          <ac:spMkLst>
            <pc:docMk/>
            <pc:sldMk cId="3121883639" sldId="256"/>
            <ac:spMk id="29" creationId="{36F5D0A6-4690-FCB8-A7DB-4110E4A1D369}"/>
          </ac:spMkLst>
        </pc:spChg>
        <pc:spChg chg="add mod">
          <ac:chgData name="Yuki Yoshimatsu" userId="ba50b75ca1f18b98" providerId="LiveId" clId="{0B9C44EB-507D-404B-B200-37955C3B5627}" dt="2025-01-19T11:14:16.015" v="184" actId="1076"/>
          <ac:spMkLst>
            <pc:docMk/>
            <pc:sldMk cId="3121883639" sldId="256"/>
            <ac:spMk id="30" creationId="{4AC5145A-368E-313D-E7F5-3BF27F8C21DE}"/>
          </ac:spMkLst>
        </pc:spChg>
        <pc:spChg chg="add mod">
          <ac:chgData name="Yuki Yoshimatsu" userId="ba50b75ca1f18b98" providerId="LiveId" clId="{0B9C44EB-507D-404B-B200-37955C3B5627}" dt="2025-01-19T11:14:16.015" v="184" actId="1076"/>
          <ac:spMkLst>
            <pc:docMk/>
            <pc:sldMk cId="3121883639" sldId="256"/>
            <ac:spMk id="31" creationId="{8B91E8E4-396D-243C-71F5-F0695AC4B7BB}"/>
          </ac:spMkLst>
        </pc:spChg>
        <pc:spChg chg="mod">
          <ac:chgData name="Yuki Yoshimatsu" userId="ba50b75ca1f18b98" providerId="LiveId" clId="{0B9C44EB-507D-404B-B200-37955C3B5627}" dt="2025-01-19T11:14:11.279" v="183" actId="1076"/>
          <ac:spMkLst>
            <pc:docMk/>
            <pc:sldMk cId="3121883639" sldId="256"/>
            <ac:spMk id="394" creationId="{00000000-0000-0000-0000-000000000000}"/>
          </ac:spMkLst>
        </pc:spChg>
        <pc:spChg chg="del">
          <ac:chgData name="Yuki Yoshimatsu" userId="ba50b75ca1f18b98" providerId="LiveId" clId="{0B9C44EB-507D-404B-B200-37955C3B5627}" dt="2025-01-19T07:28:52.297" v="2" actId="478"/>
          <ac:spMkLst>
            <pc:docMk/>
            <pc:sldMk cId="3121883639" sldId="256"/>
            <ac:spMk id="420" creationId="{5A51FE99-84AE-5AE4-5DAA-A9F11B21919D}"/>
          </ac:spMkLst>
        </pc:spChg>
        <pc:spChg chg="del">
          <ac:chgData name="Yuki Yoshimatsu" userId="ba50b75ca1f18b98" providerId="LiveId" clId="{0B9C44EB-507D-404B-B200-37955C3B5627}" dt="2025-01-19T07:28:52.297" v="2" actId="478"/>
          <ac:spMkLst>
            <pc:docMk/>
            <pc:sldMk cId="3121883639" sldId="256"/>
            <ac:spMk id="481" creationId="{653C6D80-118B-7C26-5383-01BD5D92599D}"/>
          </ac:spMkLst>
        </pc:spChg>
        <pc:spChg chg="del">
          <ac:chgData name="Yuki Yoshimatsu" userId="ba50b75ca1f18b98" providerId="LiveId" clId="{0B9C44EB-507D-404B-B200-37955C3B5627}" dt="2025-01-19T07:28:52.297" v="2" actId="478"/>
          <ac:spMkLst>
            <pc:docMk/>
            <pc:sldMk cId="3121883639" sldId="256"/>
            <ac:spMk id="501" creationId="{BEBC6A09-1D5A-5B09-6A23-F42C3A6545A2}"/>
          </ac:spMkLst>
        </pc:spChg>
        <pc:spChg chg="del">
          <ac:chgData name="Yuki Yoshimatsu" userId="ba50b75ca1f18b98" providerId="LiveId" clId="{0B9C44EB-507D-404B-B200-37955C3B5627}" dt="2025-01-19T07:28:52.297" v="2" actId="478"/>
          <ac:spMkLst>
            <pc:docMk/>
            <pc:sldMk cId="3121883639" sldId="256"/>
            <ac:spMk id="524" creationId="{103918F7-E1F8-A4ED-6C0B-4D493B424AE3}"/>
          </ac:spMkLst>
        </pc:spChg>
        <pc:spChg chg="del">
          <ac:chgData name="Yuki Yoshimatsu" userId="ba50b75ca1f18b98" providerId="LiveId" clId="{0B9C44EB-507D-404B-B200-37955C3B5627}" dt="2025-01-19T07:28:52.297" v="2" actId="478"/>
          <ac:spMkLst>
            <pc:docMk/>
            <pc:sldMk cId="3121883639" sldId="256"/>
            <ac:spMk id="578" creationId="{9D3C5675-FDE3-FB52-0DC3-763B33D8740E}"/>
          </ac:spMkLst>
        </pc:spChg>
        <pc:spChg chg="del">
          <ac:chgData name="Yuki Yoshimatsu" userId="ba50b75ca1f18b98" providerId="LiveId" clId="{0B9C44EB-507D-404B-B200-37955C3B5627}" dt="2025-01-19T07:28:52.297" v="2" actId="478"/>
          <ac:spMkLst>
            <pc:docMk/>
            <pc:sldMk cId="3121883639" sldId="256"/>
            <ac:spMk id="599" creationId="{15C39345-9482-9253-84DE-A46F5D970A38}"/>
          </ac:spMkLst>
        </pc:spChg>
        <pc:spChg chg="del">
          <ac:chgData name="Yuki Yoshimatsu" userId="ba50b75ca1f18b98" providerId="LiveId" clId="{0B9C44EB-507D-404B-B200-37955C3B5627}" dt="2025-01-19T07:28:52.297" v="2" actId="478"/>
          <ac:spMkLst>
            <pc:docMk/>
            <pc:sldMk cId="3121883639" sldId="256"/>
            <ac:spMk id="622" creationId="{5A51FE99-84AE-5AE4-5DAA-A9F11B21919D}"/>
          </ac:spMkLst>
        </pc:spChg>
        <pc:spChg chg="del">
          <ac:chgData name="Yuki Yoshimatsu" userId="ba50b75ca1f18b98" providerId="LiveId" clId="{0B9C44EB-507D-404B-B200-37955C3B5627}" dt="2025-01-19T07:28:52.297" v="2" actId="478"/>
          <ac:spMkLst>
            <pc:docMk/>
            <pc:sldMk cId="3121883639" sldId="256"/>
            <ac:spMk id="683" creationId="{0417DBDD-56BC-BFE0-88CD-8BCB4154F042}"/>
          </ac:spMkLst>
        </pc:spChg>
        <pc:spChg chg="del">
          <ac:chgData name="Yuki Yoshimatsu" userId="ba50b75ca1f18b98" providerId="LiveId" clId="{0B9C44EB-507D-404B-B200-37955C3B5627}" dt="2025-01-19T07:28:52.297" v="2" actId="478"/>
          <ac:spMkLst>
            <pc:docMk/>
            <pc:sldMk cId="3121883639" sldId="256"/>
            <ac:spMk id="737" creationId="{71DBEC28-AB60-89AA-7001-575E546CECD1}"/>
          </ac:spMkLst>
        </pc:spChg>
        <pc:spChg chg="del">
          <ac:chgData name="Yuki Yoshimatsu" userId="ba50b75ca1f18b98" providerId="LiveId" clId="{0B9C44EB-507D-404B-B200-37955C3B5627}" dt="2025-01-19T07:28:52.297" v="2" actId="478"/>
          <ac:spMkLst>
            <pc:docMk/>
            <pc:sldMk cId="3121883639" sldId="256"/>
            <ac:spMk id="760" creationId="{38E98583-BEC2-604C-F3D8-C519487E2D1A}"/>
          </ac:spMkLst>
        </pc:spChg>
        <pc:spChg chg="mod">
          <ac:chgData name="Yuki Yoshimatsu" userId="ba50b75ca1f18b98" providerId="LiveId" clId="{0B9C44EB-507D-404B-B200-37955C3B5627}" dt="2025-01-19T11:14:20.273" v="185" actId="1076"/>
          <ac:spMkLst>
            <pc:docMk/>
            <pc:sldMk cId="3121883639" sldId="256"/>
            <ac:spMk id="776" creationId="{06656C2F-0B09-C87C-C5CD-4BAE3D3EBFED}"/>
          </ac:spMkLst>
        </pc:spChg>
        <pc:grpChg chg="add mod">
          <ac:chgData name="Yuki Yoshimatsu" userId="ba50b75ca1f18b98" providerId="LiveId" clId="{0B9C44EB-507D-404B-B200-37955C3B5627}" dt="2025-01-19T07:30:12.668" v="18" actId="14100"/>
          <ac:grpSpMkLst>
            <pc:docMk/>
            <pc:sldMk cId="3121883639" sldId="256"/>
            <ac:grpSpMk id="12" creationId="{0E96900A-1DDD-BA10-DB5F-577B2DD9169D}"/>
          </ac:grpSpMkLst>
        </pc:grpChg>
        <pc:picChg chg="add del mod">
          <ac:chgData name="Yuki Yoshimatsu" userId="ba50b75ca1f18b98" providerId="LiveId" clId="{0B9C44EB-507D-404B-B200-37955C3B5627}" dt="2025-01-19T07:29:25.893" v="5" actId="478"/>
          <ac:picMkLst>
            <pc:docMk/>
            <pc:sldMk cId="3121883639" sldId="256"/>
            <ac:picMk id="2" creationId="{91DCF64E-2644-3BDB-6122-196BF8CF45F6}"/>
          </ac:picMkLst>
        </pc:picChg>
        <pc:picChg chg="add mod">
          <ac:chgData name="Yuki Yoshimatsu" userId="ba50b75ca1f18b98" providerId="LiveId" clId="{0B9C44EB-507D-404B-B200-37955C3B5627}" dt="2025-01-19T07:31:55.171" v="37" actId="1076"/>
          <ac:picMkLst>
            <pc:docMk/>
            <pc:sldMk cId="3121883639" sldId="256"/>
            <ac:picMk id="18" creationId="{27D36E67-90D2-A68C-4B5C-14D743E110E0}"/>
          </ac:picMkLst>
        </pc:picChg>
      </pc:sldChg>
      <pc:sldChg chg="addSp delSp modSp add mod">
        <pc:chgData name="Yuki Yoshimatsu" userId="ba50b75ca1f18b98" providerId="LiveId" clId="{0B9C44EB-507D-404B-B200-37955C3B5627}" dt="2025-01-19T11:53:11.424" v="405" actId="1076"/>
        <pc:sldMkLst>
          <pc:docMk/>
          <pc:sldMk cId="1960080831" sldId="257"/>
        </pc:sldMkLst>
        <pc:spChg chg="add mod">
          <ac:chgData name="Yuki Yoshimatsu" userId="ba50b75ca1f18b98" providerId="LiveId" clId="{0B9C44EB-507D-404B-B200-37955C3B5627}" dt="2025-01-19T11:50:58.650" v="385" actId="554"/>
          <ac:spMkLst>
            <pc:docMk/>
            <pc:sldMk cId="1960080831" sldId="257"/>
            <ac:spMk id="6" creationId="{E6112325-795D-0955-4E77-AECEAAFD72E4}"/>
          </ac:spMkLst>
        </pc:spChg>
        <pc:spChg chg="mod">
          <ac:chgData name="Yuki Yoshimatsu" userId="ba50b75ca1f18b98" providerId="LiveId" clId="{0B9C44EB-507D-404B-B200-37955C3B5627}" dt="2025-01-19T07:38:38.543" v="106"/>
          <ac:spMkLst>
            <pc:docMk/>
            <pc:sldMk cId="1960080831" sldId="257"/>
            <ac:spMk id="8" creationId="{8E3EF9F1-6C1C-D8F9-EEB6-BDF8CC8941B9}"/>
          </ac:spMkLst>
        </pc:spChg>
        <pc:spChg chg="mod">
          <ac:chgData name="Yuki Yoshimatsu" userId="ba50b75ca1f18b98" providerId="LiveId" clId="{0B9C44EB-507D-404B-B200-37955C3B5627}" dt="2025-01-19T07:38:38.543" v="106"/>
          <ac:spMkLst>
            <pc:docMk/>
            <pc:sldMk cId="1960080831" sldId="257"/>
            <ac:spMk id="9" creationId="{48F2B86F-13A9-1FE6-914B-7070D293ED36}"/>
          </ac:spMkLst>
        </pc:spChg>
        <pc:spChg chg="mod">
          <ac:chgData name="Yuki Yoshimatsu" userId="ba50b75ca1f18b98" providerId="LiveId" clId="{0B9C44EB-507D-404B-B200-37955C3B5627}" dt="2025-01-19T07:38:38.543" v="106"/>
          <ac:spMkLst>
            <pc:docMk/>
            <pc:sldMk cId="1960080831" sldId="257"/>
            <ac:spMk id="10" creationId="{0B3C137E-FFE5-F093-C9EE-7CC36EA32A29}"/>
          </ac:spMkLst>
        </pc:spChg>
        <pc:spChg chg="mod">
          <ac:chgData name="Yuki Yoshimatsu" userId="ba50b75ca1f18b98" providerId="LiveId" clId="{0B9C44EB-507D-404B-B200-37955C3B5627}" dt="2025-01-19T07:38:38.543" v="106"/>
          <ac:spMkLst>
            <pc:docMk/>
            <pc:sldMk cId="1960080831" sldId="257"/>
            <ac:spMk id="11" creationId="{2077F4E0-A2B0-E550-B81C-FFE4F8B14B9A}"/>
          </ac:spMkLst>
        </pc:spChg>
        <pc:spChg chg="mod">
          <ac:chgData name="Yuki Yoshimatsu" userId="ba50b75ca1f18b98" providerId="LiveId" clId="{0B9C44EB-507D-404B-B200-37955C3B5627}" dt="2025-01-19T07:38:38.543" v="106"/>
          <ac:spMkLst>
            <pc:docMk/>
            <pc:sldMk cId="1960080831" sldId="257"/>
            <ac:spMk id="12" creationId="{3C5B296B-1E5B-B603-63D7-39B560E27B7D}"/>
          </ac:spMkLst>
        </pc:spChg>
        <pc:spChg chg="add mod">
          <ac:chgData name="Yuki Yoshimatsu" userId="ba50b75ca1f18b98" providerId="LiveId" clId="{0B9C44EB-507D-404B-B200-37955C3B5627}" dt="2025-01-19T11:51:10.652" v="387" actId="554"/>
          <ac:spMkLst>
            <pc:docMk/>
            <pc:sldMk cId="1960080831" sldId="257"/>
            <ac:spMk id="17" creationId="{EA9CEB03-F197-97D4-F0E1-AEBC4625C42B}"/>
          </ac:spMkLst>
        </pc:spChg>
        <pc:spChg chg="add mod">
          <ac:chgData name="Yuki Yoshimatsu" userId="ba50b75ca1f18b98" providerId="LiveId" clId="{0B9C44EB-507D-404B-B200-37955C3B5627}" dt="2025-01-19T11:51:25.143" v="389" actId="554"/>
          <ac:spMkLst>
            <pc:docMk/>
            <pc:sldMk cId="1960080831" sldId="257"/>
            <ac:spMk id="20" creationId="{3CC2BA54-0BC0-F86F-36F9-268C41A8AB85}"/>
          </ac:spMkLst>
        </pc:spChg>
        <pc:spChg chg="add mod">
          <ac:chgData name="Yuki Yoshimatsu" userId="ba50b75ca1f18b98" providerId="LiveId" clId="{0B9C44EB-507D-404B-B200-37955C3B5627}" dt="2025-01-19T11:51:40.785" v="391" actId="554"/>
          <ac:spMkLst>
            <pc:docMk/>
            <pc:sldMk cId="1960080831" sldId="257"/>
            <ac:spMk id="23" creationId="{1D91230F-AADD-D9F7-FCA6-3F51D6DE6A06}"/>
          </ac:spMkLst>
        </pc:spChg>
        <pc:spChg chg="add mod">
          <ac:chgData name="Yuki Yoshimatsu" userId="ba50b75ca1f18b98" providerId="LiveId" clId="{0B9C44EB-507D-404B-B200-37955C3B5627}" dt="2025-01-19T11:51:57.274" v="393" actId="554"/>
          <ac:spMkLst>
            <pc:docMk/>
            <pc:sldMk cId="1960080831" sldId="257"/>
            <ac:spMk id="26" creationId="{86B014DC-F7E3-628C-E890-4E0A9C5F65C6}"/>
          </ac:spMkLst>
        </pc:spChg>
        <pc:spChg chg="add del mod">
          <ac:chgData name="Yuki Yoshimatsu" userId="ba50b75ca1f18b98" providerId="LiveId" clId="{0B9C44EB-507D-404B-B200-37955C3B5627}" dt="2025-01-19T11:13:43.212" v="170" actId="478"/>
          <ac:spMkLst>
            <pc:docMk/>
            <pc:sldMk cId="1960080831" sldId="257"/>
            <ac:spMk id="27" creationId="{4926CE10-438C-8A2E-34EF-672158294DC5}"/>
          </ac:spMkLst>
        </pc:spChg>
        <pc:spChg chg="add del mod">
          <ac:chgData name="Yuki Yoshimatsu" userId="ba50b75ca1f18b98" providerId="LiveId" clId="{0B9C44EB-507D-404B-B200-37955C3B5627}" dt="2025-01-19T11:13:43.212" v="170" actId="478"/>
          <ac:spMkLst>
            <pc:docMk/>
            <pc:sldMk cId="1960080831" sldId="257"/>
            <ac:spMk id="28" creationId="{47242DE3-DF33-C592-BEEA-9121137EA5CE}"/>
          </ac:spMkLst>
        </pc:spChg>
        <pc:spChg chg="add mod">
          <ac:chgData name="Yuki Yoshimatsu" userId="ba50b75ca1f18b98" providerId="LiveId" clId="{0B9C44EB-507D-404B-B200-37955C3B5627}" dt="2025-01-19T11:52:46.603" v="401" actId="554"/>
          <ac:spMkLst>
            <pc:docMk/>
            <pc:sldMk cId="1960080831" sldId="257"/>
            <ac:spMk id="29" creationId="{92DB8D72-3812-5E12-B68D-FC0453C8C79A}"/>
          </ac:spMkLst>
        </pc:spChg>
        <pc:spChg chg="add mod">
          <ac:chgData name="Yuki Yoshimatsu" userId="ba50b75ca1f18b98" providerId="LiveId" clId="{0B9C44EB-507D-404B-B200-37955C3B5627}" dt="2025-01-19T11:52:34.091" v="399" actId="554"/>
          <ac:spMkLst>
            <pc:docMk/>
            <pc:sldMk cId="1960080831" sldId="257"/>
            <ac:spMk id="30" creationId="{C4F6CE2A-5600-73D5-267E-49CC4D4726C5}"/>
          </ac:spMkLst>
        </pc:spChg>
        <pc:spChg chg="add mod">
          <ac:chgData name="Yuki Yoshimatsu" userId="ba50b75ca1f18b98" providerId="LiveId" clId="{0B9C44EB-507D-404B-B200-37955C3B5627}" dt="2025-01-19T11:53:11.424" v="405" actId="1076"/>
          <ac:spMkLst>
            <pc:docMk/>
            <pc:sldMk cId="1960080831" sldId="257"/>
            <ac:spMk id="31" creationId="{BC6D25AA-6372-0CE6-6FF7-32C8F428FA59}"/>
          </ac:spMkLst>
        </pc:spChg>
        <pc:spChg chg="add mod">
          <ac:chgData name="Yuki Yoshimatsu" userId="ba50b75ca1f18b98" providerId="LiveId" clId="{0B9C44EB-507D-404B-B200-37955C3B5627}" dt="2025-01-19T11:53:11.424" v="405" actId="1076"/>
          <ac:spMkLst>
            <pc:docMk/>
            <pc:sldMk cId="1960080831" sldId="257"/>
            <ac:spMk id="32" creationId="{BAE34144-2241-E3CA-67D7-B082F8FEF5BE}"/>
          </ac:spMkLst>
        </pc:spChg>
        <pc:spChg chg="add del mod">
          <ac:chgData name="Yuki Yoshimatsu" userId="ba50b75ca1f18b98" providerId="LiveId" clId="{0B9C44EB-507D-404B-B200-37955C3B5627}" dt="2025-01-19T11:13:43.212" v="170" actId="478"/>
          <ac:spMkLst>
            <pc:docMk/>
            <pc:sldMk cId="1960080831" sldId="257"/>
            <ac:spMk id="33" creationId="{66599D1E-ACA3-73D7-9BF1-983B62B5DEED}"/>
          </ac:spMkLst>
        </pc:spChg>
        <pc:spChg chg="add del mod">
          <ac:chgData name="Yuki Yoshimatsu" userId="ba50b75ca1f18b98" providerId="LiveId" clId="{0B9C44EB-507D-404B-B200-37955C3B5627}" dt="2025-01-19T11:13:43.212" v="170" actId="478"/>
          <ac:spMkLst>
            <pc:docMk/>
            <pc:sldMk cId="1960080831" sldId="257"/>
            <ac:spMk id="34" creationId="{353D82CD-B53B-7186-5A33-B28C0A217758}"/>
          </ac:spMkLst>
        </pc:spChg>
        <pc:spChg chg="add del mod">
          <ac:chgData name="Yuki Yoshimatsu" userId="ba50b75ca1f18b98" providerId="LiveId" clId="{0B9C44EB-507D-404B-B200-37955C3B5627}" dt="2025-01-19T11:13:43.212" v="170" actId="478"/>
          <ac:spMkLst>
            <pc:docMk/>
            <pc:sldMk cId="1960080831" sldId="257"/>
            <ac:spMk id="35" creationId="{143DD09F-67D8-AFC6-C826-AC7061BB887F}"/>
          </ac:spMkLst>
        </pc:spChg>
        <pc:spChg chg="add del mod">
          <ac:chgData name="Yuki Yoshimatsu" userId="ba50b75ca1f18b98" providerId="LiveId" clId="{0B9C44EB-507D-404B-B200-37955C3B5627}" dt="2025-01-19T11:13:43.212" v="170" actId="478"/>
          <ac:spMkLst>
            <pc:docMk/>
            <pc:sldMk cId="1960080831" sldId="257"/>
            <ac:spMk id="36" creationId="{B41DBD9F-8FA2-B52E-FB71-D188117EED7A}"/>
          </ac:spMkLst>
        </pc:spChg>
        <pc:spChg chg="add del mod">
          <ac:chgData name="Yuki Yoshimatsu" userId="ba50b75ca1f18b98" providerId="LiveId" clId="{0B9C44EB-507D-404B-B200-37955C3B5627}" dt="2025-01-19T11:13:43.212" v="170" actId="478"/>
          <ac:spMkLst>
            <pc:docMk/>
            <pc:sldMk cId="1960080831" sldId="257"/>
            <ac:spMk id="37" creationId="{67A040A2-2E2A-C063-2289-42860A8D5519}"/>
          </ac:spMkLst>
        </pc:spChg>
        <pc:spChg chg="add del mod">
          <ac:chgData name="Yuki Yoshimatsu" userId="ba50b75ca1f18b98" providerId="LiveId" clId="{0B9C44EB-507D-404B-B200-37955C3B5627}" dt="2025-01-19T11:13:43.212" v="170" actId="478"/>
          <ac:spMkLst>
            <pc:docMk/>
            <pc:sldMk cId="1960080831" sldId="257"/>
            <ac:spMk id="38" creationId="{14D47F06-7137-0AC0-9966-4FA7D3A7761D}"/>
          </ac:spMkLst>
        </pc:spChg>
        <pc:spChg chg="add mod">
          <ac:chgData name="Yuki Yoshimatsu" userId="ba50b75ca1f18b98" providerId="LiveId" clId="{0B9C44EB-507D-404B-B200-37955C3B5627}" dt="2025-01-19T11:18:27.484" v="192"/>
          <ac:spMkLst>
            <pc:docMk/>
            <pc:sldMk cId="1960080831" sldId="257"/>
            <ac:spMk id="43" creationId="{8BB7D3EC-1EBA-5792-00B3-B45AC4304709}"/>
          </ac:spMkLst>
        </pc:spChg>
        <pc:spChg chg="add mod">
          <ac:chgData name="Yuki Yoshimatsu" userId="ba50b75ca1f18b98" providerId="LiveId" clId="{0B9C44EB-507D-404B-B200-37955C3B5627}" dt="2025-01-19T11:19:36.252" v="211"/>
          <ac:spMkLst>
            <pc:docMk/>
            <pc:sldMk cId="1960080831" sldId="257"/>
            <ac:spMk id="47" creationId="{D532F9A5-AFEB-76E4-9C47-F5876DA1E682}"/>
          </ac:spMkLst>
        </pc:spChg>
        <pc:spChg chg="add mod">
          <ac:chgData name="Yuki Yoshimatsu" userId="ba50b75ca1f18b98" providerId="LiveId" clId="{0B9C44EB-507D-404B-B200-37955C3B5627}" dt="2025-01-19T11:20:09.967" v="214"/>
          <ac:spMkLst>
            <pc:docMk/>
            <pc:sldMk cId="1960080831" sldId="257"/>
            <ac:spMk id="51" creationId="{C45EA449-6829-7CE3-B4FB-A76E2E9336A4}"/>
          </ac:spMkLst>
        </pc:spChg>
        <pc:spChg chg="add mod">
          <ac:chgData name="Yuki Yoshimatsu" userId="ba50b75ca1f18b98" providerId="LiveId" clId="{0B9C44EB-507D-404B-B200-37955C3B5627}" dt="2025-01-19T11:20:27.004" v="217"/>
          <ac:spMkLst>
            <pc:docMk/>
            <pc:sldMk cId="1960080831" sldId="257"/>
            <ac:spMk id="55" creationId="{814D2C05-35E3-944C-6D72-B0D9D9FA6AB2}"/>
          </ac:spMkLst>
        </pc:spChg>
        <pc:spChg chg="add mod">
          <ac:chgData name="Yuki Yoshimatsu" userId="ba50b75ca1f18b98" providerId="LiveId" clId="{0B9C44EB-507D-404B-B200-37955C3B5627}" dt="2025-01-19T11:21:00.492" v="224"/>
          <ac:spMkLst>
            <pc:docMk/>
            <pc:sldMk cId="1960080831" sldId="257"/>
            <ac:spMk id="59" creationId="{98B307C4-C9CF-AE1F-4258-86B2732020F4}"/>
          </ac:spMkLst>
        </pc:spChg>
        <pc:spChg chg="add mod">
          <ac:chgData name="Yuki Yoshimatsu" userId="ba50b75ca1f18b98" providerId="LiveId" clId="{0B9C44EB-507D-404B-B200-37955C3B5627}" dt="2025-01-19T11:21:23.714" v="228"/>
          <ac:spMkLst>
            <pc:docMk/>
            <pc:sldMk cId="1960080831" sldId="257"/>
            <ac:spMk id="63" creationId="{C7AC4AD2-1F0E-2171-2163-69E14ECF13B7}"/>
          </ac:spMkLst>
        </pc:spChg>
        <pc:spChg chg="add mod">
          <ac:chgData name="Yuki Yoshimatsu" userId="ba50b75ca1f18b98" providerId="LiveId" clId="{0B9C44EB-507D-404B-B200-37955C3B5627}" dt="2025-01-19T11:50:24.975" v="383" actId="554"/>
          <ac:spMkLst>
            <pc:docMk/>
            <pc:sldMk cId="1960080831" sldId="257"/>
            <ac:spMk id="387" creationId="{D7C2B171-4146-4FE8-5B2C-EFEC7DCD9830}"/>
          </ac:spMkLst>
        </pc:spChg>
        <pc:spChg chg="add mod">
          <ac:chgData name="Yuki Yoshimatsu" userId="ba50b75ca1f18b98" providerId="LiveId" clId="{0B9C44EB-507D-404B-B200-37955C3B5627}" dt="2025-01-19T11:50:58.650" v="385" actId="554"/>
          <ac:spMkLst>
            <pc:docMk/>
            <pc:sldMk cId="1960080831" sldId="257"/>
            <ac:spMk id="388" creationId="{3CCF7878-ACFE-5794-CBF6-E1A78D66A1AD}"/>
          </ac:spMkLst>
        </pc:spChg>
        <pc:spChg chg="add mod">
          <ac:chgData name="Yuki Yoshimatsu" userId="ba50b75ca1f18b98" providerId="LiveId" clId="{0B9C44EB-507D-404B-B200-37955C3B5627}" dt="2025-01-19T11:53:11.424" v="405" actId="1076"/>
          <ac:spMkLst>
            <pc:docMk/>
            <pc:sldMk cId="1960080831" sldId="257"/>
            <ac:spMk id="389" creationId="{D8E0CAB9-C442-6C64-18A4-35A40BAAA848}"/>
          </ac:spMkLst>
        </pc:spChg>
        <pc:spChg chg="add mod">
          <ac:chgData name="Yuki Yoshimatsu" userId="ba50b75ca1f18b98" providerId="LiveId" clId="{0B9C44EB-507D-404B-B200-37955C3B5627}" dt="2025-01-19T11:51:25.143" v="389" actId="554"/>
          <ac:spMkLst>
            <pc:docMk/>
            <pc:sldMk cId="1960080831" sldId="257"/>
            <ac:spMk id="390" creationId="{333B0586-696B-D462-4C73-18F6E9FA4494}"/>
          </ac:spMkLst>
        </pc:spChg>
        <pc:spChg chg="add mod">
          <ac:chgData name="Yuki Yoshimatsu" userId="ba50b75ca1f18b98" providerId="LiveId" clId="{0B9C44EB-507D-404B-B200-37955C3B5627}" dt="2025-01-19T11:53:11.424" v="405" actId="1076"/>
          <ac:spMkLst>
            <pc:docMk/>
            <pc:sldMk cId="1960080831" sldId="257"/>
            <ac:spMk id="391" creationId="{E3A98203-1D43-9390-3CE6-D5F479ABD0CF}"/>
          </ac:spMkLst>
        </pc:spChg>
        <pc:spChg chg="add mod">
          <ac:chgData name="Yuki Yoshimatsu" userId="ba50b75ca1f18b98" providerId="LiveId" clId="{0B9C44EB-507D-404B-B200-37955C3B5627}" dt="2025-01-19T11:51:57.274" v="393" actId="554"/>
          <ac:spMkLst>
            <pc:docMk/>
            <pc:sldMk cId="1960080831" sldId="257"/>
            <ac:spMk id="392" creationId="{0B1C5BC2-2802-DC77-0038-4FD2B75678EC}"/>
          </ac:spMkLst>
        </pc:spChg>
        <pc:spChg chg="add mod">
          <ac:chgData name="Yuki Yoshimatsu" userId="ba50b75ca1f18b98" providerId="LiveId" clId="{0B9C44EB-507D-404B-B200-37955C3B5627}" dt="2025-01-19T11:52:46.603" v="401" actId="554"/>
          <ac:spMkLst>
            <pc:docMk/>
            <pc:sldMk cId="1960080831" sldId="257"/>
            <ac:spMk id="393" creationId="{B0C657B3-C9AE-A271-13D6-360A9CE14262}"/>
          </ac:spMkLst>
        </pc:spChg>
        <pc:spChg chg="mod">
          <ac:chgData name="Yuki Yoshimatsu" userId="ba50b75ca1f18b98" providerId="LiveId" clId="{0B9C44EB-507D-404B-B200-37955C3B5627}" dt="2025-01-19T11:13:24.728" v="164" actId="1076"/>
          <ac:spMkLst>
            <pc:docMk/>
            <pc:sldMk cId="1960080831" sldId="257"/>
            <ac:spMk id="394" creationId="{228BA962-FB43-FBF7-68D3-6B2E504E2E78}"/>
          </ac:spMkLst>
        </pc:spChg>
        <pc:spChg chg="del">
          <ac:chgData name="Yuki Yoshimatsu" userId="ba50b75ca1f18b98" providerId="LiveId" clId="{0B9C44EB-507D-404B-B200-37955C3B5627}" dt="2025-01-19T07:35:11.557" v="87" actId="478"/>
          <ac:spMkLst>
            <pc:docMk/>
            <pc:sldMk cId="1960080831" sldId="257"/>
            <ac:spMk id="396" creationId="{C01A8137-3E80-BCFB-458C-DE6C30627383}"/>
          </ac:spMkLst>
        </pc:spChg>
        <pc:spChg chg="mod">
          <ac:chgData name="Yuki Yoshimatsu" userId="ba50b75ca1f18b98" providerId="LiveId" clId="{0B9C44EB-507D-404B-B200-37955C3B5627}" dt="2025-01-19T11:53:11.424" v="405" actId="1076"/>
          <ac:spMkLst>
            <pc:docMk/>
            <pc:sldMk cId="1960080831" sldId="257"/>
            <ac:spMk id="400" creationId="{81203ADF-652B-16E8-48A4-9FE0F78685C1}"/>
          </ac:spMkLst>
        </pc:spChg>
        <pc:spChg chg="del">
          <ac:chgData name="Yuki Yoshimatsu" userId="ba50b75ca1f18b98" providerId="LiveId" clId="{0B9C44EB-507D-404B-B200-37955C3B5627}" dt="2025-01-19T07:35:11.557" v="87" actId="478"/>
          <ac:spMkLst>
            <pc:docMk/>
            <pc:sldMk cId="1960080831" sldId="257"/>
            <ac:spMk id="416" creationId="{8D61BE64-48A0-2BB2-3013-BD29DE60E678}"/>
          </ac:spMkLst>
        </pc:spChg>
        <pc:spChg chg="del">
          <ac:chgData name="Yuki Yoshimatsu" userId="ba50b75ca1f18b98" providerId="LiveId" clId="{0B9C44EB-507D-404B-B200-37955C3B5627}" dt="2025-01-19T07:35:11.557" v="87" actId="478"/>
          <ac:spMkLst>
            <pc:docMk/>
            <pc:sldMk cId="1960080831" sldId="257"/>
            <ac:spMk id="418" creationId="{4F51054E-56EB-50C3-64C6-E5F9AC37D7B3}"/>
          </ac:spMkLst>
        </pc:spChg>
        <pc:spChg chg="del">
          <ac:chgData name="Yuki Yoshimatsu" userId="ba50b75ca1f18b98" providerId="LiveId" clId="{0B9C44EB-507D-404B-B200-37955C3B5627}" dt="2025-01-19T07:35:11.557" v="87" actId="478"/>
          <ac:spMkLst>
            <pc:docMk/>
            <pc:sldMk cId="1960080831" sldId="257"/>
            <ac:spMk id="419" creationId="{C04D043B-BFF6-97E2-91B0-8F0C71A673A3}"/>
          </ac:spMkLst>
        </pc:spChg>
        <pc:spChg chg="del">
          <ac:chgData name="Yuki Yoshimatsu" userId="ba50b75ca1f18b98" providerId="LiveId" clId="{0B9C44EB-507D-404B-B200-37955C3B5627}" dt="2025-01-19T07:35:59.501" v="91" actId="478"/>
          <ac:spMkLst>
            <pc:docMk/>
            <pc:sldMk cId="1960080831" sldId="257"/>
            <ac:spMk id="420" creationId="{4B24842B-9601-269B-15FC-70FEFA92F30A}"/>
          </ac:spMkLst>
        </pc:spChg>
        <pc:spChg chg="del">
          <ac:chgData name="Yuki Yoshimatsu" userId="ba50b75ca1f18b98" providerId="LiveId" clId="{0B9C44EB-507D-404B-B200-37955C3B5627}" dt="2025-01-19T07:35:11.557" v="87" actId="478"/>
          <ac:spMkLst>
            <pc:docMk/>
            <pc:sldMk cId="1960080831" sldId="257"/>
            <ac:spMk id="440" creationId="{15E5D326-DE65-0FEE-0643-04CF8F5B3E61}"/>
          </ac:spMkLst>
        </pc:spChg>
        <pc:spChg chg="del">
          <ac:chgData name="Yuki Yoshimatsu" userId="ba50b75ca1f18b98" providerId="LiveId" clId="{0B9C44EB-507D-404B-B200-37955C3B5627}" dt="2025-01-19T07:35:11.557" v="87" actId="478"/>
          <ac:spMkLst>
            <pc:docMk/>
            <pc:sldMk cId="1960080831" sldId="257"/>
            <ac:spMk id="441" creationId="{EA84A7FA-57A5-DC83-1C99-252E734C3A65}"/>
          </ac:spMkLst>
        </pc:spChg>
        <pc:spChg chg="del">
          <ac:chgData name="Yuki Yoshimatsu" userId="ba50b75ca1f18b98" providerId="LiveId" clId="{0B9C44EB-507D-404B-B200-37955C3B5627}" dt="2025-01-19T07:35:11.557" v="87" actId="478"/>
          <ac:spMkLst>
            <pc:docMk/>
            <pc:sldMk cId="1960080831" sldId="257"/>
            <ac:spMk id="442" creationId="{A1D08E3C-AC97-0C8F-9BF2-F4B1CC72A9E8}"/>
          </ac:spMkLst>
        </pc:spChg>
        <pc:spChg chg="del">
          <ac:chgData name="Yuki Yoshimatsu" userId="ba50b75ca1f18b98" providerId="LiveId" clId="{0B9C44EB-507D-404B-B200-37955C3B5627}" dt="2025-01-19T07:35:59.501" v="91" actId="478"/>
          <ac:spMkLst>
            <pc:docMk/>
            <pc:sldMk cId="1960080831" sldId="257"/>
            <ac:spMk id="444" creationId="{3DD26452-506B-668B-887A-C78E2CC356DF}"/>
          </ac:spMkLst>
        </pc:spChg>
        <pc:spChg chg="del">
          <ac:chgData name="Yuki Yoshimatsu" userId="ba50b75ca1f18b98" providerId="LiveId" clId="{0B9C44EB-507D-404B-B200-37955C3B5627}" dt="2025-01-19T07:35:11.557" v="87" actId="478"/>
          <ac:spMkLst>
            <pc:docMk/>
            <pc:sldMk cId="1960080831" sldId="257"/>
            <ac:spMk id="457" creationId="{AFEFF341-4ECC-1B65-DD7E-E75F77E2A498}"/>
          </ac:spMkLst>
        </pc:spChg>
        <pc:spChg chg="del">
          <ac:chgData name="Yuki Yoshimatsu" userId="ba50b75ca1f18b98" providerId="LiveId" clId="{0B9C44EB-507D-404B-B200-37955C3B5627}" dt="2025-01-19T07:35:11.557" v="87" actId="478"/>
          <ac:spMkLst>
            <pc:docMk/>
            <pc:sldMk cId="1960080831" sldId="257"/>
            <ac:spMk id="458" creationId="{E840C6EB-1218-A2AE-D92F-EF2A9591FEDD}"/>
          </ac:spMkLst>
        </pc:spChg>
        <pc:spChg chg="del">
          <ac:chgData name="Yuki Yoshimatsu" userId="ba50b75ca1f18b98" providerId="LiveId" clId="{0B9C44EB-507D-404B-B200-37955C3B5627}" dt="2025-01-19T07:35:59.501" v="91" actId="478"/>
          <ac:spMkLst>
            <pc:docMk/>
            <pc:sldMk cId="1960080831" sldId="257"/>
            <ac:spMk id="462" creationId="{5E237C77-9651-852E-F87E-3A40DAE3A562}"/>
          </ac:spMkLst>
        </pc:spChg>
        <pc:spChg chg="del">
          <ac:chgData name="Yuki Yoshimatsu" userId="ba50b75ca1f18b98" providerId="LiveId" clId="{0B9C44EB-507D-404B-B200-37955C3B5627}" dt="2025-01-19T07:35:11.557" v="87" actId="478"/>
          <ac:spMkLst>
            <pc:docMk/>
            <pc:sldMk cId="1960080831" sldId="257"/>
            <ac:spMk id="479" creationId="{53C67218-CFE7-3EE7-E2B4-824A48F0EFD4}"/>
          </ac:spMkLst>
        </pc:spChg>
        <pc:spChg chg="del">
          <ac:chgData name="Yuki Yoshimatsu" userId="ba50b75ca1f18b98" providerId="LiveId" clId="{0B9C44EB-507D-404B-B200-37955C3B5627}" dt="2025-01-19T07:35:59.501" v="91" actId="478"/>
          <ac:spMkLst>
            <pc:docMk/>
            <pc:sldMk cId="1960080831" sldId="257"/>
            <ac:spMk id="484" creationId="{32B74F0A-85B3-11E8-D08D-9E71DA9BE443}"/>
          </ac:spMkLst>
        </pc:spChg>
        <pc:spChg chg="del">
          <ac:chgData name="Yuki Yoshimatsu" userId="ba50b75ca1f18b98" providerId="LiveId" clId="{0B9C44EB-507D-404B-B200-37955C3B5627}" dt="2025-01-19T07:35:55.330" v="90" actId="478"/>
          <ac:spMkLst>
            <pc:docMk/>
            <pc:sldMk cId="1960080831" sldId="257"/>
            <ac:spMk id="497" creationId="{52F09823-BA85-701F-86E9-4E960F593729}"/>
          </ac:spMkLst>
        </pc:spChg>
        <pc:spChg chg="del">
          <ac:chgData name="Yuki Yoshimatsu" userId="ba50b75ca1f18b98" providerId="LiveId" clId="{0B9C44EB-507D-404B-B200-37955C3B5627}" dt="2025-01-19T07:35:55.330" v="90" actId="478"/>
          <ac:spMkLst>
            <pc:docMk/>
            <pc:sldMk cId="1960080831" sldId="257"/>
            <ac:spMk id="500" creationId="{8C03F573-37AF-A85F-C965-8DA0050CDBA1}"/>
          </ac:spMkLst>
        </pc:spChg>
        <pc:spChg chg="del">
          <ac:chgData name="Yuki Yoshimatsu" userId="ba50b75ca1f18b98" providerId="LiveId" clId="{0B9C44EB-507D-404B-B200-37955C3B5627}" dt="2025-01-19T07:35:55.330" v="90" actId="478"/>
          <ac:spMkLst>
            <pc:docMk/>
            <pc:sldMk cId="1960080831" sldId="257"/>
            <ac:spMk id="502" creationId="{68E9F1DA-17FB-012F-E90C-9F078A974E6B}"/>
          </ac:spMkLst>
        </pc:spChg>
        <pc:spChg chg="del">
          <ac:chgData name="Yuki Yoshimatsu" userId="ba50b75ca1f18b98" providerId="LiveId" clId="{0B9C44EB-507D-404B-B200-37955C3B5627}" dt="2025-01-19T07:35:55.330" v="90" actId="478"/>
          <ac:spMkLst>
            <pc:docMk/>
            <pc:sldMk cId="1960080831" sldId="257"/>
            <ac:spMk id="523" creationId="{34F302B9-876D-265E-5EAC-743D744B9067}"/>
          </ac:spMkLst>
        </pc:spChg>
        <pc:spChg chg="del">
          <ac:chgData name="Yuki Yoshimatsu" userId="ba50b75ca1f18b98" providerId="LiveId" clId="{0B9C44EB-507D-404B-B200-37955C3B5627}" dt="2025-01-19T07:33:54.547" v="86" actId="478"/>
          <ac:spMkLst>
            <pc:docMk/>
            <pc:sldMk cId="1960080831" sldId="257"/>
            <ac:spMk id="538" creationId="{8192F57A-D6F8-63F7-B786-06BEBBB26751}"/>
          </ac:spMkLst>
        </pc:spChg>
        <pc:spChg chg="del">
          <ac:chgData name="Yuki Yoshimatsu" userId="ba50b75ca1f18b98" providerId="LiveId" clId="{0B9C44EB-507D-404B-B200-37955C3B5627}" dt="2025-01-19T07:35:55.330" v="90" actId="478"/>
          <ac:spMkLst>
            <pc:docMk/>
            <pc:sldMk cId="1960080831" sldId="257"/>
            <ac:spMk id="539" creationId="{39AAF0C8-3871-1077-BC45-6E708E376226}"/>
          </ac:spMkLst>
        </pc:spChg>
        <pc:spChg chg="del">
          <ac:chgData name="Yuki Yoshimatsu" userId="ba50b75ca1f18b98" providerId="LiveId" clId="{0B9C44EB-507D-404B-B200-37955C3B5627}" dt="2025-01-19T07:35:55.330" v="90" actId="478"/>
          <ac:spMkLst>
            <pc:docMk/>
            <pc:sldMk cId="1960080831" sldId="257"/>
            <ac:spMk id="559" creationId="{90C03013-2B87-A3F3-DB50-CF67F819FDB3}"/>
          </ac:spMkLst>
        </pc:spChg>
        <pc:spChg chg="del">
          <ac:chgData name="Yuki Yoshimatsu" userId="ba50b75ca1f18b98" providerId="LiveId" clId="{0B9C44EB-507D-404B-B200-37955C3B5627}" dt="2025-01-19T07:35:55.330" v="90" actId="478"/>
          <ac:spMkLst>
            <pc:docMk/>
            <pc:sldMk cId="1960080831" sldId="257"/>
            <ac:spMk id="561" creationId="{092796DB-6EF2-904C-F8E2-23E75D3F2E49}"/>
          </ac:spMkLst>
        </pc:spChg>
        <pc:spChg chg="del">
          <ac:chgData name="Yuki Yoshimatsu" userId="ba50b75ca1f18b98" providerId="LiveId" clId="{0B9C44EB-507D-404B-B200-37955C3B5627}" dt="2025-01-19T07:35:55.330" v="90" actId="478"/>
          <ac:spMkLst>
            <pc:docMk/>
            <pc:sldMk cId="1960080831" sldId="257"/>
            <ac:spMk id="562" creationId="{C64BDC10-9793-A748-843A-D3EB8CC72D48}"/>
          </ac:spMkLst>
        </pc:spChg>
        <pc:spChg chg="del">
          <ac:chgData name="Yuki Yoshimatsu" userId="ba50b75ca1f18b98" providerId="LiveId" clId="{0B9C44EB-507D-404B-B200-37955C3B5627}" dt="2025-01-19T07:33:54.547" v="86" actId="478"/>
          <ac:spMkLst>
            <pc:docMk/>
            <pc:sldMk cId="1960080831" sldId="257"/>
            <ac:spMk id="578" creationId="{15B6F819-9A5D-0B2A-0FEE-5701D3666B0B}"/>
          </ac:spMkLst>
        </pc:spChg>
        <pc:spChg chg="del">
          <ac:chgData name="Yuki Yoshimatsu" userId="ba50b75ca1f18b98" providerId="LiveId" clId="{0B9C44EB-507D-404B-B200-37955C3B5627}" dt="2025-01-19T07:35:55.330" v="90" actId="478"/>
          <ac:spMkLst>
            <pc:docMk/>
            <pc:sldMk cId="1960080831" sldId="257"/>
            <ac:spMk id="579" creationId="{79B2BBE8-0508-CC76-787F-A99F8B4A424E}"/>
          </ac:spMkLst>
        </pc:spChg>
        <pc:spChg chg="del">
          <ac:chgData name="Yuki Yoshimatsu" userId="ba50b75ca1f18b98" providerId="LiveId" clId="{0B9C44EB-507D-404B-B200-37955C3B5627}" dt="2025-01-19T07:35:55.330" v="90" actId="478"/>
          <ac:spMkLst>
            <pc:docMk/>
            <pc:sldMk cId="1960080831" sldId="257"/>
            <ac:spMk id="582" creationId="{65F4D531-D337-6D7A-0A86-A896E9A22BFA}"/>
          </ac:spMkLst>
        </pc:spChg>
        <pc:spChg chg="del">
          <ac:chgData name="Yuki Yoshimatsu" userId="ba50b75ca1f18b98" providerId="LiveId" clId="{0B9C44EB-507D-404B-B200-37955C3B5627}" dt="2025-01-19T07:33:54.547" v="86" actId="478"/>
          <ac:spMkLst>
            <pc:docMk/>
            <pc:sldMk cId="1960080831" sldId="257"/>
            <ac:spMk id="618" creationId="{8582B515-2F23-2D2D-1DE0-FB9BF8A68026}"/>
          </ac:spMkLst>
        </pc:spChg>
        <pc:spChg chg="del">
          <ac:chgData name="Yuki Yoshimatsu" userId="ba50b75ca1f18b98" providerId="LiveId" clId="{0B9C44EB-507D-404B-B200-37955C3B5627}" dt="2025-01-19T07:33:54.547" v="86" actId="478"/>
          <ac:spMkLst>
            <pc:docMk/>
            <pc:sldMk cId="1960080831" sldId="257"/>
            <ac:spMk id="640" creationId="{3DE889A9-F3B4-B093-667D-62DC8E3C9E67}"/>
          </ac:spMkLst>
        </pc:spChg>
        <pc:spChg chg="del">
          <ac:chgData name="Yuki Yoshimatsu" userId="ba50b75ca1f18b98" providerId="LiveId" clId="{0B9C44EB-507D-404B-B200-37955C3B5627}" dt="2025-01-19T07:33:54.547" v="86" actId="478"/>
          <ac:spMkLst>
            <pc:docMk/>
            <pc:sldMk cId="1960080831" sldId="257"/>
            <ac:spMk id="683" creationId="{D832C66D-7969-3D92-754B-0959975E2934}"/>
          </ac:spMkLst>
        </pc:spChg>
        <pc:spChg chg="del">
          <ac:chgData name="Yuki Yoshimatsu" userId="ba50b75ca1f18b98" providerId="LiveId" clId="{0B9C44EB-507D-404B-B200-37955C3B5627}" dt="2025-01-19T07:33:54.547" v="86" actId="478"/>
          <ac:spMkLst>
            <pc:docMk/>
            <pc:sldMk cId="1960080831" sldId="257"/>
            <ac:spMk id="684" creationId="{3FDA66CD-4606-E71C-EC58-D9B0B2B53BEB}"/>
          </ac:spMkLst>
        </pc:spChg>
        <pc:spChg chg="del">
          <ac:chgData name="Yuki Yoshimatsu" userId="ba50b75ca1f18b98" providerId="LiveId" clId="{0B9C44EB-507D-404B-B200-37955C3B5627}" dt="2025-01-19T07:33:54.547" v="86" actId="478"/>
          <ac:spMkLst>
            <pc:docMk/>
            <pc:sldMk cId="1960080831" sldId="257"/>
            <ac:spMk id="701" creationId="{BD43F78D-F596-DC5B-B8DC-35C37A2DB1A8}"/>
          </ac:spMkLst>
        </pc:spChg>
        <pc:spChg chg="del">
          <ac:chgData name="Yuki Yoshimatsu" userId="ba50b75ca1f18b98" providerId="LiveId" clId="{0B9C44EB-507D-404B-B200-37955C3B5627}" dt="2025-01-19T07:33:54.547" v="86" actId="478"/>
          <ac:spMkLst>
            <pc:docMk/>
            <pc:sldMk cId="1960080831" sldId="257"/>
            <ac:spMk id="702" creationId="{4F813700-5F63-6D29-3CB7-3D09DB6557D1}"/>
          </ac:spMkLst>
        </pc:spChg>
        <pc:spChg chg="del">
          <ac:chgData name="Yuki Yoshimatsu" userId="ba50b75ca1f18b98" providerId="LiveId" clId="{0B9C44EB-507D-404B-B200-37955C3B5627}" dt="2025-01-19T07:33:54.547" v="86" actId="478"/>
          <ac:spMkLst>
            <pc:docMk/>
            <pc:sldMk cId="1960080831" sldId="257"/>
            <ac:spMk id="720" creationId="{6AA36576-EBEA-0781-86AF-D8565097D250}"/>
          </ac:spMkLst>
        </pc:spChg>
        <pc:spChg chg="del">
          <ac:chgData name="Yuki Yoshimatsu" userId="ba50b75ca1f18b98" providerId="LiveId" clId="{0B9C44EB-507D-404B-B200-37955C3B5627}" dt="2025-01-19T07:33:54.547" v="86" actId="478"/>
          <ac:spMkLst>
            <pc:docMk/>
            <pc:sldMk cId="1960080831" sldId="257"/>
            <ac:spMk id="740" creationId="{A2444019-67B2-D90C-8BCC-E949A72C4CAE}"/>
          </ac:spMkLst>
        </pc:spChg>
        <pc:spChg chg="del">
          <ac:chgData name="Yuki Yoshimatsu" userId="ba50b75ca1f18b98" providerId="LiveId" clId="{0B9C44EB-507D-404B-B200-37955C3B5627}" dt="2025-01-19T11:09:55.080" v="150" actId="478"/>
          <ac:spMkLst>
            <pc:docMk/>
            <pc:sldMk cId="1960080831" sldId="257"/>
            <ac:spMk id="775" creationId="{CB80A32C-497C-111C-A269-09E228724D6C}"/>
          </ac:spMkLst>
        </pc:spChg>
        <pc:spChg chg="del">
          <ac:chgData name="Yuki Yoshimatsu" userId="ba50b75ca1f18b98" providerId="LiveId" clId="{0B9C44EB-507D-404B-B200-37955C3B5627}" dt="2025-01-19T11:09:55.080" v="150" actId="478"/>
          <ac:spMkLst>
            <pc:docMk/>
            <pc:sldMk cId="1960080831" sldId="257"/>
            <ac:spMk id="776" creationId="{1023FB89-70A2-9C07-8BAE-A1E239E44075}"/>
          </ac:spMkLst>
        </pc:spChg>
        <pc:spChg chg="del">
          <ac:chgData name="Yuki Yoshimatsu" userId="ba50b75ca1f18b98" providerId="LiveId" clId="{0B9C44EB-507D-404B-B200-37955C3B5627}" dt="2025-01-19T11:09:55.080" v="150" actId="478"/>
          <ac:spMkLst>
            <pc:docMk/>
            <pc:sldMk cId="1960080831" sldId="257"/>
            <ac:spMk id="782" creationId="{1B1FBCFC-6041-1CBB-96E7-56FA67030EBA}"/>
          </ac:spMkLst>
        </pc:spChg>
        <pc:spChg chg="del">
          <ac:chgData name="Yuki Yoshimatsu" userId="ba50b75ca1f18b98" providerId="LiveId" clId="{0B9C44EB-507D-404B-B200-37955C3B5627}" dt="2025-01-19T11:09:55.080" v="150" actId="478"/>
          <ac:spMkLst>
            <pc:docMk/>
            <pc:sldMk cId="1960080831" sldId="257"/>
            <ac:spMk id="783" creationId="{97122485-BE23-E327-8D84-71395AF59518}"/>
          </ac:spMkLst>
        </pc:spChg>
        <pc:spChg chg="del">
          <ac:chgData name="Yuki Yoshimatsu" userId="ba50b75ca1f18b98" providerId="LiveId" clId="{0B9C44EB-507D-404B-B200-37955C3B5627}" dt="2025-01-19T11:09:55.080" v="150" actId="478"/>
          <ac:spMkLst>
            <pc:docMk/>
            <pc:sldMk cId="1960080831" sldId="257"/>
            <ac:spMk id="784" creationId="{A6710726-5B21-9C6A-809A-5399B11DC1B4}"/>
          </ac:spMkLst>
        </pc:spChg>
        <pc:spChg chg="del">
          <ac:chgData name="Yuki Yoshimatsu" userId="ba50b75ca1f18b98" providerId="LiveId" clId="{0B9C44EB-507D-404B-B200-37955C3B5627}" dt="2025-01-19T11:09:55.080" v="150" actId="478"/>
          <ac:spMkLst>
            <pc:docMk/>
            <pc:sldMk cId="1960080831" sldId="257"/>
            <ac:spMk id="785" creationId="{4A050D31-D799-D635-35C4-FD31943FEDC7}"/>
          </ac:spMkLst>
        </pc:spChg>
        <pc:spChg chg="add mod">
          <ac:chgData name="Yuki Yoshimatsu" userId="ba50b75ca1f18b98" providerId="LiveId" clId="{0B9C44EB-507D-404B-B200-37955C3B5627}" dt="2025-01-19T11:21:56.190" v="232"/>
          <ac:spMkLst>
            <pc:docMk/>
            <pc:sldMk cId="1960080831" sldId="257"/>
            <ac:spMk id="789" creationId="{294DE069-6941-9D73-16C2-2A5D18F2AE81}"/>
          </ac:spMkLst>
        </pc:spChg>
        <pc:spChg chg="add mod">
          <ac:chgData name="Yuki Yoshimatsu" userId="ba50b75ca1f18b98" providerId="LiveId" clId="{0B9C44EB-507D-404B-B200-37955C3B5627}" dt="2025-01-19T11:22:09.570" v="235"/>
          <ac:spMkLst>
            <pc:docMk/>
            <pc:sldMk cId="1960080831" sldId="257"/>
            <ac:spMk id="793" creationId="{8ACC7D00-5644-2887-A1CC-0EF1FB04E8D0}"/>
          </ac:spMkLst>
        </pc:spChg>
        <pc:spChg chg="add mod">
          <ac:chgData name="Yuki Yoshimatsu" userId="ba50b75ca1f18b98" providerId="LiveId" clId="{0B9C44EB-507D-404B-B200-37955C3B5627}" dt="2025-01-19T11:22:44.093" v="238"/>
          <ac:spMkLst>
            <pc:docMk/>
            <pc:sldMk cId="1960080831" sldId="257"/>
            <ac:spMk id="797" creationId="{C68767E7-7735-FBD2-DA68-2D68852E1375}"/>
          </ac:spMkLst>
        </pc:spChg>
        <pc:spChg chg="add mod">
          <ac:chgData name="Yuki Yoshimatsu" userId="ba50b75ca1f18b98" providerId="LiveId" clId="{0B9C44EB-507D-404B-B200-37955C3B5627}" dt="2025-01-19T11:23:47.132" v="250"/>
          <ac:spMkLst>
            <pc:docMk/>
            <pc:sldMk cId="1960080831" sldId="257"/>
            <ac:spMk id="801" creationId="{401F67C8-7884-B970-BF62-5C2F88EE41DE}"/>
          </ac:spMkLst>
        </pc:spChg>
        <pc:spChg chg="add mod">
          <ac:chgData name="Yuki Yoshimatsu" userId="ba50b75ca1f18b98" providerId="LiveId" clId="{0B9C44EB-507D-404B-B200-37955C3B5627}" dt="2025-01-19T11:24:29.883" v="255"/>
          <ac:spMkLst>
            <pc:docMk/>
            <pc:sldMk cId="1960080831" sldId="257"/>
            <ac:spMk id="805" creationId="{2D48EA37-B83C-E264-E58F-D3378F701654}"/>
          </ac:spMkLst>
        </pc:spChg>
        <pc:spChg chg="add mod">
          <ac:chgData name="Yuki Yoshimatsu" userId="ba50b75ca1f18b98" providerId="LiveId" clId="{0B9C44EB-507D-404B-B200-37955C3B5627}" dt="2025-01-19T11:25:41.498" v="259"/>
          <ac:spMkLst>
            <pc:docMk/>
            <pc:sldMk cId="1960080831" sldId="257"/>
            <ac:spMk id="809" creationId="{77E42F2D-708B-71F9-CAC7-557FE11DA41A}"/>
          </ac:spMkLst>
        </pc:spChg>
        <pc:spChg chg="add mod">
          <ac:chgData name="Yuki Yoshimatsu" userId="ba50b75ca1f18b98" providerId="LiveId" clId="{0B9C44EB-507D-404B-B200-37955C3B5627}" dt="2025-01-19T11:27:22.462" v="263"/>
          <ac:spMkLst>
            <pc:docMk/>
            <pc:sldMk cId="1960080831" sldId="257"/>
            <ac:spMk id="813" creationId="{7961771A-93DC-86AC-88C7-38ED92FBEA8C}"/>
          </ac:spMkLst>
        </pc:spChg>
        <pc:spChg chg="add mod">
          <ac:chgData name="Yuki Yoshimatsu" userId="ba50b75ca1f18b98" providerId="LiveId" clId="{0B9C44EB-507D-404B-B200-37955C3B5627}" dt="2025-01-19T11:50:24.975" v="383" actId="554"/>
          <ac:spMkLst>
            <pc:docMk/>
            <pc:sldMk cId="1960080831" sldId="257"/>
            <ac:spMk id="815" creationId="{2AA1F8BF-B30F-8E3D-BA27-4EF73E5E34E9}"/>
          </ac:spMkLst>
        </pc:spChg>
        <pc:spChg chg="add mod">
          <ac:chgData name="Yuki Yoshimatsu" userId="ba50b75ca1f18b98" providerId="LiveId" clId="{0B9C44EB-507D-404B-B200-37955C3B5627}" dt="2025-01-19T11:50:58.650" v="385" actId="554"/>
          <ac:spMkLst>
            <pc:docMk/>
            <pc:sldMk cId="1960080831" sldId="257"/>
            <ac:spMk id="816" creationId="{4B3344FC-3244-061F-E0A9-F7012A4EEECA}"/>
          </ac:spMkLst>
        </pc:spChg>
        <pc:spChg chg="add mod">
          <ac:chgData name="Yuki Yoshimatsu" userId="ba50b75ca1f18b98" providerId="LiveId" clId="{0B9C44EB-507D-404B-B200-37955C3B5627}" dt="2025-01-19T11:53:11.424" v="405" actId="1076"/>
          <ac:spMkLst>
            <pc:docMk/>
            <pc:sldMk cId="1960080831" sldId="257"/>
            <ac:spMk id="817" creationId="{CF4F1C7E-B5C3-BBB9-B351-59C36DCD59BB}"/>
          </ac:spMkLst>
        </pc:spChg>
        <pc:spChg chg="add mod">
          <ac:chgData name="Yuki Yoshimatsu" userId="ba50b75ca1f18b98" providerId="LiveId" clId="{0B9C44EB-507D-404B-B200-37955C3B5627}" dt="2025-01-19T11:51:25.143" v="389" actId="554"/>
          <ac:spMkLst>
            <pc:docMk/>
            <pc:sldMk cId="1960080831" sldId="257"/>
            <ac:spMk id="818" creationId="{6127227E-527F-B818-D196-16366497056A}"/>
          </ac:spMkLst>
        </pc:spChg>
        <pc:spChg chg="add mod">
          <ac:chgData name="Yuki Yoshimatsu" userId="ba50b75ca1f18b98" providerId="LiveId" clId="{0B9C44EB-507D-404B-B200-37955C3B5627}" dt="2025-01-19T11:53:11.424" v="405" actId="1076"/>
          <ac:spMkLst>
            <pc:docMk/>
            <pc:sldMk cId="1960080831" sldId="257"/>
            <ac:spMk id="819" creationId="{3794DF78-99CF-EC05-482E-9B89724CFEAB}"/>
          </ac:spMkLst>
        </pc:spChg>
        <pc:spChg chg="add mod">
          <ac:chgData name="Yuki Yoshimatsu" userId="ba50b75ca1f18b98" providerId="LiveId" clId="{0B9C44EB-507D-404B-B200-37955C3B5627}" dt="2025-01-19T11:53:11.424" v="405" actId="1076"/>
          <ac:spMkLst>
            <pc:docMk/>
            <pc:sldMk cId="1960080831" sldId="257"/>
            <ac:spMk id="820" creationId="{FF9448BE-04BD-44A0-2F6D-8CF70D12B43A}"/>
          </ac:spMkLst>
        </pc:spChg>
        <pc:spChg chg="add mod">
          <ac:chgData name="Yuki Yoshimatsu" userId="ba50b75ca1f18b98" providerId="LiveId" clId="{0B9C44EB-507D-404B-B200-37955C3B5627}" dt="2025-01-19T11:52:46.603" v="401" actId="554"/>
          <ac:spMkLst>
            <pc:docMk/>
            <pc:sldMk cId="1960080831" sldId="257"/>
            <ac:spMk id="821" creationId="{4211EB1A-7C6B-6739-5A5D-4331D3F2E588}"/>
          </ac:spMkLst>
        </pc:spChg>
        <pc:spChg chg="add mod">
          <ac:chgData name="Yuki Yoshimatsu" userId="ba50b75ca1f18b98" providerId="LiveId" clId="{0B9C44EB-507D-404B-B200-37955C3B5627}" dt="2025-01-19T11:53:11.424" v="405" actId="1076"/>
          <ac:spMkLst>
            <pc:docMk/>
            <pc:sldMk cId="1960080831" sldId="257"/>
            <ac:spMk id="822" creationId="{B3A9D3B1-E797-3F7C-31D8-2BE157D8D233}"/>
          </ac:spMkLst>
        </pc:spChg>
        <pc:spChg chg="add mod">
          <ac:chgData name="Yuki Yoshimatsu" userId="ba50b75ca1f18b98" providerId="LiveId" clId="{0B9C44EB-507D-404B-B200-37955C3B5627}" dt="2025-01-19T11:52:22.176" v="397" actId="554"/>
          <ac:spMkLst>
            <pc:docMk/>
            <pc:sldMk cId="1960080831" sldId="257"/>
            <ac:spMk id="823" creationId="{92A38574-0ED0-D31D-4E1F-906CAB31BEDD}"/>
          </ac:spMkLst>
        </pc:spChg>
        <pc:spChg chg="add mod">
          <ac:chgData name="Yuki Yoshimatsu" userId="ba50b75ca1f18b98" providerId="LiveId" clId="{0B9C44EB-507D-404B-B200-37955C3B5627}" dt="2025-01-19T11:52:09.146" v="395" actId="554"/>
          <ac:spMkLst>
            <pc:docMk/>
            <pc:sldMk cId="1960080831" sldId="257"/>
            <ac:spMk id="824" creationId="{4E08F70D-1502-96D1-CCD4-62F0F63E46FF}"/>
          </ac:spMkLst>
        </pc:spChg>
        <pc:spChg chg="add mod">
          <ac:chgData name="Yuki Yoshimatsu" userId="ba50b75ca1f18b98" providerId="LiveId" clId="{0B9C44EB-507D-404B-B200-37955C3B5627}" dt="2025-01-19T11:52:34.091" v="399" actId="554"/>
          <ac:spMkLst>
            <pc:docMk/>
            <pc:sldMk cId="1960080831" sldId="257"/>
            <ac:spMk id="832" creationId="{CEFE7804-7AB1-53FC-2B21-7C1AEE587121}"/>
          </ac:spMkLst>
        </pc:spChg>
        <pc:spChg chg="add mod">
          <ac:chgData name="Yuki Yoshimatsu" userId="ba50b75ca1f18b98" providerId="LiveId" clId="{0B9C44EB-507D-404B-B200-37955C3B5627}" dt="2025-01-19T11:52:22.176" v="397" actId="554"/>
          <ac:spMkLst>
            <pc:docMk/>
            <pc:sldMk cId="1960080831" sldId="257"/>
            <ac:spMk id="833" creationId="{9530AE4B-2529-A5F3-2A70-2BD93589D04C}"/>
          </ac:spMkLst>
        </pc:spChg>
        <pc:spChg chg="add mod">
          <ac:chgData name="Yuki Yoshimatsu" userId="ba50b75ca1f18b98" providerId="LiveId" clId="{0B9C44EB-507D-404B-B200-37955C3B5627}" dt="2025-01-19T11:53:11.424" v="405" actId="1076"/>
          <ac:spMkLst>
            <pc:docMk/>
            <pc:sldMk cId="1960080831" sldId="257"/>
            <ac:spMk id="834" creationId="{78F4484D-6F30-8E36-0D44-E986E7CC3A51}"/>
          </ac:spMkLst>
        </pc:spChg>
        <pc:spChg chg="add mod">
          <ac:chgData name="Yuki Yoshimatsu" userId="ba50b75ca1f18b98" providerId="LiveId" clId="{0B9C44EB-507D-404B-B200-37955C3B5627}" dt="2025-01-19T11:31:31.087" v="315"/>
          <ac:spMkLst>
            <pc:docMk/>
            <pc:sldMk cId="1960080831" sldId="257"/>
            <ac:spMk id="847" creationId="{4A7D2091-0955-C603-4805-296EBEFBFB97}"/>
          </ac:spMkLst>
        </pc:spChg>
        <pc:spChg chg="add mod">
          <ac:chgData name="Yuki Yoshimatsu" userId="ba50b75ca1f18b98" providerId="LiveId" clId="{0B9C44EB-507D-404B-B200-37955C3B5627}" dt="2025-01-19T11:32:22.845" v="319"/>
          <ac:spMkLst>
            <pc:docMk/>
            <pc:sldMk cId="1960080831" sldId="257"/>
            <ac:spMk id="851" creationId="{C2EDF304-B9FA-6F81-1015-969C80F239BB}"/>
          </ac:spMkLst>
        </pc:spChg>
        <pc:spChg chg="add mod">
          <ac:chgData name="Yuki Yoshimatsu" userId="ba50b75ca1f18b98" providerId="LiveId" clId="{0B9C44EB-507D-404B-B200-37955C3B5627}" dt="2025-01-19T11:33:08.238" v="322"/>
          <ac:spMkLst>
            <pc:docMk/>
            <pc:sldMk cId="1960080831" sldId="257"/>
            <ac:spMk id="855" creationId="{EFFC4741-FA29-2AE8-FBFB-92672F0C1720}"/>
          </ac:spMkLst>
        </pc:spChg>
        <pc:spChg chg="add mod">
          <ac:chgData name="Yuki Yoshimatsu" userId="ba50b75ca1f18b98" providerId="LiveId" clId="{0B9C44EB-507D-404B-B200-37955C3B5627}" dt="2025-01-19T11:33:45.257" v="325"/>
          <ac:spMkLst>
            <pc:docMk/>
            <pc:sldMk cId="1960080831" sldId="257"/>
            <ac:spMk id="859" creationId="{53427826-FFA4-0AC2-B64D-D363F52A2C51}"/>
          </ac:spMkLst>
        </pc:spChg>
        <pc:spChg chg="add mod">
          <ac:chgData name="Yuki Yoshimatsu" userId="ba50b75ca1f18b98" providerId="LiveId" clId="{0B9C44EB-507D-404B-B200-37955C3B5627}" dt="2025-01-19T11:34:22.863" v="328"/>
          <ac:spMkLst>
            <pc:docMk/>
            <pc:sldMk cId="1960080831" sldId="257"/>
            <ac:spMk id="863" creationId="{467A2EA7-F45C-8A8F-603C-243A3008C40A}"/>
          </ac:spMkLst>
        </pc:spChg>
        <pc:spChg chg="add mod">
          <ac:chgData name="Yuki Yoshimatsu" userId="ba50b75ca1f18b98" providerId="LiveId" clId="{0B9C44EB-507D-404B-B200-37955C3B5627}" dt="2025-01-19T11:34:56.579" v="331"/>
          <ac:spMkLst>
            <pc:docMk/>
            <pc:sldMk cId="1960080831" sldId="257"/>
            <ac:spMk id="867" creationId="{84844556-3092-BE19-8A1D-A6A8E0F6DED1}"/>
          </ac:spMkLst>
        </pc:spChg>
        <pc:spChg chg="add mod">
          <ac:chgData name="Yuki Yoshimatsu" userId="ba50b75ca1f18b98" providerId="LiveId" clId="{0B9C44EB-507D-404B-B200-37955C3B5627}" dt="2025-01-19T11:35:40.733" v="334"/>
          <ac:spMkLst>
            <pc:docMk/>
            <pc:sldMk cId="1960080831" sldId="257"/>
            <ac:spMk id="871" creationId="{58E9736B-D766-D492-E506-983AAEAF73DC}"/>
          </ac:spMkLst>
        </pc:spChg>
        <pc:spChg chg="add mod">
          <ac:chgData name="Yuki Yoshimatsu" userId="ba50b75ca1f18b98" providerId="LiveId" clId="{0B9C44EB-507D-404B-B200-37955C3B5627}" dt="2025-01-19T11:36:17.516" v="337"/>
          <ac:spMkLst>
            <pc:docMk/>
            <pc:sldMk cId="1960080831" sldId="257"/>
            <ac:spMk id="875" creationId="{D7E99C52-19D5-F36C-40B4-8E424B1D0FAB}"/>
          </ac:spMkLst>
        </pc:spChg>
        <pc:spChg chg="add mod">
          <ac:chgData name="Yuki Yoshimatsu" userId="ba50b75ca1f18b98" providerId="LiveId" clId="{0B9C44EB-507D-404B-B200-37955C3B5627}" dt="2025-01-19T11:37:00.367" v="340"/>
          <ac:spMkLst>
            <pc:docMk/>
            <pc:sldMk cId="1960080831" sldId="257"/>
            <ac:spMk id="879" creationId="{117C2975-BDA5-F446-18B7-CCB45DBA44E9}"/>
          </ac:spMkLst>
        </pc:spChg>
        <pc:spChg chg="add mod">
          <ac:chgData name="Yuki Yoshimatsu" userId="ba50b75ca1f18b98" providerId="LiveId" clId="{0B9C44EB-507D-404B-B200-37955C3B5627}" dt="2025-01-19T11:37:47.686" v="343"/>
          <ac:spMkLst>
            <pc:docMk/>
            <pc:sldMk cId="1960080831" sldId="257"/>
            <ac:spMk id="883" creationId="{AA9ACB18-AF64-FE8A-4F2D-054DB25DA332}"/>
          </ac:spMkLst>
        </pc:spChg>
        <pc:spChg chg="add mod">
          <ac:chgData name="Yuki Yoshimatsu" userId="ba50b75ca1f18b98" providerId="LiveId" clId="{0B9C44EB-507D-404B-B200-37955C3B5627}" dt="2025-01-19T11:38:44.952" v="346"/>
          <ac:spMkLst>
            <pc:docMk/>
            <pc:sldMk cId="1960080831" sldId="257"/>
            <ac:spMk id="887" creationId="{463372C3-DE5A-5017-21A6-11F3A2432E47}"/>
          </ac:spMkLst>
        </pc:spChg>
        <pc:spChg chg="add mod">
          <ac:chgData name="Yuki Yoshimatsu" userId="ba50b75ca1f18b98" providerId="LiveId" clId="{0B9C44EB-507D-404B-B200-37955C3B5627}" dt="2025-01-19T11:43:57.303" v="350"/>
          <ac:spMkLst>
            <pc:docMk/>
            <pc:sldMk cId="1960080831" sldId="257"/>
            <ac:spMk id="891" creationId="{7169BE91-15B0-E99D-D53E-427673325292}"/>
          </ac:spMkLst>
        </pc:spChg>
        <pc:spChg chg="add mod">
          <ac:chgData name="Yuki Yoshimatsu" userId="ba50b75ca1f18b98" providerId="LiveId" clId="{0B9C44EB-507D-404B-B200-37955C3B5627}" dt="2025-01-19T11:44:50.113" v="353"/>
          <ac:spMkLst>
            <pc:docMk/>
            <pc:sldMk cId="1960080831" sldId="257"/>
            <ac:spMk id="895" creationId="{C916F38A-2234-DBE1-D745-4571663BA534}"/>
          </ac:spMkLst>
        </pc:spChg>
        <pc:spChg chg="add mod">
          <ac:chgData name="Yuki Yoshimatsu" userId="ba50b75ca1f18b98" providerId="LiveId" clId="{0B9C44EB-507D-404B-B200-37955C3B5627}" dt="2025-01-19T11:45:28.582" v="356"/>
          <ac:spMkLst>
            <pc:docMk/>
            <pc:sldMk cId="1960080831" sldId="257"/>
            <ac:spMk id="899" creationId="{AF859356-EEF9-06D4-2C1C-B315CD9BD85C}"/>
          </ac:spMkLst>
        </pc:spChg>
        <pc:spChg chg="add mod">
          <ac:chgData name="Yuki Yoshimatsu" userId="ba50b75ca1f18b98" providerId="LiveId" clId="{0B9C44EB-507D-404B-B200-37955C3B5627}" dt="2025-01-19T11:46:20.828" v="360"/>
          <ac:spMkLst>
            <pc:docMk/>
            <pc:sldMk cId="1960080831" sldId="257"/>
            <ac:spMk id="903" creationId="{0EF431FE-553B-77F8-0956-02B29CF03597}"/>
          </ac:spMkLst>
        </pc:spChg>
        <pc:spChg chg="add mod">
          <ac:chgData name="Yuki Yoshimatsu" userId="ba50b75ca1f18b98" providerId="LiveId" clId="{0B9C44EB-507D-404B-B200-37955C3B5627}" dt="2025-01-19T11:46:55.067" v="363"/>
          <ac:spMkLst>
            <pc:docMk/>
            <pc:sldMk cId="1960080831" sldId="257"/>
            <ac:spMk id="907" creationId="{F00D0138-1346-47A4-389C-E5D84C4FC7B5}"/>
          </ac:spMkLst>
        </pc:spChg>
        <pc:spChg chg="add mod">
          <ac:chgData name="Yuki Yoshimatsu" userId="ba50b75ca1f18b98" providerId="LiveId" clId="{0B9C44EB-507D-404B-B200-37955C3B5627}" dt="2025-01-19T11:47:32.751" v="366"/>
          <ac:spMkLst>
            <pc:docMk/>
            <pc:sldMk cId="1960080831" sldId="257"/>
            <ac:spMk id="911" creationId="{EE96F63B-3444-42A6-A564-E43471E0E000}"/>
          </ac:spMkLst>
        </pc:spChg>
        <pc:spChg chg="add mod">
          <ac:chgData name="Yuki Yoshimatsu" userId="ba50b75ca1f18b98" providerId="LiveId" clId="{0B9C44EB-507D-404B-B200-37955C3B5627}" dt="2025-01-19T11:48:14.545" v="369"/>
          <ac:spMkLst>
            <pc:docMk/>
            <pc:sldMk cId="1960080831" sldId="257"/>
            <ac:spMk id="915" creationId="{6DCC1A7C-2BB0-DD3F-B1CF-55729C492B5E}"/>
          </ac:spMkLst>
        </pc:spChg>
        <pc:spChg chg="add mod">
          <ac:chgData name="Yuki Yoshimatsu" userId="ba50b75ca1f18b98" providerId="LiveId" clId="{0B9C44EB-507D-404B-B200-37955C3B5627}" dt="2025-01-19T11:48:53.653" v="372"/>
          <ac:spMkLst>
            <pc:docMk/>
            <pc:sldMk cId="1960080831" sldId="257"/>
            <ac:spMk id="919" creationId="{DAA9D7BE-3727-5470-7F9D-400CA3C38DD0}"/>
          </ac:spMkLst>
        </pc:spChg>
        <pc:spChg chg="add mod">
          <ac:chgData name="Yuki Yoshimatsu" userId="ba50b75ca1f18b98" providerId="LiveId" clId="{0B9C44EB-507D-404B-B200-37955C3B5627}" dt="2025-01-19T11:49:35.330" v="375"/>
          <ac:spMkLst>
            <pc:docMk/>
            <pc:sldMk cId="1960080831" sldId="257"/>
            <ac:spMk id="923" creationId="{A66289C1-9275-42E6-0BFE-E2DC3A051CA9}"/>
          </ac:spMkLst>
        </pc:spChg>
        <pc:grpChg chg="add del mod">
          <ac:chgData name="Yuki Yoshimatsu" userId="ba50b75ca1f18b98" providerId="LiveId" clId="{0B9C44EB-507D-404B-B200-37955C3B5627}" dt="2025-01-19T07:39:22.736" v="126" actId="478"/>
          <ac:grpSpMkLst>
            <pc:docMk/>
            <pc:sldMk cId="1960080831" sldId="257"/>
            <ac:grpSpMk id="7" creationId="{CB6FC0C7-D495-EA8E-CC9E-02EA4E276740}"/>
          </ac:grpSpMkLst>
        </pc:grpChg>
        <pc:picChg chg="add del mod">
          <ac:chgData name="Yuki Yoshimatsu" userId="ba50b75ca1f18b98" providerId="LiveId" clId="{0B9C44EB-507D-404B-B200-37955C3B5627}" dt="2025-01-19T07:36:43.355" v="92" actId="478"/>
          <ac:picMkLst>
            <pc:docMk/>
            <pc:sldMk cId="1960080831" sldId="257"/>
            <ac:picMk id="2" creationId="{78843B15-EB02-B6EF-A876-E1E4E9BD6917}"/>
          </ac:picMkLst>
        </pc:picChg>
        <pc:picChg chg="add del mod">
          <ac:chgData name="Yuki Yoshimatsu" userId="ba50b75ca1f18b98" providerId="LiveId" clId="{0B9C44EB-507D-404B-B200-37955C3B5627}" dt="2025-01-19T07:36:43.355" v="92" actId="478"/>
          <ac:picMkLst>
            <pc:docMk/>
            <pc:sldMk cId="1960080831" sldId="257"/>
            <ac:picMk id="3" creationId="{7A71C4BC-D017-F738-06FD-2580DB056C1F}"/>
          </ac:picMkLst>
        </pc:picChg>
        <pc:picChg chg="add del mod">
          <ac:chgData name="Yuki Yoshimatsu" userId="ba50b75ca1f18b98" providerId="LiveId" clId="{0B9C44EB-507D-404B-B200-37955C3B5627}" dt="2025-01-19T11:19:10.685" v="198" actId="478"/>
          <ac:picMkLst>
            <pc:docMk/>
            <pc:sldMk cId="1960080831" sldId="257"/>
            <ac:picMk id="4" creationId="{21F8CFDE-9C90-2C62-6B4C-3D5F69C7D54A}"/>
          </ac:picMkLst>
        </pc:picChg>
        <pc:picChg chg="add del mod">
          <ac:chgData name="Yuki Yoshimatsu" userId="ba50b75ca1f18b98" providerId="LiveId" clId="{0B9C44EB-507D-404B-B200-37955C3B5627}" dt="2025-01-19T11:19:10.228" v="197" actId="478"/>
          <ac:picMkLst>
            <pc:docMk/>
            <pc:sldMk cId="1960080831" sldId="257"/>
            <ac:picMk id="5" creationId="{69BC711C-C97C-E283-5303-EFB35CAD1910}"/>
          </ac:picMkLst>
        </pc:picChg>
        <pc:picChg chg="add del mod">
          <ac:chgData name="Yuki Yoshimatsu" userId="ba50b75ca1f18b98" providerId="LiveId" clId="{0B9C44EB-507D-404B-B200-37955C3B5627}" dt="2025-01-19T11:19:11.500" v="199" actId="478"/>
          <ac:picMkLst>
            <pc:docMk/>
            <pc:sldMk cId="1960080831" sldId="257"/>
            <ac:picMk id="13" creationId="{7BE5208A-5163-0E7F-B18A-E4F1B8ADA7CD}"/>
          </ac:picMkLst>
        </pc:picChg>
        <pc:picChg chg="add del mod">
          <ac:chgData name="Yuki Yoshimatsu" userId="ba50b75ca1f18b98" providerId="LiveId" clId="{0B9C44EB-507D-404B-B200-37955C3B5627}" dt="2025-01-19T11:19:12.137" v="200" actId="478"/>
          <ac:picMkLst>
            <pc:docMk/>
            <pc:sldMk cId="1960080831" sldId="257"/>
            <ac:picMk id="14" creationId="{CA347EDE-6C81-0468-6233-6FA898786E31}"/>
          </ac:picMkLst>
        </pc:picChg>
        <pc:picChg chg="add del mod">
          <ac:chgData name="Yuki Yoshimatsu" userId="ba50b75ca1f18b98" providerId="LiveId" clId="{0B9C44EB-507D-404B-B200-37955C3B5627}" dt="2025-01-19T11:19:12.707" v="201" actId="478"/>
          <ac:picMkLst>
            <pc:docMk/>
            <pc:sldMk cId="1960080831" sldId="257"/>
            <ac:picMk id="15" creationId="{7732F0D5-3F7D-77F0-A36C-7AC3D033F822}"/>
          </ac:picMkLst>
        </pc:picChg>
        <pc:picChg chg="add del mod">
          <ac:chgData name="Yuki Yoshimatsu" userId="ba50b75ca1f18b98" providerId="LiveId" clId="{0B9C44EB-507D-404B-B200-37955C3B5627}" dt="2025-01-19T11:19:13.286" v="202" actId="478"/>
          <ac:picMkLst>
            <pc:docMk/>
            <pc:sldMk cId="1960080831" sldId="257"/>
            <ac:picMk id="16" creationId="{3C31E8FE-B3B7-29BD-8AA1-A2B52614E9A4}"/>
          </ac:picMkLst>
        </pc:picChg>
        <pc:picChg chg="add del mod">
          <ac:chgData name="Yuki Yoshimatsu" userId="ba50b75ca1f18b98" providerId="LiveId" clId="{0B9C44EB-507D-404B-B200-37955C3B5627}" dt="2025-01-19T11:19:13.848" v="203" actId="478"/>
          <ac:picMkLst>
            <pc:docMk/>
            <pc:sldMk cId="1960080831" sldId="257"/>
            <ac:picMk id="18" creationId="{142689CF-B121-E3B9-DEB0-00BF23BCD7C8}"/>
          </ac:picMkLst>
        </pc:picChg>
        <pc:picChg chg="add del mod">
          <ac:chgData name="Yuki Yoshimatsu" userId="ba50b75ca1f18b98" providerId="LiveId" clId="{0B9C44EB-507D-404B-B200-37955C3B5627}" dt="2025-01-19T11:19:14.434" v="204" actId="478"/>
          <ac:picMkLst>
            <pc:docMk/>
            <pc:sldMk cId="1960080831" sldId="257"/>
            <ac:picMk id="19" creationId="{1127DF2A-D5DF-CD62-E52C-46C94F8F3D6F}"/>
          </ac:picMkLst>
        </pc:picChg>
        <pc:picChg chg="add del mod">
          <ac:chgData name="Yuki Yoshimatsu" userId="ba50b75ca1f18b98" providerId="LiveId" clId="{0B9C44EB-507D-404B-B200-37955C3B5627}" dt="2025-01-19T11:19:15.438" v="205" actId="478"/>
          <ac:picMkLst>
            <pc:docMk/>
            <pc:sldMk cId="1960080831" sldId="257"/>
            <ac:picMk id="21" creationId="{D68315D5-2D12-639A-9661-2E3519483FE1}"/>
          </ac:picMkLst>
        </pc:picChg>
        <pc:picChg chg="add del mod">
          <ac:chgData name="Yuki Yoshimatsu" userId="ba50b75ca1f18b98" providerId="LiveId" clId="{0B9C44EB-507D-404B-B200-37955C3B5627}" dt="2025-01-19T11:19:15.915" v="206" actId="478"/>
          <ac:picMkLst>
            <pc:docMk/>
            <pc:sldMk cId="1960080831" sldId="257"/>
            <ac:picMk id="22" creationId="{05F8BF3A-678A-D1D5-E21C-0290D2367859}"/>
          </ac:picMkLst>
        </pc:picChg>
        <pc:picChg chg="add del mod">
          <ac:chgData name="Yuki Yoshimatsu" userId="ba50b75ca1f18b98" providerId="LiveId" clId="{0B9C44EB-507D-404B-B200-37955C3B5627}" dt="2025-01-19T11:19:16.393" v="207" actId="478"/>
          <ac:picMkLst>
            <pc:docMk/>
            <pc:sldMk cId="1960080831" sldId="257"/>
            <ac:picMk id="24" creationId="{1B99BA5F-83E9-8FEC-A83E-9706AC38D875}"/>
          </ac:picMkLst>
        </pc:picChg>
        <pc:picChg chg="add del mod">
          <ac:chgData name="Yuki Yoshimatsu" userId="ba50b75ca1f18b98" providerId="LiveId" clId="{0B9C44EB-507D-404B-B200-37955C3B5627}" dt="2025-01-19T11:19:16.858" v="208" actId="478"/>
          <ac:picMkLst>
            <pc:docMk/>
            <pc:sldMk cId="1960080831" sldId="257"/>
            <ac:picMk id="25" creationId="{B637078C-3E02-63BB-FC0A-AACC202B608D}"/>
          </ac:picMkLst>
        </pc:picChg>
        <pc:picChg chg="add del mod">
          <ac:chgData name="Yuki Yoshimatsu" userId="ba50b75ca1f18b98" providerId="LiveId" clId="{0B9C44EB-507D-404B-B200-37955C3B5627}" dt="2025-01-19T11:19:17.376" v="209" actId="478"/>
          <ac:picMkLst>
            <pc:docMk/>
            <pc:sldMk cId="1960080831" sldId="257"/>
            <ac:picMk id="39" creationId="{B6668A29-69EF-DB2C-90E1-A98970D63742}"/>
          </ac:picMkLst>
        </pc:picChg>
        <pc:picChg chg="add del mod">
          <ac:chgData name="Yuki Yoshimatsu" userId="ba50b75ca1f18b98" providerId="LiveId" clId="{0B9C44EB-507D-404B-B200-37955C3B5627}" dt="2025-01-19T11:19:17.808" v="210" actId="478"/>
          <ac:picMkLst>
            <pc:docMk/>
            <pc:sldMk cId="1960080831" sldId="257"/>
            <ac:picMk id="40" creationId="{026496CC-B689-ABB9-CC55-CEA23B664C4D}"/>
          </ac:picMkLst>
        </pc:picChg>
        <pc:picChg chg="add mod">
          <ac:chgData name="Yuki Yoshimatsu" userId="ba50b75ca1f18b98" providerId="LiveId" clId="{0B9C44EB-507D-404B-B200-37955C3B5627}" dt="2025-01-19T11:18:27.484" v="192"/>
          <ac:picMkLst>
            <pc:docMk/>
            <pc:sldMk cId="1960080831" sldId="257"/>
            <ac:picMk id="41" creationId="{14C37AC3-23B0-D4C4-ABEE-AA9C3C266101}"/>
          </ac:picMkLst>
        </pc:picChg>
        <pc:picChg chg="add mod">
          <ac:chgData name="Yuki Yoshimatsu" userId="ba50b75ca1f18b98" providerId="LiveId" clId="{0B9C44EB-507D-404B-B200-37955C3B5627}" dt="2025-01-19T11:18:27.484" v="192"/>
          <ac:picMkLst>
            <pc:docMk/>
            <pc:sldMk cId="1960080831" sldId="257"/>
            <ac:picMk id="42" creationId="{67F3E671-D6F4-7D4E-7B97-67741B770B62}"/>
          </ac:picMkLst>
        </pc:picChg>
        <pc:picChg chg="add del mod">
          <ac:chgData name="Yuki Yoshimatsu" userId="ba50b75ca1f18b98" providerId="LiveId" clId="{0B9C44EB-507D-404B-B200-37955C3B5627}" dt="2025-01-19T11:23:46.721" v="249" actId="478"/>
          <ac:picMkLst>
            <pc:docMk/>
            <pc:sldMk cId="1960080831" sldId="257"/>
            <ac:picMk id="44" creationId="{E4F944DD-6601-30F3-7315-A61641985486}"/>
          </ac:picMkLst>
        </pc:picChg>
        <pc:picChg chg="add mod">
          <ac:chgData name="Yuki Yoshimatsu" userId="ba50b75ca1f18b98" providerId="LiveId" clId="{0B9C44EB-507D-404B-B200-37955C3B5627}" dt="2025-01-19T11:19:36.252" v="211"/>
          <ac:picMkLst>
            <pc:docMk/>
            <pc:sldMk cId="1960080831" sldId="257"/>
            <ac:picMk id="45" creationId="{6FC43C8E-FDB6-6D0C-B421-D5C74CE586B1}"/>
          </ac:picMkLst>
        </pc:picChg>
        <pc:picChg chg="add mod">
          <ac:chgData name="Yuki Yoshimatsu" userId="ba50b75ca1f18b98" providerId="LiveId" clId="{0B9C44EB-507D-404B-B200-37955C3B5627}" dt="2025-01-19T11:19:36.252" v="211"/>
          <ac:picMkLst>
            <pc:docMk/>
            <pc:sldMk cId="1960080831" sldId="257"/>
            <ac:picMk id="46" creationId="{A4D15D10-1FC2-2B52-D03D-E5DC828CD460}"/>
          </ac:picMkLst>
        </pc:picChg>
        <pc:picChg chg="add mod">
          <ac:chgData name="Yuki Yoshimatsu" userId="ba50b75ca1f18b98" providerId="LiveId" clId="{0B9C44EB-507D-404B-B200-37955C3B5627}" dt="2025-01-19T11:52:15.961" v="396" actId="554"/>
          <ac:picMkLst>
            <pc:docMk/>
            <pc:sldMk cId="1960080831" sldId="257"/>
            <ac:picMk id="48" creationId="{51EC9936-856A-0236-3F81-237987C3D56F}"/>
          </ac:picMkLst>
        </pc:picChg>
        <pc:picChg chg="add mod">
          <ac:chgData name="Yuki Yoshimatsu" userId="ba50b75ca1f18b98" providerId="LiveId" clId="{0B9C44EB-507D-404B-B200-37955C3B5627}" dt="2025-01-19T11:20:09.967" v="214"/>
          <ac:picMkLst>
            <pc:docMk/>
            <pc:sldMk cId="1960080831" sldId="257"/>
            <ac:picMk id="49" creationId="{99B34B6D-1E63-1D2B-2C3C-76B47AD9E70F}"/>
          </ac:picMkLst>
        </pc:picChg>
        <pc:picChg chg="add mod">
          <ac:chgData name="Yuki Yoshimatsu" userId="ba50b75ca1f18b98" providerId="LiveId" clId="{0B9C44EB-507D-404B-B200-37955C3B5627}" dt="2025-01-19T11:20:09.967" v="214"/>
          <ac:picMkLst>
            <pc:docMk/>
            <pc:sldMk cId="1960080831" sldId="257"/>
            <ac:picMk id="50" creationId="{D35A0718-B364-3406-C7D3-198AB0366555}"/>
          </ac:picMkLst>
        </pc:picChg>
        <pc:picChg chg="add del mod">
          <ac:chgData name="Yuki Yoshimatsu" userId="ba50b75ca1f18b98" providerId="LiveId" clId="{0B9C44EB-507D-404B-B200-37955C3B5627}" dt="2025-01-19T11:20:15.864" v="216" actId="478"/>
          <ac:picMkLst>
            <pc:docMk/>
            <pc:sldMk cId="1960080831" sldId="257"/>
            <ac:picMk id="52" creationId="{38B074EB-F7B3-1A59-7C05-981DDD23D850}"/>
          </ac:picMkLst>
        </pc:picChg>
        <pc:picChg chg="add mod">
          <ac:chgData name="Yuki Yoshimatsu" userId="ba50b75ca1f18b98" providerId="LiveId" clId="{0B9C44EB-507D-404B-B200-37955C3B5627}" dt="2025-01-19T11:20:27.004" v="217"/>
          <ac:picMkLst>
            <pc:docMk/>
            <pc:sldMk cId="1960080831" sldId="257"/>
            <ac:picMk id="53" creationId="{F8199A5C-2E9F-8CB5-6A21-789B0882E07F}"/>
          </ac:picMkLst>
        </pc:picChg>
        <pc:picChg chg="add mod">
          <ac:chgData name="Yuki Yoshimatsu" userId="ba50b75ca1f18b98" providerId="LiveId" clId="{0B9C44EB-507D-404B-B200-37955C3B5627}" dt="2025-01-19T11:20:27.004" v="217"/>
          <ac:picMkLst>
            <pc:docMk/>
            <pc:sldMk cId="1960080831" sldId="257"/>
            <ac:picMk id="54" creationId="{E768663F-320D-312C-4985-4C8482EC4920}"/>
          </ac:picMkLst>
        </pc:picChg>
        <pc:picChg chg="add mod">
          <ac:chgData name="Yuki Yoshimatsu" userId="ba50b75ca1f18b98" providerId="LiveId" clId="{0B9C44EB-507D-404B-B200-37955C3B5627}" dt="2025-01-19T11:50:45.819" v="384" actId="554"/>
          <ac:picMkLst>
            <pc:docMk/>
            <pc:sldMk cId="1960080831" sldId="257"/>
            <ac:picMk id="56" creationId="{92AC8008-26F1-5E2F-145D-21A3F1CA4995}"/>
          </ac:picMkLst>
        </pc:picChg>
        <pc:picChg chg="add mod">
          <ac:chgData name="Yuki Yoshimatsu" userId="ba50b75ca1f18b98" providerId="LiveId" clId="{0B9C44EB-507D-404B-B200-37955C3B5627}" dt="2025-01-19T11:21:00.492" v="224"/>
          <ac:picMkLst>
            <pc:docMk/>
            <pc:sldMk cId="1960080831" sldId="257"/>
            <ac:picMk id="57" creationId="{11778670-17E0-DACE-2624-2D6709ABEF39}"/>
          </ac:picMkLst>
        </pc:picChg>
        <pc:picChg chg="add mod">
          <ac:chgData name="Yuki Yoshimatsu" userId="ba50b75ca1f18b98" providerId="LiveId" clId="{0B9C44EB-507D-404B-B200-37955C3B5627}" dt="2025-01-19T11:21:00.492" v="224"/>
          <ac:picMkLst>
            <pc:docMk/>
            <pc:sldMk cId="1960080831" sldId="257"/>
            <ac:picMk id="58" creationId="{A5674078-3613-5BD9-1ED2-56FAC8E58E06}"/>
          </ac:picMkLst>
        </pc:picChg>
        <pc:picChg chg="add mod">
          <ac:chgData name="Yuki Yoshimatsu" userId="ba50b75ca1f18b98" providerId="LiveId" clId="{0B9C44EB-507D-404B-B200-37955C3B5627}" dt="2025-01-19T11:51:04.228" v="386" actId="554"/>
          <ac:picMkLst>
            <pc:docMk/>
            <pc:sldMk cId="1960080831" sldId="257"/>
            <ac:picMk id="60" creationId="{F506D30F-CB4E-54E5-4710-F0D656E389F1}"/>
          </ac:picMkLst>
        </pc:picChg>
        <pc:picChg chg="add mod">
          <ac:chgData name="Yuki Yoshimatsu" userId="ba50b75ca1f18b98" providerId="LiveId" clId="{0B9C44EB-507D-404B-B200-37955C3B5627}" dt="2025-01-19T11:21:23.714" v="228"/>
          <ac:picMkLst>
            <pc:docMk/>
            <pc:sldMk cId="1960080831" sldId="257"/>
            <ac:picMk id="61" creationId="{CB5A42AB-8F0E-1EFA-DE1B-4E3BEA4A61EB}"/>
          </ac:picMkLst>
        </pc:picChg>
        <pc:picChg chg="add mod">
          <ac:chgData name="Yuki Yoshimatsu" userId="ba50b75ca1f18b98" providerId="LiveId" clId="{0B9C44EB-507D-404B-B200-37955C3B5627}" dt="2025-01-19T11:21:23.714" v="228"/>
          <ac:picMkLst>
            <pc:docMk/>
            <pc:sldMk cId="1960080831" sldId="257"/>
            <ac:picMk id="62" creationId="{51A5BC46-947D-979A-966F-7173A72ED9F8}"/>
          </ac:picMkLst>
        </pc:picChg>
        <pc:picChg chg="del">
          <ac:chgData name="Yuki Yoshimatsu" userId="ba50b75ca1f18b98" providerId="LiveId" clId="{0B9C44EB-507D-404B-B200-37955C3B5627}" dt="2025-01-19T11:29:01.831" v="281" actId="478"/>
          <ac:picMkLst>
            <pc:docMk/>
            <pc:sldMk cId="1960080831" sldId="257"/>
            <ac:picMk id="384" creationId="{1C211977-1E16-FE65-39A0-7701E7582DEB}"/>
          </ac:picMkLst>
        </pc:picChg>
        <pc:picChg chg="del">
          <ac:chgData name="Yuki Yoshimatsu" userId="ba50b75ca1f18b98" providerId="LiveId" clId="{0B9C44EB-507D-404B-B200-37955C3B5627}" dt="2025-01-19T11:29:01.831" v="281" actId="478"/>
          <ac:picMkLst>
            <pc:docMk/>
            <pc:sldMk cId="1960080831" sldId="257"/>
            <ac:picMk id="385" creationId="{1EF974D0-3D37-51C8-A482-3C3B24348CF6}"/>
          </ac:picMkLst>
        </pc:picChg>
        <pc:picChg chg="del">
          <ac:chgData name="Yuki Yoshimatsu" userId="ba50b75ca1f18b98" providerId="LiveId" clId="{0B9C44EB-507D-404B-B200-37955C3B5627}" dt="2025-01-19T11:29:01.831" v="281" actId="478"/>
          <ac:picMkLst>
            <pc:docMk/>
            <pc:sldMk cId="1960080831" sldId="257"/>
            <ac:picMk id="386" creationId="{6AACCB24-6617-39AC-D743-5D681342C8DB}"/>
          </ac:picMkLst>
        </pc:picChg>
        <pc:picChg chg="del">
          <ac:chgData name="Yuki Yoshimatsu" userId="ba50b75ca1f18b98" providerId="LiveId" clId="{0B9C44EB-507D-404B-B200-37955C3B5627}" dt="2025-01-19T11:09:55.080" v="150" actId="478"/>
          <ac:picMkLst>
            <pc:docMk/>
            <pc:sldMk cId="1960080831" sldId="257"/>
            <ac:picMk id="777" creationId="{9E75D2CB-E79A-B2C4-85DD-1ACEF7A3777E}"/>
          </ac:picMkLst>
        </pc:picChg>
        <pc:picChg chg="del">
          <ac:chgData name="Yuki Yoshimatsu" userId="ba50b75ca1f18b98" providerId="LiveId" clId="{0B9C44EB-507D-404B-B200-37955C3B5627}" dt="2025-01-19T11:09:55.080" v="150" actId="478"/>
          <ac:picMkLst>
            <pc:docMk/>
            <pc:sldMk cId="1960080831" sldId="257"/>
            <ac:picMk id="779" creationId="{BF87ED67-51A3-25BC-289F-44CA70E802A5}"/>
          </ac:picMkLst>
        </pc:picChg>
        <pc:picChg chg="del">
          <ac:chgData name="Yuki Yoshimatsu" userId="ba50b75ca1f18b98" providerId="LiveId" clId="{0B9C44EB-507D-404B-B200-37955C3B5627}" dt="2025-01-19T11:09:55.080" v="150" actId="478"/>
          <ac:picMkLst>
            <pc:docMk/>
            <pc:sldMk cId="1960080831" sldId="257"/>
            <ac:picMk id="780" creationId="{203AC59C-D75F-1C4D-B92F-32F4E562012F}"/>
          </ac:picMkLst>
        </pc:picChg>
        <pc:picChg chg="del">
          <ac:chgData name="Yuki Yoshimatsu" userId="ba50b75ca1f18b98" providerId="LiveId" clId="{0B9C44EB-507D-404B-B200-37955C3B5627}" dt="2025-01-19T11:09:55.080" v="150" actId="478"/>
          <ac:picMkLst>
            <pc:docMk/>
            <pc:sldMk cId="1960080831" sldId="257"/>
            <ac:picMk id="781" creationId="{A6D37CCD-CA6F-1D13-690A-6F21267D9076}"/>
          </ac:picMkLst>
        </pc:picChg>
        <pc:picChg chg="add mod">
          <ac:chgData name="Yuki Yoshimatsu" userId="ba50b75ca1f18b98" providerId="LiveId" clId="{0B9C44EB-507D-404B-B200-37955C3B5627}" dt="2025-01-19T11:51:18.321" v="388" actId="554"/>
          <ac:picMkLst>
            <pc:docMk/>
            <pc:sldMk cId="1960080831" sldId="257"/>
            <ac:picMk id="786" creationId="{66DF7007-69DA-6290-1C50-C95E1EB320B4}"/>
          </ac:picMkLst>
        </pc:picChg>
        <pc:picChg chg="add mod">
          <ac:chgData name="Yuki Yoshimatsu" userId="ba50b75ca1f18b98" providerId="LiveId" clId="{0B9C44EB-507D-404B-B200-37955C3B5627}" dt="2025-01-19T11:21:56.190" v="232"/>
          <ac:picMkLst>
            <pc:docMk/>
            <pc:sldMk cId="1960080831" sldId="257"/>
            <ac:picMk id="787" creationId="{B2BCC585-C42C-6D2C-FC5F-6B0D416F7267}"/>
          </ac:picMkLst>
        </pc:picChg>
        <pc:picChg chg="add mod">
          <ac:chgData name="Yuki Yoshimatsu" userId="ba50b75ca1f18b98" providerId="LiveId" clId="{0B9C44EB-507D-404B-B200-37955C3B5627}" dt="2025-01-19T11:21:56.190" v="232"/>
          <ac:picMkLst>
            <pc:docMk/>
            <pc:sldMk cId="1960080831" sldId="257"/>
            <ac:picMk id="788" creationId="{6E351340-47BE-6510-E7FB-235ABE9039FB}"/>
          </ac:picMkLst>
        </pc:picChg>
        <pc:picChg chg="add mod">
          <ac:chgData name="Yuki Yoshimatsu" userId="ba50b75ca1f18b98" providerId="LiveId" clId="{0B9C44EB-507D-404B-B200-37955C3B5627}" dt="2025-01-19T11:51:31.417" v="390" actId="554"/>
          <ac:picMkLst>
            <pc:docMk/>
            <pc:sldMk cId="1960080831" sldId="257"/>
            <ac:picMk id="790" creationId="{513BF4F1-AB88-D0C5-0760-C736C1EA8EDF}"/>
          </ac:picMkLst>
        </pc:picChg>
        <pc:picChg chg="add mod">
          <ac:chgData name="Yuki Yoshimatsu" userId="ba50b75ca1f18b98" providerId="LiveId" clId="{0B9C44EB-507D-404B-B200-37955C3B5627}" dt="2025-01-19T11:22:09.570" v="235"/>
          <ac:picMkLst>
            <pc:docMk/>
            <pc:sldMk cId="1960080831" sldId="257"/>
            <ac:picMk id="791" creationId="{351C464E-8540-BFCB-80CB-B2B0A148DA58}"/>
          </ac:picMkLst>
        </pc:picChg>
        <pc:picChg chg="add mod">
          <ac:chgData name="Yuki Yoshimatsu" userId="ba50b75ca1f18b98" providerId="LiveId" clId="{0B9C44EB-507D-404B-B200-37955C3B5627}" dt="2025-01-19T11:22:09.570" v="235"/>
          <ac:picMkLst>
            <pc:docMk/>
            <pc:sldMk cId="1960080831" sldId="257"/>
            <ac:picMk id="792" creationId="{41374095-1375-4FEE-6196-73DD9F6432DA}"/>
          </ac:picMkLst>
        </pc:picChg>
        <pc:picChg chg="add mod">
          <ac:chgData name="Yuki Yoshimatsu" userId="ba50b75ca1f18b98" providerId="LiveId" clId="{0B9C44EB-507D-404B-B200-37955C3B5627}" dt="2025-01-19T11:51:49.111" v="392" actId="554"/>
          <ac:picMkLst>
            <pc:docMk/>
            <pc:sldMk cId="1960080831" sldId="257"/>
            <ac:picMk id="794" creationId="{965A9D9F-AE05-81C6-E682-9E5A337256F2}"/>
          </ac:picMkLst>
        </pc:picChg>
        <pc:picChg chg="add mod">
          <ac:chgData name="Yuki Yoshimatsu" userId="ba50b75ca1f18b98" providerId="LiveId" clId="{0B9C44EB-507D-404B-B200-37955C3B5627}" dt="2025-01-19T11:22:44.093" v="238"/>
          <ac:picMkLst>
            <pc:docMk/>
            <pc:sldMk cId="1960080831" sldId="257"/>
            <ac:picMk id="795" creationId="{8932C43E-CEAC-F0F2-9093-64A5E84F1117}"/>
          </ac:picMkLst>
        </pc:picChg>
        <pc:picChg chg="add mod">
          <ac:chgData name="Yuki Yoshimatsu" userId="ba50b75ca1f18b98" providerId="LiveId" clId="{0B9C44EB-507D-404B-B200-37955C3B5627}" dt="2025-01-19T11:22:44.093" v="238"/>
          <ac:picMkLst>
            <pc:docMk/>
            <pc:sldMk cId="1960080831" sldId="257"/>
            <ac:picMk id="796" creationId="{0B12EEAE-1712-D970-733A-88330B73E7E6}"/>
          </ac:picMkLst>
        </pc:picChg>
        <pc:picChg chg="add mod">
          <ac:chgData name="Yuki Yoshimatsu" userId="ba50b75ca1f18b98" providerId="LiveId" clId="{0B9C44EB-507D-404B-B200-37955C3B5627}" dt="2025-01-19T11:52:03.266" v="394" actId="554"/>
          <ac:picMkLst>
            <pc:docMk/>
            <pc:sldMk cId="1960080831" sldId="257"/>
            <ac:picMk id="798" creationId="{8FC345C2-B756-D773-B9EC-6D097FED9F65}"/>
          </ac:picMkLst>
        </pc:picChg>
        <pc:picChg chg="add mod">
          <ac:chgData name="Yuki Yoshimatsu" userId="ba50b75ca1f18b98" providerId="LiveId" clId="{0B9C44EB-507D-404B-B200-37955C3B5627}" dt="2025-01-19T11:23:47.132" v="250"/>
          <ac:picMkLst>
            <pc:docMk/>
            <pc:sldMk cId="1960080831" sldId="257"/>
            <ac:picMk id="799" creationId="{518FC562-4BFA-97E8-1640-0FD58EB0DB5E}"/>
          </ac:picMkLst>
        </pc:picChg>
        <pc:picChg chg="add mod">
          <ac:chgData name="Yuki Yoshimatsu" userId="ba50b75ca1f18b98" providerId="LiveId" clId="{0B9C44EB-507D-404B-B200-37955C3B5627}" dt="2025-01-19T11:23:47.132" v="250"/>
          <ac:picMkLst>
            <pc:docMk/>
            <pc:sldMk cId="1960080831" sldId="257"/>
            <ac:picMk id="800" creationId="{6299608D-2453-AAA9-CFEF-72746F505EFD}"/>
          </ac:picMkLst>
        </pc:picChg>
        <pc:picChg chg="add del mod">
          <ac:chgData name="Yuki Yoshimatsu" userId="ba50b75ca1f18b98" providerId="LiveId" clId="{0B9C44EB-507D-404B-B200-37955C3B5627}" dt="2025-01-19T11:24:29.578" v="254" actId="478"/>
          <ac:picMkLst>
            <pc:docMk/>
            <pc:sldMk cId="1960080831" sldId="257"/>
            <ac:picMk id="802" creationId="{85F9E8A4-C890-BFAD-51EA-AA9FF80DC3E1}"/>
          </ac:picMkLst>
        </pc:picChg>
        <pc:picChg chg="add mod">
          <ac:chgData name="Yuki Yoshimatsu" userId="ba50b75ca1f18b98" providerId="LiveId" clId="{0B9C44EB-507D-404B-B200-37955C3B5627}" dt="2025-01-19T11:24:29.883" v="255"/>
          <ac:picMkLst>
            <pc:docMk/>
            <pc:sldMk cId="1960080831" sldId="257"/>
            <ac:picMk id="803" creationId="{94A30EED-F807-FB33-F646-CF75522873C4}"/>
          </ac:picMkLst>
        </pc:picChg>
        <pc:picChg chg="add mod">
          <ac:chgData name="Yuki Yoshimatsu" userId="ba50b75ca1f18b98" providerId="LiveId" clId="{0B9C44EB-507D-404B-B200-37955C3B5627}" dt="2025-01-19T11:24:29.883" v="255"/>
          <ac:picMkLst>
            <pc:docMk/>
            <pc:sldMk cId="1960080831" sldId="257"/>
            <ac:picMk id="804" creationId="{F04C363B-E9F2-42DC-0112-C2612CC9E2EA}"/>
          </ac:picMkLst>
        </pc:picChg>
        <pc:picChg chg="add mod">
          <ac:chgData name="Yuki Yoshimatsu" userId="ba50b75ca1f18b98" providerId="LiveId" clId="{0B9C44EB-507D-404B-B200-37955C3B5627}" dt="2025-01-19T11:52:27.650" v="398" actId="554"/>
          <ac:picMkLst>
            <pc:docMk/>
            <pc:sldMk cId="1960080831" sldId="257"/>
            <ac:picMk id="806" creationId="{0C7F4ABB-63A8-7E70-AA5F-DC5E56CAD049}"/>
          </ac:picMkLst>
        </pc:picChg>
        <pc:picChg chg="add mod">
          <ac:chgData name="Yuki Yoshimatsu" userId="ba50b75ca1f18b98" providerId="LiveId" clId="{0B9C44EB-507D-404B-B200-37955C3B5627}" dt="2025-01-19T11:25:41.498" v="259"/>
          <ac:picMkLst>
            <pc:docMk/>
            <pc:sldMk cId="1960080831" sldId="257"/>
            <ac:picMk id="807" creationId="{AB6F7BAC-6DE5-BCBE-A3C0-4474E64A1377}"/>
          </ac:picMkLst>
        </pc:picChg>
        <pc:picChg chg="add mod">
          <ac:chgData name="Yuki Yoshimatsu" userId="ba50b75ca1f18b98" providerId="LiveId" clId="{0B9C44EB-507D-404B-B200-37955C3B5627}" dt="2025-01-19T11:25:41.498" v="259"/>
          <ac:picMkLst>
            <pc:docMk/>
            <pc:sldMk cId="1960080831" sldId="257"/>
            <ac:picMk id="808" creationId="{FCBE0B0B-7BFC-EE81-BE07-A334D694B1DB}"/>
          </ac:picMkLst>
        </pc:picChg>
        <pc:picChg chg="add mod">
          <ac:chgData name="Yuki Yoshimatsu" userId="ba50b75ca1f18b98" providerId="LiveId" clId="{0B9C44EB-507D-404B-B200-37955C3B5627}" dt="2025-01-19T11:52:40.023" v="400" actId="554"/>
          <ac:picMkLst>
            <pc:docMk/>
            <pc:sldMk cId="1960080831" sldId="257"/>
            <ac:picMk id="810" creationId="{4992C15B-517E-EF4B-9EA5-143E0ABBDC25}"/>
          </ac:picMkLst>
        </pc:picChg>
        <pc:picChg chg="add mod">
          <ac:chgData name="Yuki Yoshimatsu" userId="ba50b75ca1f18b98" providerId="LiveId" clId="{0B9C44EB-507D-404B-B200-37955C3B5627}" dt="2025-01-19T11:27:22.462" v="263"/>
          <ac:picMkLst>
            <pc:docMk/>
            <pc:sldMk cId="1960080831" sldId="257"/>
            <ac:picMk id="811" creationId="{2263AA61-5009-AAA4-5D98-B87D27CCDCCD}"/>
          </ac:picMkLst>
        </pc:picChg>
        <pc:picChg chg="add mod">
          <ac:chgData name="Yuki Yoshimatsu" userId="ba50b75ca1f18b98" providerId="LiveId" clId="{0B9C44EB-507D-404B-B200-37955C3B5627}" dt="2025-01-19T11:27:22.462" v="263"/>
          <ac:picMkLst>
            <pc:docMk/>
            <pc:sldMk cId="1960080831" sldId="257"/>
            <ac:picMk id="812" creationId="{72EDF5C7-7C88-2E96-789D-9DC2D157F94C}"/>
          </ac:picMkLst>
        </pc:picChg>
        <pc:picChg chg="add mod">
          <ac:chgData name="Yuki Yoshimatsu" userId="ba50b75ca1f18b98" providerId="LiveId" clId="{0B9C44EB-507D-404B-B200-37955C3B5627}" dt="2025-01-19T11:52:59.246" v="404" actId="554"/>
          <ac:picMkLst>
            <pc:docMk/>
            <pc:sldMk cId="1960080831" sldId="257"/>
            <ac:picMk id="814" creationId="{9D1DE705-A527-0700-384D-9AB07EDBF68B}"/>
          </ac:picMkLst>
        </pc:picChg>
        <pc:picChg chg="del">
          <ac:chgData name="Yuki Yoshimatsu" userId="ba50b75ca1f18b98" providerId="LiveId" clId="{0B9C44EB-507D-404B-B200-37955C3B5627}" dt="2025-01-19T11:29:01.831" v="281" actId="478"/>
          <ac:picMkLst>
            <pc:docMk/>
            <pc:sldMk cId="1960080831" sldId="257"/>
            <ac:picMk id="825" creationId="{00287B82-2D27-DA0D-444E-409EAA0C4866}"/>
          </ac:picMkLst>
        </pc:picChg>
        <pc:picChg chg="del">
          <ac:chgData name="Yuki Yoshimatsu" userId="ba50b75ca1f18b98" providerId="LiveId" clId="{0B9C44EB-507D-404B-B200-37955C3B5627}" dt="2025-01-19T11:28:50.596" v="279" actId="478"/>
          <ac:picMkLst>
            <pc:docMk/>
            <pc:sldMk cId="1960080831" sldId="257"/>
            <ac:picMk id="826" creationId="{25679D73-E744-9BF9-3ECA-C9E22AE3A604}"/>
          </ac:picMkLst>
        </pc:picChg>
        <pc:picChg chg="del">
          <ac:chgData name="Yuki Yoshimatsu" userId="ba50b75ca1f18b98" providerId="LiveId" clId="{0B9C44EB-507D-404B-B200-37955C3B5627}" dt="2025-01-19T11:28:50.596" v="279" actId="478"/>
          <ac:picMkLst>
            <pc:docMk/>
            <pc:sldMk cId="1960080831" sldId="257"/>
            <ac:picMk id="827" creationId="{98B08A18-9392-16C2-05B1-C0C65E4D0061}"/>
          </ac:picMkLst>
        </pc:picChg>
        <pc:picChg chg="del">
          <ac:chgData name="Yuki Yoshimatsu" userId="ba50b75ca1f18b98" providerId="LiveId" clId="{0B9C44EB-507D-404B-B200-37955C3B5627}" dt="2025-01-19T11:28:50.596" v="279" actId="478"/>
          <ac:picMkLst>
            <pc:docMk/>
            <pc:sldMk cId="1960080831" sldId="257"/>
            <ac:picMk id="828" creationId="{DF1F10F0-2BD5-9C82-335F-4B7126D217ED}"/>
          </ac:picMkLst>
        </pc:picChg>
        <pc:picChg chg="del">
          <ac:chgData name="Yuki Yoshimatsu" userId="ba50b75ca1f18b98" providerId="LiveId" clId="{0B9C44EB-507D-404B-B200-37955C3B5627}" dt="2025-01-19T11:28:50.596" v="279" actId="478"/>
          <ac:picMkLst>
            <pc:docMk/>
            <pc:sldMk cId="1960080831" sldId="257"/>
            <ac:picMk id="829" creationId="{7AFDCD19-71D7-AAA1-F242-A8F67E9CBFAF}"/>
          </ac:picMkLst>
        </pc:picChg>
        <pc:picChg chg="del">
          <ac:chgData name="Yuki Yoshimatsu" userId="ba50b75ca1f18b98" providerId="LiveId" clId="{0B9C44EB-507D-404B-B200-37955C3B5627}" dt="2025-01-19T11:28:50.596" v="279" actId="478"/>
          <ac:picMkLst>
            <pc:docMk/>
            <pc:sldMk cId="1960080831" sldId="257"/>
            <ac:picMk id="830" creationId="{C208DB26-789C-1647-0799-A176DF6955EF}"/>
          </ac:picMkLst>
        </pc:picChg>
        <pc:picChg chg="del">
          <ac:chgData name="Yuki Yoshimatsu" userId="ba50b75ca1f18b98" providerId="LiveId" clId="{0B9C44EB-507D-404B-B200-37955C3B5627}" dt="2025-01-19T11:28:50.596" v="279" actId="478"/>
          <ac:picMkLst>
            <pc:docMk/>
            <pc:sldMk cId="1960080831" sldId="257"/>
            <ac:picMk id="831" creationId="{F995EDFB-09E1-5B40-46F5-A1BC7A1622F6}"/>
          </ac:picMkLst>
        </pc:picChg>
        <pc:picChg chg="del">
          <ac:chgData name="Yuki Yoshimatsu" userId="ba50b75ca1f18b98" providerId="LiveId" clId="{0B9C44EB-507D-404B-B200-37955C3B5627}" dt="2025-01-19T11:29:01.831" v="281" actId="478"/>
          <ac:picMkLst>
            <pc:docMk/>
            <pc:sldMk cId="1960080831" sldId="257"/>
            <ac:picMk id="835" creationId="{37653DA0-AB3A-2805-203E-62CE595251B6}"/>
          </ac:picMkLst>
        </pc:picChg>
        <pc:picChg chg="del">
          <ac:chgData name="Yuki Yoshimatsu" userId="ba50b75ca1f18b98" providerId="LiveId" clId="{0B9C44EB-507D-404B-B200-37955C3B5627}" dt="2025-01-19T11:28:55.891" v="280" actId="478"/>
          <ac:picMkLst>
            <pc:docMk/>
            <pc:sldMk cId="1960080831" sldId="257"/>
            <ac:picMk id="836" creationId="{0EA9ADFB-CD0B-BAB8-1E32-1C30F1415103}"/>
          </ac:picMkLst>
        </pc:picChg>
        <pc:picChg chg="del">
          <ac:chgData name="Yuki Yoshimatsu" userId="ba50b75ca1f18b98" providerId="LiveId" clId="{0B9C44EB-507D-404B-B200-37955C3B5627}" dt="2025-01-19T11:28:55.891" v="280" actId="478"/>
          <ac:picMkLst>
            <pc:docMk/>
            <pc:sldMk cId="1960080831" sldId="257"/>
            <ac:picMk id="837" creationId="{D6677BB2-6BC1-5264-C051-1EBE03A862C4}"/>
          </ac:picMkLst>
        </pc:picChg>
        <pc:picChg chg="del">
          <ac:chgData name="Yuki Yoshimatsu" userId="ba50b75ca1f18b98" providerId="LiveId" clId="{0B9C44EB-507D-404B-B200-37955C3B5627}" dt="2025-01-19T11:28:55.891" v="280" actId="478"/>
          <ac:picMkLst>
            <pc:docMk/>
            <pc:sldMk cId="1960080831" sldId="257"/>
            <ac:picMk id="838" creationId="{B201DFB2-9A4A-E438-86AA-5E081494609E}"/>
          </ac:picMkLst>
        </pc:picChg>
        <pc:picChg chg="del">
          <ac:chgData name="Yuki Yoshimatsu" userId="ba50b75ca1f18b98" providerId="LiveId" clId="{0B9C44EB-507D-404B-B200-37955C3B5627}" dt="2025-01-19T11:28:55.891" v="280" actId="478"/>
          <ac:picMkLst>
            <pc:docMk/>
            <pc:sldMk cId="1960080831" sldId="257"/>
            <ac:picMk id="839" creationId="{C495AAE8-610F-800C-9281-5EF5D6E44328}"/>
          </ac:picMkLst>
        </pc:picChg>
        <pc:picChg chg="del">
          <ac:chgData name="Yuki Yoshimatsu" userId="ba50b75ca1f18b98" providerId="LiveId" clId="{0B9C44EB-507D-404B-B200-37955C3B5627}" dt="2025-01-19T11:28:55.891" v="280" actId="478"/>
          <ac:picMkLst>
            <pc:docMk/>
            <pc:sldMk cId="1960080831" sldId="257"/>
            <ac:picMk id="840" creationId="{65111E5F-369C-70E7-CFD2-1F6CEB1F76BD}"/>
          </ac:picMkLst>
        </pc:picChg>
        <pc:picChg chg="del">
          <ac:chgData name="Yuki Yoshimatsu" userId="ba50b75ca1f18b98" providerId="LiveId" clId="{0B9C44EB-507D-404B-B200-37955C3B5627}" dt="2025-01-19T11:28:55.891" v="280" actId="478"/>
          <ac:picMkLst>
            <pc:docMk/>
            <pc:sldMk cId="1960080831" sldId="257"/>
            <ac:picMk id="841" creationId="{6E98FFF7-4577-596D-7E18-3A98DDE1B19D}"/>
          </ac:picMkLst>
        </pc:picChg>
        <pc:picChg chg="del">
          <ac:chgData name="Yuki Yoshimatsu" userId="ba50b75ca1f18b98" providerId="LiveId" clId="{0B9C44EB-507D-404B-B200-37955C3B5627}" dt="2025-01-19T11:29:01.831" v="281" actId="478"/>
          <ac:picMkLst>
            <pc:docMk/>
            <pc:sldMk cId="1960080831" sldId="257"/>
            <ac:picMk id="842" creationId="{467CC764-5E0A-3384-C027-98A71690ECDC}"/>
          </ac:picMkLst>
        </pc:picChg>
        <pc:picChg chg="del">
          <ac:chgData name="Yuki Yoshimatsu" userId="ba50b75ca1f18b98" providerId="LiveId" clId="{0B9C44EB-507D-404B-B200-37955C3B5627}" dt="2025-01-19T11:29:01.831" v="281" actId="478"/>
          <ac:picMkLst>
            <pc:docMk/>
            <pc:sldMk cId="1960080831" sldId="257"/>
            <ac:picMk id="843" creationId="{FC2C13FF-AB39-A4AD-054D-4EB0A8D61D41}"/>
          </ac:picMkLst>
        </pc:picChg>
        <pc:picChg chg="del">
          <ac:chgData name="Yuki Yoshimatsu" userId="ba50b75ca1f18b98" providerId="LiveId" clId="{0B9C44EB-507D-404B-B200-37955C3B5627}" dt="2025-01-19T11:29:01.831" v="281" actId="478"/>
          <ac:picMkLst>
            <pc:docMk/>
            <pc:sldMk cId="1960080831" sldId="257"/>
            <ac:picMk id="844" creationId="{3789DABA-E116-EF4C-E38D-3FFE63EE2AEC}"/>
          </ac:picMkLst>
        </pc:picChg>
        <pc:picChg chg="add mod">
          <ac:chgData name="Yuki Yoshimatsu" userId="ba50b75ca1f18b98" providerId="LiveId" clId="{0B9C44EB-507D-404B-B200-37955C3B5627}" dt="2025-01-19T11:31:31.087" v="315"/>
          <ac:picMkLst>
            <pc:docMk/>
            <pc:sldMk cId="1960080831" sldId="257"/>
            <ac:picMk id="845" creationId="{EFC5C030-E3C8-5F23-FAC3-F2D213941D99}"/>
          </ac:picMkLst>
        </pc:picChg>
        <pc:picChg chg="add mod">
          <ac:chgData name="Yuki Yoshimatsu" userId="ba50b75ca1f18b98" providerId="LiveId" clId="{0B9C44EB-507D-404B-B200-37955C3B5627}" dt="2025-01-19T11:31:31.087" v="315"/>
          <ac:picMkLst>
            <pc:docMk/>
            <pc:sldMk cId="1960080831" sldId="257"/>
            <ac:picMk id="846" creationId="{B3944587-29B0-93AD-8C1C-079AC5AE5933}"/>
          </ac:picMkLst>
        </pc:picChg>
        <pc:picChg chg="add mod">
          <ac:chgData name="Yuki Yoshimatsu" userId="ba50b75ca1f18b98" providerId="LiveId" clId="{0B9C44EB-507D-404B-B200-37955C3B5627}" dt="2025-01-19T11:50:45.819" v="384" actId="554"/>
          <ac:picMkLst>
            <pc:docMk/>
            <pc:sldMk cId="1960080831" sldId="257"/>
            <ac:picMk id="848" creationId="{7D5A224A-56D5-7AF9-DB86-7BCEA7A6D643}"/>
          </ac:picMkLst>
        </pc:picChg>
        <pc:picChg chg="add mod">
          <ac:chgData name="Yuki Yoshimatsu" userId="ba50b75ca1f18b98" providerId="LiveId" clId="{0B9C44EB-507D-404B-B200-37955C3B5627}" dt="2025-01-19T11:32:22.845" v="319"/>
          <ac:picMkLst>
            <pc:docMk/>
            <pc:sldMk cId="1960080831" sldId="257"/>
            <ac:picMk id="849" creationId="{7394653A-6889-1468-91E6-092E5274E012}"/>
          </ac:picMkLst>
        </pc:picChg>
        <pc:picChg chg="add mod">
          <ac:chgData name="Yuki Yoshimatsu" userId="ba50b75ca1f18b98" providerId="LiveId" clId="{0B9C44EB-507D-404B-B200-37955C3B5627}" dt="2025-01-19T11:32:22.845" v="319"/>
          <ac:picMkLst>
            <pc:docMk/>
            <pc:sldMk cId="1960080831" sldId="257"/>
            <ac:picMk id="850" creationId="{58DECB05-9480-030D-E876-308D042B87FA}"/>
          </ac:picMkLst>
        </pc:picChg>
        <pc:picChg chg="add mod">
          <ac:chgData name="Yuki Yoshimatsu" userId="ba50b75ca1f18b98" providerId="LiveId" clId="{0B9C44EB-507D-404B-B200-37955C3B5627}" dt="2025-01-19T11:51:04.228" v="386" actId="554"/>
          <ac:picMkLst>
            <pc:docMk/>
            <pc:sldMk cId="1960080831" sldId="257"/>
            <ac:picMk id="852" creationId="{EEF7B6FF-A8A7-ACD0-7C85-3B4855D65D90}"/>
          </ac:picMkLst>
        </pc:picChg>
        <pc:picChg chg="add mod">
          <ac:chgData name="Yuki Yoshimatsu" userId="ba50b75ca1f18b98" providerId="LiveId" clId="{0B9C44EB-507D-404B-B200-37955C3B5627}" dt="2025-01-19T11:33:08.238" v="322"/>
          <ac:picMkLst>
            <pc:docMk/>
            <pc:sldMk cId="1960080831" sldId="257"/>
            <ac:picMk id="853" creationId="{44468346-5395-C568-DA0D-735170DD942A}"/>
          </ac:picMkLst>
        </pc:picChg>
        <pc:picChg chg="add mod">
          <ac:chgData name="Yuki Yoshimatsu" userId="ba50b75ca1f18b98" providerId="LiveId" clId="{0B9C44EB-507D-404B-B200-37955C3B5627}" dt="2025-01-19T11:33:08.238" v="322"/>
          <ac:picMkLst>
            <pc:docMk/>
            <pc:sldMk cId="1960080831" sldId="257"/>
            <ac:picMk id="854" creationId="{30832E78-78ED-39D2-2C12-E8877FB40D9D}"/>
          </ac:picMkLst>
        </pc:picChg>
        <pc:picChg chg="add mod">
          <ac:chgData name="Yuki Yoshimatsu" userId="ba50b75ca1f18b98" providerId="LiveId" clId="{0B9C44EB-507D-404B-B200-37955C3B5627}" dt="2025-01-19T11:51:18.321" v="388" actId="554"/>
          <ac:picMkLst>
            <pc:docMk/>
            <pc:sldMk cId="1960080831" sldId="257"/>
            <ac:picMk id="856" creationId="{DF1804A1-267F-FECA-04B5-F27AD69F65A4}"/>
          </ac:picMkLst>
        </pc:picChg>
        <pc:picChg chg="add mod">
          <ac:chgData name="Yuki Yoshimatsu" userId="ba50b75ca1f18b98" providerId="LiveId" clId="{0B9C44EB-507D-404B-B200-37955C3B5627}" dt="2025-01-19T11:33:45.257" v="325"/>
          <ac:picMkLst>
            <pc:docMk/>
            <pc:sldMk cId="1960080831" sldId="257"/>
            <ac:picMk id="857" creationId="{967F0649-D125-3EDE-DBA2-8550F1C883C1}"/>
          </ac:picMkLst>
        </pc:picChg>
        <pc:picChg chg="add mod">
          <ac:chgData name="Yuki Yoshimatsu" userId="ba50b75ca1f18b98" providerId="LiveId" clId="{0B9C44EB-507D-404B-B200-37955C3B5627}" dt="2025-01-19T11:33:45.257" v="325"/>
          <ac:picMkLst>
            <pc:docMk/>
            <pc:sldMk cId="1960080831" sldId="257"/>
            <ac:picMk id="858" creationId="{9FF8B715-7B91-A290-6DEF-1DEA9369615B}"/>
          </ac:picMkLst>
        </pc:picChg>
        <pc:picChg chg="add mod">
          <ac:chgData name="Yuki Yoshimatsu" userId="ba50b75ca1f18b98" providerId="LiveId" clId="{0B9C44EB-507D-404B-B200-37955C3B5627}" dt="2025-01-19T11:51:31.417" v="390" actId="554"/>
          <ac:picMkLst>
            <pc:docMk/>
            <pc:sldMk cId="1960080831" sldId="257"/>
            <ac:picMk id="860" creationId="{CD3EE991-5F40-B3C3-4FC1-B2E717781FCE}"/>
          </ac:picMkLst>
        </pc:picChg>
        <pc:picChg chg="add mod">
          <ac:chgData name="Yuki Yoshimatsu" userId="ba50b75ca1f18b98" providerId="LiveId" clId="{0B9C44EB-507D-404B-B200-37955C3B5627}" dt="2025-01-19T11:34:22.863" v="328"/>
          <ac:picMkLst>
            <pc:docMk/>
            <pc:sldMk cId="1960080831" sldId="257"/>
            <ac:picMk id="861" creationId="{E972635D-82ED-7C98-2338-FC98FCA7F006}"/>
          </ac:picMkLst>
        </pc:picChg>
        <pc:picChg chg="add mod">
          <ac:chgData name="Yuki Yoshimatsu" userId="ba50b75ca1f18b98" providerId="LiveId" clId="{0B9C44EB-507D-404B-B200-37955C3B5627}" dt="2025-01-19T11:34:22.863" v="328"/>
          <ac:picMkLst>
            <pc:docMk/>
            <pc:sldMk cId="1960080831" sldId="257"/>
            <ac:picMk id="862" creationId="{D780CC61-BABB-3195-F83F-676192324B97}"/>
          </ac:picMkLst>
        </pc:picChg>
        <pc:picChg chg="add mod">
          <ac:chgData name="Yuki Yoshimatsu" userId="ba50b75ca1f18b98" providerId="LiveId" clId="{0B9C44EB-507D-404B-B200-37955C3B5627}" dt="2025-01-19T11:51:49.111" v="392" actId="554"/>
          <ac:picMkLst>
            <pc:docMk/>
            <pc:sldMk cId="1960080831" sldId="257"/>
            <ac:picMk id="864" creationId="{B12A4681-D152-0F40-CFF8-56D1FB79BB51}"/>
          </ac:picMkLst>
        </pc:picChg>
        <pc:picChg chg="add mod">
          <ac:chgData name="Yuki Yoshimatsu" userId="ba50b75ca1f18b98" providerId="LiveId" clId="{0B9C44EB-507D-404B-B200-37955C3B5627}" dt="2025-01-19T11:34:56.579" v="331"/>
          <ac:picMkLst>
            <pc:docMk/>
            <pc:sldMk cId="1960080831" sldId="257"/>
            <ac:picMk id="865" creationId="{1D9453D1-B111-5F18-13B6-F533D3CF4697}"/>
          </ac:picMkLst>
        </pc:picChg>
        <pc:picChg chg="add mod">
          <ac:chgData name="Yuki Yoshimatsu" userId="ba50b75ca1f18b98" providerId="LiveId" clId="{0B9C44EB-507D-404B-B200-37955C3B5627}" dt="2025-01-19T11:34:56.579" v="331"/>
          <ac:picMkLst>
            <pc:docMk/>
            <pc:sldMk cId="1960080831" sldId="257"/>
            <ac:picMk id="866" creationId="{262C70D3-225F-2096-31C6-A05AA523B6A4}"/>
          </ac:picMkLst>
        </pc:picChg>
        <pc:picChg chg="add mod">
          <ac:chgData name="Yuki Yoshimatsu" userId="ba50b75ca1f18b98" providerId="LiveId" clId="{0B9C44EB-507D-404B-B200-37955C3B5627}" dt="2025-01-19T11:52:03.266" v="394" actId="554"/>
          <ac:picMkLst>
            <pc:docMk/>
            <pc:sldMk cId="1960080831" sldId="257"/>
            <ac:picMk id="868" creationId="{B514009B-DB4E-1CF2-8212-BF9D10867F0A}"/>
          </ac:picMkLst>
        </pc:picChg>
        <pc:picChg chg="add mod">
          <ac:chgData name="Yuki Yoshimatsu" userId="ba50b75ca1f18b98" providerId="LiveId" clId="{0B9C44EB-507D-404B-B200-37955C3B5627}" dt="2025-01-19T11:35:40.733" v="334"/>
          <ac:picMkLst>
            <pc:docMk/>
            <pc:sldMk cId="1960080831" sldId="257"/>
            <ac:picMk id="869" creationId="{A3460FBB-FE7B-B03C-827E-E2A9E5CB45D1}"/>
          </ac:picMkLst>
        </pc:picChg>
        <pc:picChg chg="add mod">
          <ac:chgData name="Yuki Yoshimatsu" userId="ba50b75ca1f18b98" providerId="LiveId" clId="{0B9C44EB-507D-404B-B200-37955C3B5627}" dt="2025-01-19T11:35:40.733" v="334"/>
          <ac:picMkLst>
            <pc:docMk/>
            <pc:sldMk cId="1960080831" sldId="257"/>
            <ac:picMk id="870" creationId="{56EBBBBC-37BC-D23C-244C-9CCB0BEEDB27}"/>
          </ac:picMkLst>
        </pc:picChg>
        <pc:picChg chg="add mod">
          <ac:chgData name="Yuki Yoshimatsu" userId="ba50b75ca1f18b98" providerId="LiveId" clId="{0B9C44EB-507D-404B-B200-37955C3B5627}" dt="2025-01-19T11:52:15.961" v="396" actId="554"/>
          <ac:picMkLst>
            <pc:docMk/>
            <pc:sldMk cId="1960080831" sldId="257"/>
            <ac:picMk id="872" creationId="{924E66E9-1198-155D-6B12-5021FABCD37B}"/>
          </ac:picMkLst>
        </pc:picChg>
        <pc:picChg chg="add mod">
          <ac:chgData name="Yuki Yoshimatsu" userId="ba50b75ca1f18b98" providerId="LiveId" clId="{0B9C44EB-507D-404B-B200-37955C3B5627}" dt="2025-01-19T11:36:17.516" v="337"/>
          <ac:picMkLst>
            <pc:docMk/>
            <pc:sldMk cId="1960080831" sldId="257"/>
            <ac:picMk id="873" creationId="{77179471-9416-B8AE-CB77-FDC1FCBA25C5}"/>
          </ac:picMkLst>
        </pc:picChg>
        <pc:picChg chg="add mod">
          <ac:chgData name="Yuki Yoshimatsu" userId="ba50b75ca1f18b98" providerId="LiveId" clId="{0B9C44EB-507D-404B-B200-37955C3B5627}" dt="2025-01-19T11:36:17.516" v="337"/>
          <ac:picMkLst>
            <pc:docMk/>
            <pc:sldMk cId="1960080831" sldId="257"/>
            <ac:picMk id="874" creationId="{957C2B00-0EC5-E34A-FBC5-4903A37A2101}"/>
          </ac:picMkLst>
        </pc:picChg>
        <pc:picChg chg="add mod">
          <ac:chgData name="Yuki Yoshimatsu" userId="ba50b75ca1f18b98" providerId="LiveId" clId="{0B9C44EB-507D-404B-B200-37955C3B5627}" dt="2025-01-19T11:52:27.650" v="398" actId="554"/>
          <ac:picMkLst>
            <pc:docMk/>
            <pc:sldMk cId="1960080831" sldId="257"/>
            <ac:picMk id="876" creationId="{9947BFB9-ACA5-FB4B-459D-3C8A357E506F}"/>
          </ac:picMkLst>
        </pc:picChg>
        <pc:picChg chg="add mod">
          <ac:chgData name="Yuki Yoshimatsu" userId="ba50b75ca1f18b98" providerId="LiveId" clId="{0B9C44EB-507D-404B-B200-37955C3B5627}" dt="2025-01-19T11:37:00.367" v="340"/>
          <ac:picMkLst>
            <pc:docMk/>
            <pc:sldMk cId="1960080831" sldId="257"/>
            <ac:picMk id="877" creationId="{992FEA19-7198-0808-478B-AE1A96F14BBF}"/>
          </ac:picMkLst>
        </pc:picChg>
        <pc:picChg chg="add mod">
          <ac:chgData name="Yuki Yoshimatsu" userId="ba50b75ca1f18b98" providerId="LiveId" clId="{0B9C44EB-507D-404B-B200-37955C3B5627}" dt="2025-01-19T11:37:00.367" v="340"/>
          <ac:picMkLst>
            <pc:docMk/>
            <pc:sldMk cId="1960080831" sldId="257"/>
            <ac:picMk id="878" creationId="{17958E9E-62C7-5D0B-CEBA-692A49626F5E}"/>
          </ac:picMkLst>
        </pc:picChg>
        <pc:picChg chg="add mod">
          <ac:chgData name="Yuki Yoshimatsu" userId="ba50b75ca1f18b98" providerId="LiveId" clId="{0B9C44EB-507D-404B-B200-37955C3B5627}" dt="2025-01-19T11:52:40.023" v="400" actId="554"/>
          <ac:picMkLst>
            <pc:docMk/>
            <pc:sldMk cId="1960080831" sldId="257"/>
            <ac:picMk id="880" creationId="{60B270FF-2EEF-539E-75AF-0C6E6946C7EB}"/>
          </ac:picMkLst>
        </pc:picChg>
        <pc:picChg chg="add mod">
          <ac:chgData name="Yuki Yoshimatsu" userId="ba50b75ca1f18b98" providerId="LiveId" clId="{0B9C44EB-507D-404B-B200-37955C3B5627}" dt="2025-01-19T11:37:47.686" v="343"/>
          <ac:picMkLst>
            <pc:docMk/>
            <pc:sldMk cId="1960080831" sldId="257"/>
            <ac:picMk id="881" creationId="{578FA221-DA33-9F25-17C1-94DEED827711}"/>
          </ac:picMkLst>
        </pc:picChg>
        <pc:picChg chg="add mod">
          <ac:chgData name="Yuki Yoshimatsu" userId="ba50b75ca1f18b98" providerId="LiveId" clId="{0B9C44EB-507D-404B-B200-37955C3B5627}" dt="2025-01-19T11:37:47.686" v="343"/>
          <ac:picMkLst>
            <pc:docMk/>
            <pc:sldMk cId="1960080831" sldId="257"/>
            <ac:picMk id="882" creationId="{47F2CB9A-A22C-EE59-162A-854CBFC87A2C}"/>
          </ac:picMkLst>
        </pc:picChg>
        <pc:picChg chg="add mod">
          <ac:chgData name="Yuki Yoshimatsu" userId="ba50b75ca1f18b98" providerId="LiveId" clId="{0B9C44EB-507D-404B-B200-37955C3B5627}" dt="2025-01-19T11:52:59.246" v="404" actId="554"/>
          <ac:picMkLst>
            <pc:docMk/>
            <pc:sldMk cId="1960080831" sldId="257"/>
            <ac:picMk id="884" creationId="{D38D4E69-F37A-FA20-4D69-D643A056CC8F}"/>
          </ac:picMkLst>
        </pc:picChg>
        <pc:picChg chg="add mod">
          <ac:chgData name="Yuki Yoshimatsu" userId="ba50b75ca1f18b98" providerId="LiveId" clId="{0B9C44EB-507D-404B-B200-37955C3B5627}" dt="2025-01-19T11:38:44.952" v="346"/>
          <ac:picMkLst>
            <pc:docMk/>
            <pc:sldMk cId="1960080831" sldId="257"/>
            <ac:picMk id="885" creationId="{1B986367-0BA2-A9D5-640D-0D3F4AD7FB5F}"/>
          </ac:picMkLst>
        </pc:picChg>
        <pc:picChg chg="add mod">
          <ac:chgData name="Yuki Yoshimatsu" userId="ba50b75ca1f18b98" providerId="LiveId" clId="{0B9C44EB-507D-404B-B200-37955C3B5627}" dt="2025-01-19T11:38:44.952" v="346"/>
          <ac:picMkLst>
            <pc:docMk/>
            <pc:sldMk cId="1960080831" sldId="257"/>
            <ac:picMk id="886" creationId="{6CED8F93-4A38-DE77-DE0F-C43E55867E1E}"/>
          </ac:picMkLst>
        </pc:picChg>
        <pc:picChg chg="add mod">
          <ac:chgData name="Yuki Yoshimatsu" userId="ba50b75ca1f18b98" providerId="LiveId" clId="{0B9C44EB-507D-404B-B200-37955C3B5627}" dt="2025-01-19T11:50:45.819" v="384" actId="554"/>
          <ac:picMkLst>
            <pc:docMk/>
            <pc:sldMk cId="1960080831" sldId="257"/>
            <ac:picMk id="888" creationId="{1853FF9F-8A7E-1FF9-5839-498A97C8664D}"/>
          </ac:picMkLst>
        </pc:picChg>
        <pc:picChg chg="add mod">
          <ac:chgData name="Yuki Yoshimatsu" userId="ba50b75ca1f18b98" providerId="LiveId" clId="{0B9C44EB-507D-404B-B200-37955C3B5627}" dt="2025-01-19T11:43:57.303" v="350"/>
          <ac:picMkLst>
            <pc:docMk/>
            <pc:sldMk cId="1960080831" sldId="257"/>
            <ac:picMk id="889" creationId="{353F9E9E-60CF-2990-0996-3A0D75CE0C97}"/>
          </ac:picMkLst>
        </pc:picChg>
        <pc:picChg chg="add mod">
          <ac:chgData name="Yuki Yoshimatsu" userId="ba50b75ca1f18b98" providerId="LiveId" clId="{0B9C44EB-507D-404B-B200-37955C3B5627}" dt="2025-01-19T11:43:57.303" v="350"/>
          <ac:picMkLst>
            <pc:docMk/>
            <pc:sldMk cId="1960080831" sldId="257"/>
            <ac:picMk id="890" creationId="{02C4116D-43F0-4A39-9684-77871F23E51D}"/>
          </ac:picMkLst>
        </pc:picChg>
        <pc:picChg chg="add mod">
          <ac:chgData name="Yuki Yoshimatsu" userId="ba50b75ca1f18b98" providerId="LiveId" clId="{0B9C44EB-507D-404B-B200-37955C3B5627}" dt="2025-01-19T11:51:04.228" v="386" actId="554"/>
          <ac:picMkLst>
            <pc:docMk/>
            <pc:sldMk cId="1960080831" sldId="257"/>
            <ac:picMk id="892" creationId="{95A6652F-CC29-8E9E-430E-9DFA66482482}"/>
          </ac:picMkLst>
        </pc:picChg>
        <pc:picChg chg="add mod">
          <ac:chgData name="Yuki Yoshimatsu" userId="ba50b75ca1f18b98" providerId="LiveId" clId="{0B9C44EB-507D-404B-B200-37955C3B5627}" dt="2025-01-19T11:44:50.113" v="353"/>
          <ac:picMkLst>
            <pc:docMk/>
            <pc:sldMk cId="1960080831" sldId="257"/>
            <ac:picMk id="893" creationId="{0969D4CA-D2A6-0D8C-A8D2-CEADCFCE013C}"/>
          </ac:picMkLst>
        </pc:picChg>
        <pc:picChg chg="add mod">
          <ac:chgData name="Yuki Yoshimatsu" userId="ba50b75ca1f18b98" providerId="LiveId" clId="{0B9C44EB-507D-404B-B200-37955C3B5627}" dt="2025-01-19T11:44:50.113" v="353"/>
          <ac:picMkLst>
            <pc:docMk/>
            <pc:sldMk cId="1960080831" sldId="257"/>
            <ac:picMk id="894" creationId="{98FEEA32-4F1F-901E-3753-7AB178BA00E4}"/>
          </ac:picMkLst>
        </pc:picChg>
        <pc:picChg chg="add mod">
          <ac:chgData name="Yuki Yoshimatsu" userId="ba50b75ca1f18b98" providerId="LiveId" clId="{0B9C44EB-507D-404B-B200-37955C3B5627}" dt="2025-01-19T11:51:18.321" v="388" actId="554"/>
          <ac:picMkLst>
            <pc:docMk/>
            <pc:sldMk cId="1960080831" sldId="257"/>
            <ac:picMk id="896" creationId="{EE8C7A86-238B-0164-2110-3238C8757E51}"/>
          </ac:picMkLst>
        </pc:picChg>
        <pc:picChg chg="add mod">
          <ac:chgData name="Yuki Yoshimatsu" userId="ba50b75ca1f18b98" providerId="LiveId" clId="{0B9C44EB-507D-404B-B200-37955C3B5627}" dt="2025-01-19T11:45:28.582" v="356"/>
          <ac:picMkLst>
            <pc:docMk/>
            <pc:sldMk cId="1960080831" sldId="257"/>
            <ac:picMk id="897" creationId="{9AE1744C-BACF-61EA-C539-B1D3C1534EFB}"/>
          </ac:picMkLst>
        </pc:picChg>
        <pc:picChg chg="add mod">
          <ac:chgData name="Yuki Yoshimatsu" userId="ba50b75ca1f18b98" providerId="LiveId" clId="{0B9C44EB-507D-404B-B200-37955C3B5627}" dt="2025-01-19T11:45:28.582" v="356"/>
          <ac:picMkLst>
            <pc:docMk/>
            <pc:sldMk cId="1960080831" sldId="257"/>
            <ac:picMk id="898" creationId="{781D8EE3-2836-2218-1AC3-2164319BAC74}"/>
          </ac:picMkLst>
        </pc:picChg>
        <pc:picChg chg="add mod">
          <ac:chgData name="Yuki Yoshimatsu" userId="ba50b75ca1f18b98" providerId="LiveId" clId="{0B9C44EB-507D-404B-B200-37955C3B5627}" dt="2025-01-19T11:51:31.417" v="390" actId="554"/>
          <ac:picMkLst>
            <pc:docMk/>
            <pc:sldMk cId="1960080831" sldId="257"/>
            <ac:picMk id="900" creationId="{0F913EB2-1476-471D-BFAC-B5B56402724F}"/>
          </ac:picMkLst>
        </pc:picChg>
        <pc:picChg chg="add mod">
          <ac:chgData name="Yuki Yoshimatsu" userId="ba50b75ca1f18b98" providerId="LiveId" clId="{0B9C44EB-507D-404B-B200-37955C3B5627}" dt="2025-01-19T11:46:20.828" v="360"/>
          <ac:picMkLst>
            <pc:docMk/>
            <pc:sldMk cId="1960080831" sldId="257"/>
            <ac:picMk id="901" creationId="{DCF23FC4-09BD-94C5-5460-2B5A3DB0B6A5}"/>
          </ac:picMkLst>
        </pc:picChg>
        <pc:picChg chg="add mod">
          <ac:chgData name="Yuki Yoshimatsu" userId="ba50b75ca1f18b98" providerId="LiveId" clId="{0B9C44EB-507D-404B-B200-37955C3B5627}" dt="2025-01-19T11:46:20.828" v="360"/>
          <ac:picMkLst>
            <pc:docMk/>
            <pc:sldMk cId="1960080831" sldId="257"/>
            <ac:picMk id="902" creationId="{28122890-DD0A-B424-E61F-A1CED62A6714}"/>
          </ac:picMkLst>
        </pc:picChg>
        <pc:picChg chg="add mod">
          <ac:chgData name="Yuki Yoshimatsu" userId="ba50b75ca1f18b98" providerId="LiveId" clId="{0B9C44EB-507D-404B-B200-37955C3B5627}" dt="2025-01-19T11:51:49.111" v="392" actId="554"/>
          <ac:picMkLst>
            <pc:docMk/>
            <pc:sldMk cId="1960080831" sldId="257"/>
            <ac:picMk id="904" creationId="{74FEE752-6945-A72E-29A2-AF34A34452FF}"/>
          </ac:picMkLst>
        </pc:picChg>
        <pc:picChg chg="add mod">
          <ac:chgData name="Yuki Yoshimatsu" userId="ba50b75ca1f18b98" providerId="LiveId" clId="{0B9C44EB-507D-404B-B200-37955C3B5627}" dt="2025-01-19T11:46:55.067" v="363"/>
          <ac:picMkLst>
            <pc:docMk/>
            <pc:sldMk cId="1960080831" sldId="257"/>
            <ac:picMk id="905" creationId="{FD162831-1953-1B06-A82D-02FFFA99FD66}"/>
          </ac:picMkLst>
        </pc:picChg>
        <pc:picChg chg="add mod">
          <ac:chgData name="Yuki Yoshimatsu" userId="ba50b75ca1f18b98" providerId="LiveId" clId="{0B9C44EB-507D-404B-B200-37955C3B5627}" dt="2025-01-19T11:46:55.067" v="363"/>
          <ac:picMkLst>
            <pc:docMk/>
            <pc:sldMk cId="1960080831" sldId="257"/>
            <ac:picMk id="906" creationId="{097ACA6A-5897-63AC-99EB-92FAA9AF1B01}"/>
          </ac:picMkLst>
        </pc:picChg>
        <pc:picChg chg="add mod">
          <ac:chgData name="Yuki Yoshimatsu" userId="ba50b75ca1f18b98" providerId="LiveId" clId="{0B9C44EB-507D-404B-B200-37955C3B5627}" dt="2025-01-19T11:52:03.266" v="394" actId="554"/>
          <ac:picMkLst>
            <pc:docMk/>
            <pc:sldMk cId="1960080831" sldId="257"/>
            <ac:picMk id="908" creationId="{874A703A-BF60-808B-1BA8-14852C815212}"/>
          </ac:picMkLst>
        </pc:picChg>
        <pc:picChg chg="add mod">
          <ac:chgData name="Yuki Yoshimatsu" userId="ba50b75ca1f18b98" providerId="LiveId" clId="{0B9C44EB-507D-404B-B200-37955C3B5627}" dt="2025-01-19T11:47:32.751" v="366"/>
          <ac:picMkLst>
            <pc:docMk/>
            <pc:sldMk cId="1960080831" sldId="257"/>
            <ac:picMk id="909" creationId="{2BA389CF-4A9E-BA80-7E45-1DA79608849C}"/>
          </ac:picMkLst>
        </pc:picChg>
        <pc:picChg chg="add mod">
          <ac:chgData name="Yuki Yoshimatsu" userId="ba50b75ca1f18b98" providerId="LiveId" clId="{0B9C44EB-507D-404B-B200-37955C3B5627}" dt="2025-01-19T11:47:32.751" v="366"/>
          <ac:picMkLst>
            <pc:docMk/>
            <pc:sldMk cId="1960080831" sldId="257"/>
            <ac:picMk id="910" creationId="{A73C9EEC-CC3D-B121-B626-F471FB847315}"/>
          </ac:picMkLst>
        </pc:picChg>
        <pc:picChg chg="add mod">
          <ac:chgData name="Yuki Yoshimatsu" userId="ba50b75ca1f18b98" providerId="LiveId" clId="{0B9C44EB-507D-404B-B200-37955C3B5627}" dt="2025-01-19T11:52:15.961" v="396" actId="554"/>
          <ac:picMkLst>
            <pc:docMk/>
            <pc:sldMk cId="1960080831" sldId="257"/>
            <ac:picMk id="912" creationId="{5BDECC5A-BF93-0572-1483-39EEBD950B33}"/>
          </ac:picMkLst>
        </pc:picChg>
        <pc:picChg chg="add mod">
          <ac:chgData name="Yuki Yoshimatsu" userId="ba50b75ca1f18b98" providerId="LiveId" clId="{0B9C44EB-507D-404B-B200-37955C3B5627}" dt="2025-01-19T11:48:14.545" v="369"/>
          <ac:picMkLst>
            <pc:docMk/>
            <pc:sldMk cId="1960080831" sldId="257"/>
            <ac:picMk id="913" creationId="{562F7EF0-331C-3E32-94D6-DA419B055A10}"/>
          </ac:picMkLst>
        </pc:picChg>
        <pc:picChg chg="add mod">
          <ac:chgData name="Yuki Yoshimatsu" userId="ba50b75ca1f18b98" providerId="LiveId" clId="{0B9C44EB-507D-404B-B200-37955C3B5627}" dt="2025-01-19T11:48:14.545" v="369"/>
          <ac:picMkLst>
            <pc:docMk/>
            <pc:sldMk cId="1960080831" sldId="257"/>
            <ac:picMk id="914" creationId="{29B394DC-D097-90FE-50C3-05A6CD12A16B}"/>
          </ac:picMkLst>
        </pc:picChg>
        <pc:picChg chg="add mod">
          <ac:chgData name="Yuki Yoshimatsu" userId="ba50b75ca1f18b98" providerId="LiveId" clId="{0B9C44EB-507D-404B-B200-37955C3B5627}" dt="2025-01-19T11:52:27.650" v="398" actId="554"/>
          <ac:picMkLst>
            <pc:docMk/>
            <pc:sldMk cId="1960080831" sldId="257"/>
            <ac:picMk id="916" creationId="{0F7CDFB2-2267-3F30-2D37-100916ED60CB}"/>
          </ac:picMkLst>
        </pc:picChg>
        <pc:picChg chg="add mod">
          <ac:chgData name="Yuki Yoshimatsu" userId="ba50b75ca1f18b98" providerId="LiveId" clId="{0B9C44EB-507D-404B-B200-37955C3B5627}" dt="2025-01-19T11:48:53.653" v="372"/>
          <ac:picMkLst>
            <pc:docMk/>
            <pc:sldMk cId="1960080831" sldId="257"/>
            <ac:picMk id="917" creationId="{4B5F711E-A75B-0C08-DCB7-3E10C9EA53F7}"/>
          </ac:picMkLst>
        </pc:picChg>
        <pc:picChg chg="add mod">
          <ac:chgData name="Yuki Yoshimatsu" userId="ba50b75ca1f18b98" providerId="LiveId" clId="{0B9C44EB-507D-404B-B200-37955C3B5627}" dt="2025-01-19T11:48:53.653" v="372"/>
          <ac:picMkLst>
            <pc:docMk/>
            <pc:sldMk cId="1960080831" sldId="257"/>
            <ac:picMk id="918" creationId="{A48C4F59-35F3-163D-9DA6-DC288710351E}"/>
          </ac:picMkLst>
        </pc:picChg>
        <pc:picChg chg="add mod">
          <ac:chgData name="Yuki Yoshimatsu" userId="ba50b75ca1f18b98" providerId="LiveId" clId="{0B9C44EB-507D-404B-B200-37955C3B5627}" dt="2025-01-19T11:52:40.023" v="400" actId="554"/>
          <ac:picMkLst>
            <pc:docMk/>
            <pc:sldMk cId="1960080831" sldId="257"/>
            <ac:picMk id="920" creationId="{C1406985-4479-F6C0-DD03-AAE845DA21AD}"/>
          </ac:picMkLst>
        </pc:picChg>
        <pc:picChg chg="add mod">
          <ac:chgData name="Yuki Yoshimatsu" userId="ba50b75ca1f18b98" providerId="LiveId" clId="{0B9C44EB-507D-404B-B200-37955C3B5627}" dt="2025-01-19T11:49:35.330" v="375"/>
          <ac:picMkLst>
            <pc:docMk/>
            <pc:sldMk cId="1960080831" sldId="257"/>
            <ac:picMk id="921" creationId="{B3DC5A2E-D040-E7DA-7C90-E3031B73B91C}"/>
          </ac:picMkLst>
        </pc:picChg>
        <pc:picChg chg="add mod">
          <ac:chgData name="Yuki Yoshimatsu" userId="ba50b75ca1f18b98" providerId="LiveId" clId="{0B9C44EB-507D-404B-B200-37955C3B5627}" dt="2025-01-19T11:49:35.330" v="375"/>
          <ac:picMkLst>
            <pc:docMk/>
            <pc:sldMk cId="1960080831" sldId="257"/>
            <ac:picMk id="922" creationId="{4D375F41-08E6-1A24-268E-224057BEFD44}"/>
          </ac:picMkLst>
        </pc:picChg>
        <pc:picChg chg="add mod">
          <ac:chgData name="Yuki Yoshimatsu" userId="ba50b75ca1f18b98" providerId="LiveId" clId="{0B9C44EB-507D-404B-B200-37955C3B5627}" dt="2025-01-19T11:52:59.246" v="404" actId="554"/>
          <ac:picMkLst>
            <pc:docMk/>
            <pc:sldMk cId="1960080831" sldId="257"/>
            <ac:picMk id="924" creationId="{415945C2-0479-FF9A-80BD-19F45E9B0051}"/>
          </ac:picMkLst>
        </pc:picChg>
        <pc:picChg chg="add mod">
          <ac:chgData name="Yuki Yoshimatsu" userId="ba50b75ca1f18b98" providerId="LiveId" clId="{0B9C44EB-507D-404B-B200-37955C3B5627}" dt="2025-01-19T11:52:53.438" v="403" actId="571"/>
          <ac:picMkLst>
            <pc:docMk/>
            <pc:sldMk cId="1960080831" sldId="257"/>
            <ac:picMk id="925" creationId="{3ED7242D-0E38-4A0C-6BA9-26FF675D77E7}"/>
          </ac:picMkLst>
        </pc:picChg>
        <pc:picChg chg="add mod">
          <ac:chgData name="Yuki Yoshimatsu" userId="ba50b75ca1f18b98" providerId="LiveId" clId="{0B9C44EB-507D-404B-B200-37955C3B5627}" dt="2025-01-19T11:52:53.438" v="403" actId="571"/>
          <ac:picMkLst>
            <pc:docMk/>
            <pc:sldMk cId="1960080831" sldId="257"/>
            <ac:picMk id="926" creationId="{504E8973-C8FD-386A-59A6-EBA04EC69396}"/>
          </ac:picMkLst>
        </pc:picChg>
      </pc:sldChg>
      <pc:sldChg chg="add del">
        <pc:chgData name="Yuki Yoshimatsu" userId="ba50b75ca1f18b98" providerId="LiveId" clId="{0B9C44EB-507D-404B-B200-37955C3B5627}" dt="2025-01-19T11:12:18.799" v="162" actId="47"/>
        <pc:sldMkLst>
          <pc:docMk/>
          <pc:sldMk cId="2818595337" sldId="258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339CE6-025C-4E02-B3A3-3688E659F701}" type="datetimeFigureOut">
              <a:rPr kumimoji="1" lang="ja-JP" altLang="en-US" smtClean="0"/>
              <a:t>2025/8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577975" y="1143000"/>
            <a:ext cx="37020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AE09ECD-8FBE-403C-B26B-7BC4E8F617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07628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AE09ECD-8FBE-403C-B26B-7BC4E8F617F2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12205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3240048" y="11183257"/>
            <a:ext cx="36720543" cy="7716611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6480096" y="20399852"/>
            <a:ext cx="30240447" cy="9199934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6394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32789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49184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65579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819745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98369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14764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31159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ー サブタイトルの書式設定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DFD4A-8214-41F6-8297-F0750557CD9C}" type="datetimeFigureOut">
              <a:rPr lang="en-US" smtClean="0"/>
              <a:t>8/12/2025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F5653-0861-4A45-9A2D-8145EE6646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696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DFD4A-8214-41F6-8297-F0750557CD9C}" type="datetimeFigureOut">
              <a:rPr lang="en-US" smtClean="0"/>
              <a:t>8/12/2025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F5653-0861-4A45-9A2D-8145EE6646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0944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123324326" y="7566612"/>
            <a:ext cx="38273064" cy="16126549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505128" y="7566612"/>
            <a:ext cx="114099187" cy="16126549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DFD4A-8214-41F6-8297-F0750557CD9C}" type="datetimeFigureOut">
              <a:rPr lang="en-US" smtClean="0"/>
              <a:t>8/12/2025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F5653-0861-4A45-9A2D-8145EE6646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38803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DFD4A-8214-41F6-8297-F0750557CD9C}" type="datetimeFigureOut">
              <a:rPr lang="en-US" smtClean="0"/>
              <a:t>8/12/2025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F5653-0861-4A45-9A2D-8145EE6646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56555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12554" y="23133170"/>
            <a:ext cx="36720543" cy="7149948"/>
          </a:xfrm>
        </p:spPr>
        <p:txBody>
          <a:bodyPr anchor="t"/>
          <a:lstStyle>
            <a:lvl1pPr algn="l">
              <a:defRPr sz="14300" b="1" cap="all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12554" y="15258230"/>
            <a:ext cx="36720543" cy="7874941"/>
          </a:xfrm>
        </p:spPr>
        <p:txBody>
          <a:bodyPr anchor="b"/>
          <a:lstStyle>
            <a:lvl1pPr marL="0" indent="0">
              <a:buNone/>
              <a:defRPr sz="7200">
                <a:solidFill>
                  <a:schemeClr val="tx1">
                    <a:tint val="75000"/>
                  </a:schemeClr>
                </a:solidFill>
              </a:defRPr>
            </a:lvl1pPr>
            <a:lvl2pPr marL="1639491" indent="0">
              <a:buNone/>
              <a:defRPr sz="6500">
                <a:solidFill>
                  <a:schemeClr val="tx1">
                    <a:tint val="75000"/>
                  </a:schemeClr>
                </a:solidFill>
              </a:defRPr>
            </a:lvl2pPr>
            <a:lvl3pPr marL="3278981" indent="0">
              <a:buNone/>
              <a:defRPr sz="5700">
                <a:solidFill>
                  <a:schemeClr val="tx1">
                    <a:tint val="75000"/>
                  </a:schemeClr>
                </a:solidFill>
              </a:defRPr>
            </a:lvl3pPr>
            <a:lvl4pPr marL="4918472" indent="0">
              <a:buNone/>
              <a:defRPr sz="5100">
                <a:solidFill>
                  <a:schemeClr val="tx1">
                    <a:tint val="75000"/>
                  </a:schemeClr>
                </a:solidFill>
              </a:defRPr>
            </a:lvl4pPr>
            <a:lvl5pPr marL="6557963" indent="0">
              <a:buNone/>
              <a:defRPr sz="5100">
                <a:solidFill>
                  <a:schemeClr val="tx1">
                    <a:tint val="75000"/>
                  </a:schemeClr>
                </a:solidFill>
              </a:defRPr>
            </a:lvl5pPr>
            <a:lvl6pPr marL="8197453" indent="0">
              <a:buNone/>
              <a:defRPr sz="5100">
                <a:solidFill>
                  <a:schemeClr val="tx1">
                    <a:tint val="75000"/>
                  </a:schemeClr>
                </a:solidFill>
              </a:defRPr>
            </a:lvl6pPr>
            <a:lvl7pPr marL="9836944" indent="0">
              <a:buNone/>
              <a:defRPr sz="5100">
                <a:solidFill>
                  <a:schemeClr val="tx1">
                    <a:tint val="75000"/>
                  </a:schemeClr>
                </a:solidFill>
              </a:defRPr>
            </a:lvl7pPr>
            <a:lvl8pPr marL="11476434" indent="0">
              <a:buNone/>
              <a:defRPr sz="5100">
                <a:solidFill>
                  <a:schemeClr val="tx1">
                    <a:tint val="75000"/>
                  </a:schemeClr>
                </a:solidFill>
              </a:defRPr>
            </a:lvl8pPr>
            <a:lvl9pPr marL="13115925" indent="0">
              <a:buNone/>
              <a:defRPr sz="5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DFD4A-8214-41F6-8297-F0750557CD9C}" type="datetimeFigureOut">
              <a:rPr lang="en-US" smtClean="0"/>
              <a:t>8/12/2025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F5653-0861-4A45-9A2D-8145EE6646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0714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505129" y="44099680"/>
            <a:ext cx="76186124" cy="124732426"/>
          </a:xfrm>
        </p:spPr>
        <p:txBody>
          <a:bodyPr/>
          <a:lstStyle>
            <a:lvl1pPr>
              <a:defRPr sz="10000"/>
            </a:lvl1pPr>
            <a:lvl2pPr>
              <a:defRPr sz="8600"/>
            </a:lvl2pPr>
            <a:lvl3pPr>
              <a:defRPr sz="7200"/>
            </a:lvl3pPr>
            <a:lvl4pPr>
              <a:defRPr sz="6500"/>
            </a:lvl4pPr>
            <a:lvl5pPr>
              <a:defRPr sz="6500"/>
            </a:lvl5pPr>
            <a:lvl6pPr>
              <a:defRPr sz="6500"/>
            </a:lvl6pPr>
            <a:lvl7pPr>
              <a:defRPr sz="6500"/>
            </a:lvl7pPr>
            <a:lvl8pPr>
              <a:defRPr sz="6500"/>
            </a:lvl8pPr>
            <a:lvl9pPr>
              <a:defRPr sz="6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5411264" y="44099680"/>
            <a:ext cx="76186124" cy="124732426"/>
          </a:xfrm>
        </p:spPr>
        <p:txBody>
          <a:bodyPr/>
          <a:lstStyle>
            <a:lvl1pPr>
              <a:defRPr sz="10000"/>
            </a:lvl1pPr>
            <a:lvl2pPr>
              <a:defRPr sz="8600"/>
            </a:lvl2pPr>
            <a:lvl3pPr>
              <a:defRPr sz="7200"/>
            </a:lvl3pPr>
            <a:lvl4pPr>
              <a:defRPr sz="6500"/>
            </a:lvl4pPr>
            <a:lvl5pPr>
              <a:defRPr sz="6500"/>
            </a:lvl5pPr>
            <a:lvl6pPr>
              <a:defRPr sz="6500"/>
            </a:lvl6pPr>
            <a:lvl7pPr>
              <a:defRPr sz="6500"/>
            </a:lvl7pPr>
            <a:lvl8pPr>
              <a:defRPr sz="6500"/>
            </a:lvl8pPr>
            <a:lvl9pPr>
              <a:defRPr sz="6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DFD4A-8214-41F6-8297-F0750557CD9C}" type="datetimeFigureOut">
              <a:rPr lang="en-US" smtClean="0"/>
              <a:t>8/12/2025</a:t>
            </a:fld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F5653-0861-4A45-9A2D-8145EE6646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5465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160036" y="1441659"/>
            <a:ext cx="38880575" cy="5999958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2160033" y="8058279"/>
            <a:ext cx="19087784" cy="3358307"/>
          </a:xfrm>
        </p:spPr>
        <p:txBody>
          <a:bodyPr anchor="b"/>
          <a:lstStyle>
            <a:lvl1pPr marL="0" indent="0">
              <a:buNone/>
              <a:defRPr sz="8600" b="1"/>
            </a:lvl1pPr>
            <a:lvl2pPr marL="1639491" indent="0">
              <a:buNone/>
              <a:defRPr sz="7200" b="1"/>
            </a:lvl2pPr>
            <a:lvl3pPr marL="3278981" indent="0">
              <a:buNone/>
              <a:defRPr sz="6500" b="1"/>
            </a:lvl3pPr>
            <a:lvl4pPr marL="4918472" indent="0">
              <a:buNone/>
              <a:defRPr sz="5700" b="1"/>
            </a:lvl4pPr>
            <a:lvl5pPr marL="6557963" indent="0">
              <a:buNone/>
              <a:defRPr sz="5700" b="1"/>
            </a:lvl5pPr>
            <a:lvl6pPr marL="8197453" indent="0">
              <a:buNone/>
              <a:defRPr sz="5700" b="1"/>
            </a:lvl6pPr>
            <a:lvl7pPr marL="9836944" indent="0">
              <a:buNone/>
              <a:defRPr sz="5700" b="1"/>
            </a:lvl7pPr>
            <a:lvl8pPr marL="11476434" indent="0">
              <a:buNone/>
              <a:defRPr sz="5700" b="1"/>
            </a:lvl8pPr>
            <a:lvl9pPr marL="13115925" indent="0">
              <a:buNone/>
              <a:defRPr sz="57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160033" y="11416584"/>
            <a:ext cx="19087784" cy="20741519"/>
          </a:xfrm>
        </p:spPr>
        <p:txBody>
          <a:bodyPr/>
          <a:lstStyle>
            <a:lvl1pPr>
              <a:defRPr sz="8600"/>
            </a:lvl1pPr>
            <a:lvl2pPr>
              <a:defRPr sz="7200"/>
            </a:lvl2pPr>
            <a:lvl3pPr>
              <a:defRPr sz="6500"/>
            </a:lvl3pPr>
            <a:lvl4pPr>
              <a:defRPr sz="5700"/>
            </a:lvl4pPr>
            <a:lvl5pPr>
              <a:defRPr sz="5700"/>
            </a:lvl5pPr>
            <a:lvl6pPr>
              <a:defRPr sz="5700"/>
            </a:lvl6pPr>
            <a:lvl7pPr>
              <a:defRPr sz="5700"/>
            </a:lvl7pPr>
            <a:lvl8pPr>
              <a:defRPr sz="5700"/>
            </a:lvl8pPr>
            <a:lvl9pPr>
              <a:defRPr sz="57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21945327" y="8058279"/>
            <a:ext cx="19095282" cy="3358307"/>
          </a:xfrm>
        </p:spPr>
        <p:txBody>
          <a:bodyPr anchor="b"/>
          <a:lstStyle>
            <a:lvl1pPr marL="0" indent="0">
              <a:buNone/>
              <a:defRPr sz="8600" b="1"/>
            </a:lvl1pPr>
            <a:lvl2pPr marL="1639491" indent="0">
              <a:buNone/>
              <a:defRPr sz="7200" b="1"/>
            </a:lvl2pPr>
            <a:lvl3pPr marL="3278981" indent="0">
              <a:buNone/>
              <a:defRPr sz="6500" b="1"/>
            </a:lvl3pPr>
            <a:lvl4pPr marL="4918472" indent="0">
              <a:buNone/>
              <a:defRPr sz="5700" b="1"/>
            </a:lvl4pPr>
            <a:lvl5pPr marL="6557963" indent="0">
              <a:buNone/>
              <a:defRPr sz="5700" b="1"/>
            </a:lvl5pPr>
            <a:lvl6pPr marL="8197453" indent="0">
              <a:buNone/>
              <a:defRPr sz="5700" b="1"/>
            </a:lvl6pPr>
            <a:lvl7pPr marL="9836944" indent="0">
              <a:buNone/>
              <a:defRPr sz="5700" b="1"/>
            </a:lvl7pPr>
            <a:lvl8pPr marL="11476434" indent="0">
              <a:buNone/>
              <a:defRPr sz="5700" b="1"/>
            </a:lvl8pPr>
            <a:lvl9pPr marL="13115925" indent="0">
              <a:buNone/>
              <a:defRPr sz="57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21945327" y="11416584"/>
            <a:ext cx="19095282" cy="20741519"/>
          </a:xfrm>
        </p:spPr>
        <p:txBody>
          <a:bodyPr/>
          <a:lstStyle>
            <a:lvl1pPr>
              <a:defRPr sz="8600"/>
            </a:lvl1pPr>
            <a:lvl2pPr>
              <a:defRPr sz="7200"/>
            </a:lvl2pPr>
            <a:lvl3pPr>
              <a:defRPr sz="6500"/>
            </a:lvl3pPr>
            <a:lvl4pPr>
              <a:defRPr sz="5700"/>
            </a:lvl4pPr>
            <a:lvl5pPr>
              <a:defRPr sz="5700"/>
            </a:lvl5pPr>
            <a:lvl6pPr>
              <a:defRPr sz="5700"/>
            </a:lvl6pPr>
            <a:lvl7pPr>
              <a:defRPr sz="5700"/>
            </a:lvl7pPr>
            <a:lvl8pPr>
              <a:defRPr sz="5700"/>
            </a:lvl8pPr>
            <a:lvl9pPr>
              <a:defRPr sz="57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DFD4A-8214-41F6-8297-F0750557CD9C}" type="datetimeFigureOut">
              <a:rPr lang="en-US" smtClean="0"/>
              <a:t>8/12/2025</a:t>
            </a:fld>
            <a:endParaRPr 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F5653-0861-4A45-9A2D-8145EE6646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69655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DFD4A-8214-41F6-8297-F0750557CD9C}" type="datetimeFigureOut">
              <a:rPr lang="en-US" smtClean="0"/>
              <a:t>8/12/2025</a:t>
            </a:fld>
            <a:endParaRPr 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F5653-0861-4A45-9A2D-8145EE6646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61097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DFD4A-8214-41F6-8297-F0750557CD9C}" type="datetimeFigureOut">
              <a:rPr lang="en-US" smtClean="0"/>
              <a:t>8/12/2025</a:t>
            </a:fld>
            <a:endParaRPr 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F5653-0861-4A45-9A2D-8145EE6646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10888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160040" y="1433323"/>
            <a:ext cx="14212711" cy="6099956"/>
          </a:xfrm>
        </p:spPr>
        <p:txBody>
          <a:bodyPr anchor="b"/>
          <a:lstStyle>
            <a:lvl1pPr algn="l">
              <a:defRPr sz="7200" b="1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16890249" y="1433327"/>
            <a:ext cx="24150356" cy="30724779"/>
          </a:xfrm>
        </p:spPr>
        <p:txBody>
          <a:bodyPr/>
          <a:lstStyle>
            <a:lvl1pPr>
              <a:defRPr sz="11400"/>
            </a:lvl1pPr>
            <a:lvl2pPr>
              <a:defRPr sz="10000"/>
            </a:lvl2pPr>
            <a:lvl3pPr>
              <a:defRPr sz="8600"/>
            </a:lvl3pPr>
            <a:lvl4pPr>
              <a:defRPr sz="7200"/>
            </a:lvl4pPr>
            <a:lvl5pPr>
              <a:defRPr sz="7200"/>
            </a:lvl5pPr>
            <a:lvl6pPr>
              <a:defRPr sz="7200"/>
            </a:lvl6pPr>
            <a:lvl7pPr>
              <a:defRPr sz="7200"/>
            </a:lvl7pPr>
            <a:lvl8pPr>
              <a:defRPr sz="7200"/>
            </a:lvl8pPr>
            <a:lvl9pPr>
              <a:defRPr sz="72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2160040" y="7533283"/>
            <a:ext cx="14212711" cy="24624824"/>
          </a:xfrm>
        </p:spPr>
        <p:txBody>
          <a:bodyPr/>
          <a:lstStyle>
            <a:lvl1pPr marL="0" indent="0">
              <a:buNone/>
              <a:defRPr sz="5100"/>
            </a:lvl1pPr>
            <a:lvl2pPr marL="1639491" indent="0">
              <a:buNone/>
              <a:defRPr sz="4300"/>
            </a:lvl2pPr>
            <a:lvl3pPr marL="3278981" indent="0">
              <a:buNone/>
              <a:defRPr sz="3600"/>
            </a:lvl3pPr>
            <a:lvl4pPr marL="4918472" indent="0">
              <a:buNone/>
              <a:defRPr sz="3300"/>
            </a:lvl4pPr>
            <a:lvl5pPr marL="6557963" indent="0">
              <a:buNone/>
              <a:defRPr sz="3300"/>
            </a:lvl5pPr>
            <a:lvl6pPr marL="8197453" indent="0">
              <a:buNone/>
              <a:defRPr sz="3300"/>
            </a:lvl6pPr>
            <a:lvl7pPr marL="9836944" indent="0">
              <a:buNone/>
              <a:defRPr sz="3300"/>
            </a:lvl7pPr>
            <a:lvl8pPr marL="11476434" indent="0">
              <a:buNone/>
              <a:defRPr sz="3300"/>
            </a:lvl8pPr>
            <a:lvl9pPr marL="13115925" indent="0">
              <a:buNone/>
              <a:defRPr sz="33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DFD4A-8214-41F6-8297-F0750557CD9C}" type="datetimeFigureOut">
              <a:rPr lang="en-US" smtClean="0"/>
              <a:t>8/12/2025</a:t>
            </a:fld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F5653-0861-4A45-9A2D-8145EE6646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2403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467631" y="25199817"/>
            <a:ext cx="25920383" cy="2974982"/>
          </a:xfrm>
        </p:spPr>
        <p:txBody>
          <a:bodyPr anchor="b"/>
          <a:lstStyle>
            <a:lvl1pPr algn="l">
              <a:defRPr sz="7200" b="1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8467631" y="3216645"/>
            <a:ext cx="25920383" cy="21599843"/>
          </a:xfrm>
        </p:spPr>
        <p:txBody>
          <a:bodyPr/>
          <a:lstStyle>
            <a:lvl1pPr marL="0" indent="0">
              <a:buNone/>
              <a:defRPr sz="11400"/>
            </a:lvl1pPr>
            <a:lvl2pPr marL="1639491" indent="0">
              <a:buNone/>
              <a:defRPr sz="10000"/>
            </a:lvl2pPr>
            <a:lvl3pPr marL="3278981" indent="0">
              <a:buNone/>
              <a:defRPr sz="8600"/>
            </a:lvl3pPr>
            <a:lvl4pPr marL="4918472" indent="0">
              <a:buNone/>
              <a:defRPr sz="7200"/>
            </a:lvl4pPr>
            <a:lvl5pPr marL="6557963" indent="0">
              <a:buNone/>
              <a:defRPr sz="7200"/>
            </a:lvl5pPr>
            <a:lvl6pPr marL="8197453" indent="0">
              <a:buNone/>
              <a:defRPr sz="7200"/>
            </a:lvl6pPr>
            <a:lvl7pPr marL="9836944" indent="0">
              <a:buNone/>
              <a:defRPr sz="7200"/>
            </a:lvl7pPr>
            <a:lvl8pPr marL="11476434" indent="0">
              <a:buNone/>
              <a:defRPr sz="7200"/>
            </a:lvl8pPr>
            <a:lvl9pPr marL="13115925" indent="0">
              <a:buNone/>
              <a:defRPr sz="7200"/>
            </a:lvl9pPr>
          </a:lstStyle>
          <a:p>
            <a:endParaRPr 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467631" y="28174798"/>
            <a:ext cx="25920383" cy="4224967"/>
          </a:xfrm>
        </p:spPr>
        <p:txBody>
          <a:bodyPr/>
          <a:lstStyle>
            <a:lvl1pPr marL="0" indent="0">
              <a:buNone/>
              <a:defRPr sz="5100"/>
            </a:lvl1pPr>
            <a:lvl2pPr marL="1639491" indent="0">
              <a:buNone/>
              <a:defRPr sz="4300"/>
            </a:lvl2pPr>
            <a:lvl3pPr marL="3278981" indent="0">
              <a:buNone/>
              <a:defRPr sz="3600"/>
            </a:lvl3pPr>
            <a:lvl4pPr marL="4918472" indent="0">
              <a:buNone/>
              <a:defRPr sz="3300"/>
            </a:lvl4pPr>
            <a:lvl5pPr marL="6557963" indent="0">
              <a:buNone/>
              <a:defRPr sz="3300"/>
            </a:lvl5pPr>
            <a:lvl6pPr marL="8197453" indent="0">
              <a:buNone/>
              <a:defRPr sz="3300"/>
            </a:lvl6pPr>
            <a:lvl7pPr marL="9836944" indent="0">
              <a:buNone/>
              <a:defRPr sz="3300"/>
            </a:lvl7pPr>
            <a:lvl8pPr marL="11476434" indent="0">
              <a:buNone/>
              <a:defRPr sz="3300"/>
            </a:lvl8pPr>
            <a:lvl9pPr marL="13115925" indent="0">
              <a:buNone/>
              <a:defRPr sz="33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DFD4A-8214-41F6-8297-F0750557CD9C}" type="datetimeFigureOut">
              <a:rPr lang="en-US" smtClean="0"/>
              <a:t>8/12/2025</a:t>
            </a:fld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F5653-0861-4A45-9A2D-8145EE6646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15582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2160036" y="1441659"/>
            <a:ext cx="38880575" cy="5999958"/>
          </a:xfrm>
          <a:prstGeom prst="rect">
            <a:avLst/>
          </a:prstGeom>
        </p:spPr>
        <p:txBody>
          <a:bodyPr vert="horz" lIns="327898" tIns="163949" rIns="327898" bIns="163949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2160036" y="8399943"/>
            <a:ext cx="38880575" cy="23758163"/>
          </a:xfrm>
          <a:prstGeom prst="rect">
            <a:avLst/>
          </a:prstGeom>
        </p:spPr>
        <p:txBody>
          <a:bodyPr vert="horz" lIns="327898" tIns="163949" rIns="327898" bIns="163949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2160038" y="33366429"/>
            <a:ext cx="10080150" cy="1916652"/>
          </a:xfrm>
          <a:prstGeom prst="rect">
            <a:avLst/>
          </a:prstGeom>
        </p:spPr>
        <p:txBody>
          <a:bodyPr vert="horz" lIns="327898" tIns="163949" rIns="327898" bIns="163949" rtlCol="0" anchor="ctr"/>
          <a:lstStyle>
            <a:lvl1pPr algn="l">
              <a:defRPr sz="4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ADFD4A-8214-41F6-8297-F0750557CD9C}" type="datetimeFigureOut">
              <a:rPr lang="en-US" smtClean="0"/>
              <a:t>8/12/2025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14760218" y="33366429"/>
            <a:ext cx="13680203" cy="1916652"/>
          </a:xfrm>
          <a:prstGeom prst="rect">
            <a:avLst/>
          </a:prstGeom>
        </p:spPr>
        <p:txBody>
          <a:bodyPr vert="horz" lIns="327898" tIns="163949" rIns="327898" bIns="163949" rtlCol="0" anchor="ctr"/>
          <a:lstStyle>
            <a:lvl1pPr algn="ctr">
              <a:defRPr sz="4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30960463" y="33366429"/>
            <a:ext cx="10080150" cy="1916652"/>
          </a:xfrm>
          <a:prstGeom prst="rect">
            <a:avLst/>
          </a:prstGeom>
        </p:spPr>
        <p:txBody>
          <a:bodyPr vert="horz" lIns="327898" tIns="163949" rIns="327898" bIns="163949" rtlCol="0" anchor="ctr"/>
          <a:lstStyle>
            <a:lvl1pPr algn="r">
              <a:defRPr sz="4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1F5653-0861-4A45-9A2D-8145EE6646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17664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278981" rtl="0" eaLnBrk="1" latinLnBrk="0" hangingPunct="1">
        <a:spcBef>
          <a:spcPct val="0"/>
        </a:spcBef>
        <a:buNone/>
        <a:defRPr sz="15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29618" indent="-1229618" algn="l" defTabSz="3278981" rtl="0" eaLnBrk="1" latinLnBrk="0" hangingPunct="1">
        <a:spcBef>
          <a:spcPct val="20000"/>
        </a:spcBef>
        <a:buFont typeface="Arial" panose="020B0604020202020204" pitchFamily="34" charset="0"/>
        <a:buChar char="•"/>
        <a:defRPr sz="11400" kern="1200">
          <a:solidFill>
            <a:schemeClr val="tx1"/>
          </a:solidFill>
          <a:latin typeface="+mn-lt"/>
          <a:ea typeface="+mn-ea"/>
          <a:cs typeface="+mn-cs"/>
        </a:defRPr>
      </a:lvl1pPr>
      <a:lvl2pPr marL="2664173" indent="-1024682" algn="l" defTabSz="3278981" rtl="0" eaLnBrk="1" latinLnBrk="0" hangingPunct="1">
        <a:spcBef>
          <a:spcPct val="20000"/>
        </a:spcBef>
        <a:buFont typeface="Arial" panose="020B0604020202020204" pitchFamily="34" charset="0"/>
        <a:buChar char="–"/>
        <a:defRPr sz="10000" kern="1200">
          <a:solidFill>
            <a:schemeClr val="tx1"/>
          </a:solidFill>
          <a:latin typeface="+mn-lt"/>
          <a:ea typeface="+mn-ea"/>
          <a:cs typeface="+mn-cs"/>
        </a:defRPr>
      </a:lvl2pPr>
      <a:lvl3pPr marL="4098727" indent="-819745" algn="l" defTabSz="3278981" rtl="0" eaLnBrk="1" latinLnBrk="0" hangingPunct="1">
        <a:spcBef>
          <a:spcPct val="20000"/>
        </a:spcBef>
        <a:buFont typeface="Arial" panose="020B0604020202020204" pitchFamily="34" charset="0"/>
        <a:buChar char="•"/>
        <a:defRPr sz="8600" kern="1200">
          <a:solidFill>
            <a:schemeClr val="tx1"/>
          </a:solidFill>
          <a:latin typeface="+mn-lt"/>
          <a:ea typeface="+mn-ea"/>
          <a:cs typeface="+mn-cs"/>
        </a:defRPr>
      </a:lvl3pPr>
      <a:lvl4pPr marL="5738217" indent="-819745" algn="l" defTabSz="3278981" rtl="0" eaLnBrk="1" latinLnBrk="0" hangingPunct="1">
        <a:spcBef>
          <a:spcPct val="20000"/>
        </a:spcBef>
        <a:buFont typeface="Arial" panose="020B0604020202020204" pitchFamily="34" charset="0"/>
        <a:buChar char="–"/>
        <a:defRPr sz="7200" kern="1200">
          <a:solidFill>
            <a:schemeClr val="tx1"/>
          </a:solidFill>
          <a:latin typeface="+mn-lt"/>
          <a:ea typeface="+mn-ea"/>
          <a:cs typeface="+mn-cs"/>
        </a:defRPr>
      </a:lvl4pPr>
      <a:lvl5pPr marL="7377708" indent="-819745" algn="l" defTabSz="3278981" rtl="0" eaLnBrk="1" latinLnBrk="0" hangingPunct="1">
        <a:spcBef>
          <a:spcPct val="20000"/>
        </a:spcBef>
        <a:buFont typeface="Arial" panose="020B0604020202020204" pitchFamily="34" charset="0"/>
        <a:buChar char="»"/>
        <a:defRPr sz="7200" kern="1200">
          <a:solidFill>
            <a:schemeClr val="tx1"/>
          </a:solidFill>
          <a:latin typeface="+mn-lt"/>
          <a:ea typeface="+mn-ea"/>
          <a:cs typeface="+mn-cs"/>
        </a:defRPr>
      </a:lvl5pPr>
      <a:lvl6pPr marL="9017198" indent="-819745" algn="l" defTabSz="3278981" rtl="0" eaLnBrk="1" latinLnBrk="0" hangingPunct="1">
        <a:spcBef>
          <a:spcPct val="200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6pPr>
      <a:lvl7pPr marL="10656689" indent="-819745" algn="l" defTabSz="3278981" rtl="0" eaLnBrk="1" latinLnBrk="0" hangingPunct="1">
        <a:spcBef>
          <a:spcPct val="200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7pPr>
      <a:lvl8pPr marL="12296180" indent="-819745" algn="l" defTabSz="3278981" rtl="0" eaLnBrk="1" latinLnBrk="0" hangingPunct="1">
        <a:spcBef>
          <a:spcPct val="200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8pPr>
      <a:lvl9pPr marL="13935670" indent="-819745" algn="l" defTabSz="3278981" rtl="0" eaLnBrk="1" latinLnBrk="0" hangingPunct="1">
        <a:spcBef>
          <a:spcPct val="200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278981" rtl="0" eaLnBrk="1" latinLnBrk="0" hangingPunct="1">
        <a:defRPr sz="6500" kern="1200">
          <a:solidFill>
            <a:schemeClr val="tx1"/>
          </a:solidFill>
          <a:latin typeface="+mn-lt"/>
          <a:ea typeface="+mn-ea"/>
          <a:cs typeface="+mn-cs"/>
        </a:defRPr>
      </a:lvl1pPr>
      <a:lvl2pPr marL="1639491" algn="l" defTabSz="3278981" rtl="0" eaLnBrk="1" latinLnBrk="0" hangingPunct="1">
        <a:defRPr sz="6500" kern="1200">
          <a:solidFill>
            <a:schemeClr val="tx1"/>
          </a:solidFill>
          <a:latin typeface="+mn-lt"/>
          <a:ea typeface="+mn-ea"/>
          <a:cs typeface="+mn-cs"/>
        </a:defRPr>
      </a:lvl2pPr>
      <a:lvl3pPr marL="3278981" algn="l" defTabSz="3278981" rtl="0" eaLnBrk="1" latinLnBrk="0" hangingPunct="1">
        <a:defRPr sz="6500" kern="1200">
          <a:solidFill>
            <a:schemeClr val="tx1"/>
          </a:solidFill>
          <a:latin typeface="+mn-lt"/>
          <a:ea typeface="+mn-ea"/>
          <a:cs typeface="+mn-cs"/>
        </a:defRPr>
      </a:lvl3pPr>
      <a:lvl4pPr marL="4918472" algn="l" defTabSz="3278981" rtl="0" eaLnBrk="1" latinLnBrk="0" hangingPunct="1">
        <a:defRPr sz="6500" kern="1200">
          <a:solidFill>
            <a:schemeClr val="tx1"/>
          </a:solidFill>
          <a:latin typeface="+mn-lt"/>
          <a:ea typeface="+mn-ea"/>
          <a:cs typeface="+mn-cs"/>
        </a:defRPr>
      </a:lvl4pPr>
      <a:lvl5pPr marL="6557963" algn="l" defTabSz="3278981" rtl="0" eaLnBrk="1" latinLnBrk="0" hangingPunct="1">
        <a:defRPr sz="6500" kern="1200">
          <a:solidFill>
            <a:schemeClr val="tx1"/>
          </a:solidFill>
          <a:latin typeface="+mn-lt"/>
          <a:ea typeface="+mn-ea"/>
          <a:cs typeface="+mn-cs"/>
        </a:defRPr>
      </a:lvl5pPr>
      <a:lvl6pPr marL="8197453" algn="l" defTabSz="3278981" rtl="0" eaLnBrk="1" latinLnBrk="0" hangingPunct="1">
        <a:defRPr sz="6500" kern="1200">
          <a:solidFill>
            <a:schemeClr val="tx1"/>
          </a:solidFill>
          <a:latin typeface="+mn-lt"/>
          <a:ea typeface="+mn-ea"/>
          <a:cs typeface="+mn-cs"/>
        </a:defRPr>
      </a:lvl6pPr>
      <a:lvl7pPr marL="9836944" algn="l" defTabSz="3278981" rtl="0" eaLnBrk="1" latinLnBrk="0" hangingPunct="1">
        <a:defRPr sz="6500" kern="1200">
          <a:solidFill>
            <a:schemeClr val="tx1"/>
          </a:solidFill>
          <a:latin typeface="+mn-lt"/>
          <a:ea typeface="+mn-ea"/>
          <a:cs typeface="+mn-cs"/>
        </a:defRPr>
      </a:lvl7pPr>
      <a:lvl8pPr marL="11476434" algn="l" defTabSz="3278981" rtl="0" eaLnBrk="1" latinLnBrk="0" hangingPunct="1">
        <a:defRPr sz="6500" kern="1200">
          <a:solidFill>
            <a:schemeClr val="tx1"/>
          </a:solidFill>
          <a:latin typeface="+mn-lt"/>
          <a:ea typeface="+mn-ea"/>
          <a:cs typeface="+mn-cs"/>
        </a:defRPr>
      </a:lvl8pPr>
      <a:lvl9pPr marL="13115925" algn="l" defTabSz="3278981" rtl="0" eaLnBrk="1" latinLnBrk="0" hangingPunct="1">
        <a:defRPr sz="6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26" Type="http://schemas.openxmlformats.org/officeDocument/2006/relationships/image" Target="../media/image24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34" Type="http://schemas.openxmlformats.org/officeDocument/2006/relationships/image" Target="../media/image32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5" Type="http://schemas.openxmlformats.org/officeDocument/2006/relationships/image" Target="../media/image23.png"/><Relationship Id="rId33" Type="http://schemas.openxmlformats.org/officeDocument/2006/relationships/image" Target="../media/image31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29" Type="http://schemas.openxmlformats.org/officeDocument/2006/relationships/image" Target="../media/image2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png"/><Relationship Id="rId32" Type="http://schemas.openxmlformats.org/officeDocument/2006/relationships/image" Target="../media/image30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28" Type="http://schemas.openxmlformats.org/officeDocument/2006/relationships/image" Target="../media/image26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31" Type="http://schemas.openxmlformats.org/officeDocument/2006/relationships/image" Target="../media/image29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Relationship Id="rId27" Type="http://schemas.openxmlformats.org/officeDocument/2006/relationships/image" Target="../media/image25.png"/><Relationship Id="rId30" Type="http://schemas.openxmlformats.org/officeDocument/2006/relationships/image" Target="../media/image28.png"/><Relationship Id="rId8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DDEB9B0-A0FC-8BA9-1408-FFB2F2AAA84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4" name="テキスト ボックス 393">
            <a:extLst>
              <a:ext uri="{FF2B5EF4-FFF2-40B4-BE49-F238E27FC236}">
                <a16:creationId xmlns:a16="http://schemas.microsoft.com/office/drawing/2014/main" id="{228BA962-FB43-FBF7-68D3-6B2E504E2E78}"/>
              </a:ext>
            </a:extLst>
          </p:cNvPr>
          <p:cNvSpPr txBox="1"/>
          <p:nvPr/>
        </p:nvSpPr>
        <p:spPr>
          <a:xfrm>
            <a:off x="0" y="-163830"/>
            <a:ext cx="11584453" cy="1418081"/>
          </a:xfrm>
          <a:prstGeom prst="rect">
            <a:avLst/>
          </a:prstGeom>
          <a:noFill/>
        </p:spPr>
        <p:txBody>
          <a:bodyPr wrap="none" lIns="185166" tIns="92583" rIns="185166" bIns="92583" rtlCol="0">
            <a:spAutoFit/>
          </a:bodyPr>
          <a:lstStyle/>
          <a:p>
            <a:r>
              <a:rPr lang="en-US" sz="8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</a:p>
        </p:txBody>
      </p:sp>
      <p:sp>
        <p:nvSpPr>
          <p:cNvPr id="400" name="テキスト ボックス 399">
            <a:extLst>
              <a:ext uri="{FF2B5EF4-FFF2-40B4-BE49-F238E27FC236}">
                <a16:creationId xmlns:a16="http://schemas.microsoft.com/office/drawing/2014/main" id="{81203ADF-652B-16E8-48A4-9FE0F78685C1}"/>
              </a:ext>
            </a:extLst>
          </p:cNvPr>
          <p:cNvSpPr txBox="1"/>
          <p:nvPr/>
        </p:nvSpPr>
        <p:spPr>
          <a:xfrm>
            <a:off x="19584013" y="2108790"/>
            <a:ext cx="221535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1  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E6112325-795D-0955-4E77-AECEAAFD72E4}"/>
              </a:ext>
            </a:extLst>
          </p:cNvPr>
          <p:cNvSpPr txBox="1"/>
          <p:nvPr/>
        </p:nvSpPr>
        <p:spPr>
          <a:xfrm>
            <a:off x="19584013" y="5470719"/>
            <a:ext cx="221535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2  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A9CEB03-F197-97D4-F0E1-AEBC4625C42B}"/>
              </a:ext>
            </a:extLst>
          </p:cNvPr>
          <p:cNvSpPr txBox="1"/>
          <p:nvPr/>
        </p:nvSpPr>
        <p:spPr>
          <a:xfrm>
            <a:off x="19584013" y="8832648"/>
            <a:ext cx="221535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3  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3CC2BA54-0BC0-F86F-36F9-268C41A8AB85}"/>
              </a:ext>
            </a:extLst>
          </p:cNvPr>
          <p:cNvSpPr txBox="1"/>
          <p:nvPr/>
        </p:nvSpPr>
        <p:spPr>
          <a:xfrm>
            <a:off x="19584013" y="12194577"/>
            <a:ext cx="198451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4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1D91230F-AADD-D9F7-FCA6-3F51D6DE6A06}"/>
              </a:ext>
            </a:extLst>
          </p:cNvPr>
          <p:cNvSpPr txBox="1"/>
          <p:nvPr/>
        </p:nvSpPr>
        <p:spPr>
          <a:xfrm>
            <a:off x="19584013" y="15556506"/>
            <a:ext cx="198451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5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86B014DC-F7E3-628C-E890-4E0A9C5F65C6}"/>
              </a:ext>
            </a:extLst>
          </p:cNvPr>
          <p:cNvSpPr txBox="1"/>
          <p:nvPr/>
        </p:nvSpPr>
        <p:spPr>
          <a:xfrm>
            <a:off x="19584013" y="18918435"/>
            <a:ext cx="198451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6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92DB8D72-3812-5E12-B68D-FC0453C8C79A}"/>
              </a:ext>
            </a:extLst>
          </p:cNvPr>
          <p:cNvSpPr txBox="1"/>
          <p:nvPr/>
        </p:nvSpPr>
        <p:spPr>
          <a:xfrm>
            <a:off x="19584013" y="32366152"/>
            <a:ext cx="244618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10  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C4F6CE2A-5600-73D5-267E-49CC4D4726C5}"/>
              </a:ext>
            </a:extLst>
          </p:cNvPr>
          <p:cNvSpPr txBox="1"/>
          <p:nvPr/>
        </p:nvSpPr>
        <p:spPr>
          <a:xfrm>
            <a:off x="19584013" y="29004222"/>
            <a:ext cx="198451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9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BC6D25AA-6372-0CE6-6FF7-32C8F428FA59}"/>
              </a:ext>
            </a:extLst>
          </p:cNvPr>
          <p:cNvSpPr txBox="1"/>
          <p:nvPr/>
        </p:nvSpPr>
        <p:spPr>
          <a:xfrm>
            <a:off x="19584013" y="25642293"/>
            <a:ext cx="19845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8</a:t>
            </a: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BAE34144-2241-E3CA-67D7-B082F8FEF5BE}"/>
              </a:ext>
            </a:extLst>
          </p:cNvPr>
          <p:cNvSpPr txBox="1"/>
          <p:nvPr/>
        </p:nvSpPr>
        <p:spPr>
          <a:xfrm>
            <a:off x="19584013" y="22280364"/>
            <a:ext cx="198451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7</a:t>
            </a:r>
          </a:p>
        </p:txBody>
      </p:sp>
      <p:pic>
        <p:nvPicPr>
          <p:cNvPr id="48" name="図 47">
            <a:extLst>
              <a:ext uri="{FF2B5EF4-FFF2-40B4-BE49-F238E27FC236}">
                <a16:creationId xmlns:a16="http://schemas.microsoft.com/office/drawing/2014/main" id="{51EC9936-856A-0236-3F81-237987C3D56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584014" y="23035955"/>
            <a:ext cx="7029297" cy="2456901"/>
          </a:xfrm>
          <a:prstGeom prst="rect">
            <a:avLst/>
          </a:prstGeom>
        </p:spPr>
      </p:pic>
      <p:pic>
        <p:nvPicPr>
          <p:cNvPr id="56" name="図 55">
            <a:extLst>
              <a:ext uri="{FF2B5EF4-FFF2-40B4-BE49-F238E27FC236}">
                <a16:creationId xmlns:a16="http://schemas.microsoft.com/office/drawing/2014/main" id="{92AC8008-26F1-5E2F-145D-21A3F1CA499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584013" y="2950197"/>
            <a:ext cx="7035394" cy="2450804"/>
          </a:xfrm>
          <a:prstGeom prst="rect">
            <a:avLst/>
          </a:prstGeom>
        </p:spPr>
      </p:pic>
      <p:pic>
        <p:nvPicPr>
          <p:cNvPr id="60" name="図 59">
            <a:extLst>
              <a:ext uri="{FF2B5EF4-FFF2-40B4-BE49-F238E27FC236}">
                <a16:creationId xmlns:a16="http://schemas.microsoft.com/office/drawing/2014/main" id="{F506D30F-CB4E-54E5-4710-F0D656E389F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584014" y="6229464"/>
            <a:ext cx="7029297" cy="2456901"/>
          </a:xfrm>
          <a:prstGeom prst="rect">
            <a:avLst/>
          </a:prstGeom>
        </p:spPr>
      </p:pic>
      <p:pic>
        <p:nvPicPr>
          <p:cNvPr id="786" name="図 785">
            <a:extLst>
              <a:ext uri="{FF2B5EF4-FFF2-40B4-BE49-F238E27FC236}">
                <a16:creationId xmlns:a16="http://schemas.microsoft.com/office/drawing/2014/main" id="{66DF7007-69DA-6290-1C50-C95E1EB320B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584013" y="9609812"/>
            <a:ext cx="7035394" cy="2456901"/>
          </a:xfrm>
          <a:prstGeom prst="rect">
            <a:avLst/>
          </a:prstGeom>
        </p:spPr>
      </p:pic>
      <p:pic>
        <p:nvPicPr>
          <p:cNvPr id="790" name="図 789">
            <a:extLst>
              <a:ext uri="{FF2B5EF4-FFF2-40B4-BE49-F238E27FC236}">
                <a16:creationId xmlns:a16="http://schemas.microsoft.com/office/drawing/2014/main" id="{513BF4F1-AB88-D0C5-0760-C736C1EA8ED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9584013" y="12990159"/>
            <a:ext cx="7035394" cy="2450804"/>
          </a:xfrm>
          <a:prstGeom prst="rect">
            <a:avLst/>
          </a:prstGeom>
        </p:spPr>
      </p:pic>
      <p:pic>
        <p:nvPicPr>
          <p:cNvPr id="794" name="図 793">
            <a:extLst>
              <a:ext uri="{FF2B5EF4-FFF2-40B4-BE49-F238E27FC236}">
                <a16:creationId xmlns:a16="http://schemas.microsoft.com/office/drawing/2014/main" id="{965A9D9F-AE05-81C6-E682-9E5A337256F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9584014" y="16202835"/>
            <a:ext cx="7047587" cy="2450804"/>
          </a:xfrm>
          <a:prstGeom prst="rect">
            <a:avLst/>
          </a:prstGeom>
        </p:spPr>
      </p:pic>
      <p:pic>
        <p:nvPicPr>
          <p:cNvPr id="798" name="図 797">
            <a:extLst>
              <a:ext uri="{FF2B5EF4-FFF2-40B4-BE49-F238E27FC236}">
                <a16:creationId xmlns:a16="http://schemas.microsoft.com/office/drawing/2014/main" id="{8FC345C2-B756-D773-B9EC-6D097FED9F6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9584014" y="19605393"/>
            <a:ext cx="7053683" cy="2542252"/>
          </a:xfrm>
          <a:prstGeom prst="rect">
            <a:avLst/>
          </a:prstGeom>
        </p:spPr>
      </p:pic>
      <p:pic>
        <p:nvPicPr>
          <p:cNvPr id="806" name="図 805">
            <a:extLst>
              <a:ext uri="{FF2B5EF4-FFF2-40B4-BE49-F238E27FC236}">
                <a16:creationId xmlns:a16="http://schemas.microsoft.com/office/drawing/2014/main" id="{0C7F4ABB-63A8-7E70-AA5F-DC5E56CAD04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9584014" y="26426309"/>
            <a:ext cx="7047587" cy="2456901"/>
          </a:xfrm>
          <a:prstGeom prst="rect">
            <a:avLst/>
          </a:prstGeom>
        </p:spPr>
      </p:pic>
      <p:pic>
        <p:nvPicPr>
          <p:cNvPr id="810" name="図 809">
            <a:extLst>
              <a:ext uri="{FF2B5EF4-FFF2-40B4-BE49-F238E27FC236}">
                <a16:creationId xmlns:a16="http://schemas.microsoft.com/office/drawing/2014/main" id="{4992C15B-517E-EF4B-9EA5-143E0ABBDC25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9584013" y="29814385"/>
            <a:ext cx="7035394" cy="2462997"/>
          </a:xfrm>
          <a:prstGeom prst="rect">
            <a:avLst/>
          </a:prstGeom>
        </p:spPr>
      </p:pic>
      <p:pic>
        <p:nvPicPr>
          <p:cNvPr id="814" name="図 813">
            <a:extLst>
              <a:ext uri="{FF2B5EF4-FFF2-40B4-BE49-F238E27FC236}">
                <a16:creationId xmlns:a16="http://schemas.microsoft.com/office/drawing/2014/main" id="{9D1DE705-A527-0700-384D-9AB07EDBF68B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9584014" y="33160719"/>
            <a:ext cx="7047587" cy="2462997"/>
          </a:xfrm>
          <a:prstGeom prst="rect">
            <a:avLst/>
          </a:prstGeom>
        </p:spPr>
      </p:pic>
      <p:sp>
        <p:nvSpPr>
          <p:cNvPr id="815" name="テキスト ボックス 814">
            <a:extLst>
              <a:ext uri="{FF2B5EF4-FFF2-40B4-BE49-F238E27FC236}">
                <a16:creationId xmlns:a16="http://schemas.microsoft.com/office/drawing/2014/main" id="{2AA1F8BF-B30F-8E3D-BA27-4EF73E5E34E9}"/>
              </a:ext>
            </a:extLst>
          </p:cNvPr>
          <p:cNvSpPr txBox="1"/>
          <p:nvPr/>
        </p:nvSpPr>
        <p:spPr>
          <a:xfrm>
            <a:off x="27648991" y="2108790"/>
            <a:ext cx="24207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11  </a:t>
            </a:r>
          </a:p>
        </p:txBody>
      </p:sp>
      <p:sp>
        <p:nvSpPr>
          <p:cNvPr id="816" name="テキスト ボックス 815">
            <a:extLst>
              <a:ext uri="{FF2B5EF4-FFF2-40B4-BE49-F238E27FC236}">
                <a16:creationId xmlns:a16="http://schemas.microsoft.com/office/drawing/2014/main" id="{4B3344FC-3244-061F-E0A9-F7012A4EEECA}"/>
              </a:ext>
            </a:extLst>
          </p:cNvPr>
          <p:cNvSpPr txBox="1"/>
          <p:nvPr/>
        </p:nvSpPr>
        <p:spPr>
          <a:xfrm>
            <a:off x="27648990" y="5470719"/>
            <a:ext cx="244618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12  </a:t>
            </a:r>
          </a:p>
        </p:txBody>
      </p:sp>
      <p:sp>
        <p:nvSpPr>
          <p:cNvPr id="817" name="テキスト ボックス 816">
            <a:extLst>
              <a:ext uri="{FF2B5EF4-FFF2-40B4-BE49-F238E27FC236}">
                <a16:creationId xmlns:a16="http://schemas.microsoft.com/office/drawing/2014/main" id="{CF4F1C7E-B5C3-BBB9-B351-59C36DCD59BB}"/>
              </a:ext>
            </a:extLst>
          </p:cNvPr>
          <p:cNvSpPr txBox="1"/>
          <p:nvPr/>
        </p:nvSpPr>
        <p:spPr>
          <a:xfrm>
            <a:off x="27648990" y="8832648"/>
            <a:ext cx="244618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13  </a:t>
            </a:r>
          </a:p>
        </p:txBody>
      </p:sp>
      <p:sp>
        <p:nvSpPr>
          <p:cNvPr id="818" name="テキスト ボックス 817">
            <a:extLst>
              <a:ext uri="{FF2B5EF4-FFF2-40B4-BE49-F238E27FC236}">
                <a16:creationId xmlns:a16="http://schemas.microsoft.com/office/drawing/2014/main" id="{6127227E-527F-B818-D196-16366497056A}"/>
              </a:ext>
            </a:extLst>
          </p:cNvPr>
          <p:cNvSpPr txBox="1"/>
          <p:nvPr/>
        </p:nvSpPr>
        <p:spPr>
          <a:xfrm>
            <a:off x="27648990" y="12194577"/>
            <a:ext cx="221535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14</a:t>
            </a:r>
          </a:p>
        </p:txBody>
      </p:sp>
      <p:sp>
        <p:nvSpPr>
          <p:cNvPr id="819" name="テキスト ボックス 818">
            <a:extLst>
              <a:ext uri="{FF2B5EF4-FFF2-40B4-BE49-F238E27FC236}">
                <a16:creationId xmlns:a16="http://schemas.microsoft.com/office/drawing/2014/main" id="{3794DF78-99CF-EC05-482E-9B89724CFEAB}"/>
              </a:ext>
            </a:extLst>
          </p:cNvPr>
          <p:cNvSpPr txBox="1"/>
          <p:nvPr/>
        </p:nvSpPr>
        <p:spPr>
          <a:xfrm>
            <a:off x="27648990" y="15556506"/>
            <a:ext cx="221535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15</a:t>
            </a:r>
          </a:p>
        </p:txBody>
      </p:sp>
      <p:sp>
        <p:nvSpPr>
          <p:cNvPr id="820" name="テキスト ボックス 819">
            <a:extLst>
              <a:ext uri="{FF2B5EF4-FFF2-40B4-BE49-F238E27FC236}">
                <a16:creationId xmlns:a16="http://schemas.microsoft.com/office/drawing/2014/main" id="{FF9448BE-04BD-44A0-2F6D-8CF70D12B43A}"/>
              </a:ext>
            </a:extLst>
          </p:cNvPr>
          <p:cNvSpPr txBox="1"/>
          <p:nvPr/>
        </p:nvSpPr>
        <p:spPr>
          <a:xfrm>
            <a:off x="27648990" y="18918435"/>
            <a:ext cx="221535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16</a:t>
            </a:r>
          </a:p>
        </p:txBody>
      </p:sp>
      <p:sp>
        <p:nvSpPr>
          <p:cNvPr id="821" name="テキスト ボックス 820">
            <a:extLst>
              <a:ext uri="{FF2B5EF4-FFF2-40B4-BE49-F238E27FC236}">
                <a16:creationId xmlns:a16="http://schemas.microsoft.com/office/drawing/2014/main" id="{4211EB1A-7C6B-6739-5A5D-4331D3F2E588}"/>
              </a:ext>
            </a:extLst>
          </p:cNvPr>
          <p:cNvSpPr txBox="1"/>
          <p:nvPr/>
        </p:nvSpPr>
        <p:spPr>
          <a:xfrm>
            <a:off x="27648990" y="32366152"/>
            <a:ext cx="244618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20  </a:t>
            </a:r>
          </a:p>
        </p:txBody>
      </p:sp>
      <p:sp>
        <p:nvSpPr>
          <p:cNvPr id="822" name="テキスト ボックス 821">
            <a:extLst>
              <a:ext uri="{FF2B5EF4-FFF2-40B4-BE49-F238E27FC236}">
                <a16:creationId xmlns:a16="http://schemas.microsoft.com/office/drawing/2014/main" id="{B3A9D3B1-E797-3F7C-31D8-2BE157D8D233}"/>
              </a:ext>
            </a:extLst>
          </p:cNvPr>
          <p:cNvSpPr txBox="1"/>
          <p:nvPr/>
        </p:nvSpPr>
        <p:spPr>
          <a:xfrm>
            <a:off x="27648990" y="29004222"/>
            <a:ext cx="221535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19</a:t>
            </a:r>
          </a:p>
        </p:txBody>
      </p:sp>
      <p:sp>
        <p:nvSpPr>
          <p:cNvPr id="823" name="テキスト ボックス 822">
            <a:extLst>
              <a:ext uri="{FF2B5EF4-FFF2-40B4-BE49-F238E27FC236}">
                <a16:creationId xmlns:a16="http://schemas.microsoft.com/office/drawing/2014/main" id="{92A38574-0ED0-D31D-4E1F-906CAB31BEDD}"/>
              </a:ext>
            </a:extLst>
          </p:cNvPr>
          <p:cNvSpPr txBox="1"/>
          <p:nvPr/>
        </p:nvSpPr>
        <p:spPr>
          <a:xfrm>
            <a:off x="27648991" y="25642293"/>
            <a:ext cx="24461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18</a:t>
            </a:r>
          </a:p>
        </p:txBody>
      </p:sp>
      <p:sp>
        <p:nvSpPr>
          <p:cNvPr id="824" name="テキスト ボックス 823">
            <a:extLst>
              <a:ext uri="{FF2B5EF4-FFF2-40B4-BE49-F238E27FC236}">
                <a16:creationId xmlns:a16="http://schemas.microsoft.com/office/drawing/2014/main" id="{4E08F70D-1502-96D1-CCD4-62F0F63E46FF}"/>
              </a:ext>
            </a:extLst>
          </p:cNvPr>
          <p:cNvSpPr txBox="1"/>
          <p:nvPr/>
        </p:nvSpPr>
        <p:spPr>
          <a:xfrm>
            <a:off x="27648990" y="22280364"/>
            <a:ext cx="221535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17</a:t>
            </a:r>
          </a:p>
        </p:txBody>
      </p:sp>
      <p:sp>
        <p:nvSpPr>
          <p:cNvPr id="387" name="テキスト ボックス 386">
            <a:extLst>
              <a:ext uri="{FF2B5EF4-FFF2-40B4-BE49-F238E27FC236}">
                <a16:creationId xmlns:a16="http://schemas.microsoft.com/office/drawing/2014/main" id="{D7C2B171-4146-4FE8-5B2C-EFEC7DCD9830}"/>
              </a:ext>
            </a:extLst>
          </p:cNvPr>
          <p:cNvSpPr txBox="1"/>
          <p:nvPr/>
        </p:nvSpPr>
        <p:spPr>
          <a:xfrm>
            <a:off x="35699587" y="2108790"/>
            <a:ext cx="244618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21  </a:t>
            </a:r>
          </a:p>
        </p:txBody>
      </p:sp>
      <p:sp>
        <p:nvSpPr>
          <p:cNvPr id="388" name="テキスト ボックス 387">
            <a:extLst>
              <a:ext uri="{FF2B5EF4-FFF2-40B4-BE49-F238E27FC236}">
                <a16:creationId xmlns:a16="http://schemas.microsoft.com/office/drawing/2014/main" id="{3CCF7878-ACFE-5794-CBF6-E1A78D66A1AD}"/>
              </a:ext>
            </a:extLst>
          </p:cNvPr>
          <p:cNvSpPr txBox="1"/>
          <p:nvPr/>
        </p:nvSpPr>
        <p:spPr>
          <a:xfrm>
            <a:off x="35699587" y="5470719"/>
            <a:ext cx="233076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22 </a:t>
            </a:r>
          </a:p>
        </p:txBody>
      </p:sp>
      <p:sp>
        <p:nvSpPr>
          <p:cNvPr id="389" name="テキスト ボックス 388">
            <a:extLst>
              <a:ext uri="{FF2B5EF4-FFF2-40B4-BE49-F238E27FC236}">
                <a16:creationId xmlns:a16="http://schemas.microsoft.com/office/drawing/2014/main" id="{D8E0CAB9-C442-6C64-18A4-35A40BAAA848}"/>
              </a:ext>
            </a:extLst>
          </p:cNvPr>
          <p:cNvSpPr txBox="1"/>
          <p:nvPr/>
        </p:nvSpPr>
        <p:spPr>
          <a:xfrm>
            <a:off x="35699587" y="8832648"/>
            <a:ext cx="244618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23  </a:t>
            </a:r>
          </a:p>
        </p:txBody>
      </p:sp>
      <p:sp>
        <p:nvSpPr>
          <p:cNvPr id="390" name="テキスト ボックス 389">
            <a:extLst>
              <a:ext uri="{FF2B5EF4-FFF2-40B4-BE49-F238E27FC236}">
                <a16:creationId xmlns:a16="http://schemas.microsoft.com/office/drawing/2014/main" id="{333B0586-696B-D462-4C73-18F6E9FA4494}"/>
              </a:ext>
            </a:extLst>
          </p:cNvPr>
          <p:cNvSpPr txBox="1"/>
          <p:nvPr/>
        </p:nvSpPr>
        <p:spPr>
          <a:xfrm>
            <a:off x="35699587" y="12194577"/>
            <a:ext cx="221535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24</a:t>
            </a:r>
          </a:p>
        </p:txBody>
      </p:sp>
      <p:sp>
        <p:nvSpPr>
          <p:cNvPr id="391" name="テキスト ボックス 390">
            <a:extLst>
              <a:ext uri="{FF2B5EF4-FFF2-40B4-BE49-F238E27FC236}">
                <a16:creationId xmlns:a16="http://schemas.microsoft.com/office/drawing/2014/main" id="{E3A98203-1D43-9390-3CE6-D5F479ABD0CF}"/>
              </a:ext>
            </a:extLst>
          </p:cNvPr>
          <p:cNvSpPr txBox="1"/>
          <p:nvPr/>
        </p:nvSpPr>
        <p:spPr>
          <a:xfrm>
            <a:off x="35699587" y="15556506"/>
            <a:ext cx="221535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25</a:t>
            </a:r>
          </a:p>
        </p:txBody>
      </p:sp>
      <p:sp>
        <p:nvSpPr>
          <p:cNvPr id="392" name="テキスト ボックス 391">
            <a:extLst>
              <a:ext uri="{FF2B5EF4-FFF2-40B4-BE49-F238E27FC236}">
                <a16:creationId xmlns:a16="http://schemas.microsoft.com/office/drawing/2014/main" id="{0B1C5BC2-2802-DC77-0038-4FD2B75678EC}"/>
              </a:ext>
            </a:extLst>
          </p:cNvPr>
          <p:cNvSpPr txBox="1"/>
          <p:nvPr/>
        </p:nvSpPr>
        <p:spPr>
          <a:xfrm>
            <a:off x="35699587" y="18918435"/>
            <a:ext cx="233076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 26</a:t>
            </a:r>
          </a:p>
        </p:txBody>
      </p:sp>
      <p:sp>
        <p:nvSpPr>
          <p:cNvPr id="393" name="テキスト ボックス 392">
            <a:extLst>
              <a:ext uri="{FF2B5EF4-FFF2-40B4-BE49-F238E27FC236}">
                <a16:creationId xmlns:a16="http://schemas.microsoft.com/office/drawing/2014/main" id="{B0C657B3-C9AE-A271-13D6-360A9CE14262}"/>
              </a:ext>
            </a:extLst>
          </p:cNvPr>
          <p:cNvSpPr txBox="1"/>
          <p:nvPr/>
        </p:nvSpPr>
        <p:spPr>
          <a:xfrm>
            <a:off x="35699587" y="32366152"/>
            <a:ext cx="244618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30  </a:t>
            </a:r>
          </a:p>
        </p:txBody>
      </p:sp>
      <p:sp>
        <p:nvSpPr>
          <p:cNvPr id="832" name="テキスト ボックス 831">
            <a:extLst>
              <a:ext uri="{FF2B5EF4-FFF2-40B4-BE49-F238E27FC236}">
                <a16:creationId xmlns:a16="http://schemas.microsoft.com/office/drawing/2014/main" id="{CEFE7804-7AB1-53FC-2B21-7C1AEE587121}"/>
              </a:ext>
            </a:extLst>
          </p:cNvPr>
          <p:cNvSpPr txBox="1"/>
          <p:nvPr/>
        </p:nvSpPr>
        <p:spPr>
          <a:xfrm>
            <a:off x="35699587" y="29004222"/>
            <a:ext cx="221535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29</a:t>
            </a:r>
          </a:p>
        </p:txBody>
      </p:sp>
      <p:sp>
        <p:nvSpPr>
          <p:cNvPr id="833" name="テキスト ボックス 832">
            <a:extLst>
              <a:ext uri="{FF2B5EF4-FFF2-40B4-BE49-F238E27FC236}">
                <a16:creationId xmlns:a16="http://schemas.microsoft.com/office/drawing/2014/main" id="{9530AE4B-2529-A5F3-2A70-2BD93589D04C}"/>
              </a:ext>
            </a:extLst>
          </p:cNvPr>
          <p:cNvSpPr txBox="1"/>
          <p:nvPr/>
        </p:nvSpPr>
        <p:spPr>
          <a:xfrm>
            <a:off x="35699588" y="25642293"/>
            <a:ext cx="291726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2 8</a:t>
            </a:r>
          </a:p>
        </p:txBody>
      </p:sp>
      <p:sp>
        <p:nvSpPr>
          <p:cNvPr id="834" name="テキスト ボックス 833">
            <a:extLst>
              <a:ext uri="{FF2B5EF4-FFF2-40B4-BE49-F238E27FC236}">
                <a16:creationId xmlns:a16="http://schemas.microsoft.com/office/drawing/2014/main" id="{78F4484D-6F30-8E36-0D44-E986E7CC3A51}"/>
              </a:ext>
            </a:extLst>
          </p:cNvPr>
          <p:cNvSpPr txBox="1"/>
          <p:nvPr/>
        </p:nvSpPr>
        <p:spPr>
          <a:xfrm>
            <a:off x="35699587" y="22280364"/>
            <a:ext cx="221535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27</a:t>
            </a:r>
          </a:p>
        </p:txBody>
      </p:sp>
      <p:pic>
        <p:nvPicPr>
          <p:cNvPr id="848" name="図 847">
            <a:extLst>
              <a:ext uri="{FF2B5EF4-FFF2-40B4-BE49-F238E27FC236}">
                <a16:creationId xmlns:a16="http://schemas.microsoft.com/office/drawing/2014/main" id="{7D5A224A-56D5-7AF9-DB86-7BCEA7A6D643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7648991" y="2950197"/>
            <a:ext cx="7047587" cy="2450804"/>
          </a:xfrm>
          <a:prstGeom prst="rect">
            <a:avLst/>
          </a:prstGeom>
        </p:spPr>
      </p:pic>
      <p:pic>
        <p:nvPicPr>
          <p:cNvPr id="852" name="図 851">
            <a:extLst>
              <a:ext uri="{FF2B5EF4-FFF2-40B4-BE49-F238E27FC236}">
                <a16:creationId xmlns:a16="http://schemas.microsoft.com/office/drawing/2014/main" id="{EEF7B6FF-A8A7-ACD0-7C85-3B4855D65D90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7648991" y="6229463"/>
            <a:ext cx="7053683" cy="2450804"/>
          </a:xfrm>
          <a:prstGeom prst="rect">
            <a:avLst/>
          </a:prstGeom>
        </p:spPr>
      </p:pic>
      <p:pic>
        <p:nvPicPr>
          <p:cNvPr id="856" name="図 855">
            <a:extLst>
              <a:ext uri="{FF2B5EF4-FFF2-40B4-BE49-F238E27FC236}">
                <a16:creationId xmlns:a16="http://schemas.microsoft.com/office/drawing/2014/main" id="{DF1804A1-267F-FECA-04B5-F27AD69F65A4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7648990" y="9609811"/>
            <a:ext cx="7041490" cy="2450804"/>
          </a:xfrm>
          <a:prstGeom prst="rect">
            <a:avLst/>
          </a:prstGeom>
        </p:spPr>
      </p:pic>
      <p:pic>
        <p:nvPicPr>
          <p:cNvPr id="860" name="図 859">
            <a:extLst>
              <a:ext uri="{FF2B5EF4-FFF2-40B4-BE49-F238E27FC236}">
                <a16:creationId xmlns:a16="http://schemas.microsoft.com/office/drawing/2014/main" id="{CD3EE991-5F40-B3C3-4FC1-B2E717781FCE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27648990" y="12990159"/>
            <a:ext cx="7041490" cy="2450804"/>
          </a:xfrm>
          <a:prstGeom prst="rect">
            <a:avLst/>
          </a:prstGeom>
        </p:spPr>
      </p:pic>
      <p:pic>
        <p:nvPicPr>
          <p:cNvPr id="864" name="図 863">
            <a:extLst>
              <a:ext uri="{FF2B5EF4-FFF2-40B4-BE49-F238E27FC236}">
                <a16:creationId xmlns:a16="http://schemas.microsoft.com/office/drawing/2014/main" id="{B12A4681-D152-0F40-CFF8-56D1FB79BB51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7648991" y="16202835"/>
            <a:ext cx="7047587" cy="2450804"/>
          </a:xfrm>
          <a:prstGeom prst="rect">
            <a:avLst/>
          </a:prstGeom>
        </p:spPr>
      </p:pic>
      <p:pic>
        <p:nvPicPr>
          <p:cNvPr id="868" name="図 867">
            <a:extLst>
              <a:ext uri="{FF2B5EF4-FFF2-40B4-BE49-F238E27FC236}">
                <a16:creationId xmlns:a16="http://schemas.microsoft.com/office/drawing/2014/main" id="{B514009B-DB4E-1CF2-8212-BF9D10867F0A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7648990" y="19605393"/>
            <a:ext cx="7041490" cy="2450804"/>
          </a:xfrm>
          <a:prstGeom prst="rect">
            <a:avLst/>
          </a:prstGeom>
        </p:spPr>
      </p:pic>
      <p:pic>
        <p:nvPicPr>
          <p:cNvPr id="872" name="図 871">
            <a:extLst>
              <a:ext uri="{FF2B5EF4-FFF2-40B4-BE49-F238E27FC236}">
                <a16:creationId xmlns:a16="http://schemas.microsoft.com/office/drawing/2014/main" id="{924E66E9-1198-155D-6B12-5021FABCD37B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27648990" y="23035954"/>
            <a:ext cx="7041490" cy="2450804"/>
          </a:xfrm>
          <a:prstGeom prst="rect">
            <a:avLst/>
          </a:prstGeom>
        </p:spPr>
      </p:pic>
      <p:pic>
        <p:nvPicPr>
          <p:cNvPr id="876" name="図 875">
            <a:extLst>
              <a:ext uri="{FF2B5EF4-FFF2-40B4-BE49-F238E27FC236}">
                <a16:creationId xmlns:a16="http://schemas.microsoft.com/office/drawing/2014/main" id="{9947BFB9-ACA5-FB4B-459D-3C8A357E506F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7648990" y="26426308"/>
            <a:ext cx="7041490" cy="2450804"/>
          </a:xfrm>
          <a:prstGeom prst="rect">
            <a:avLst/>
          </a:prstGeom>
        </p:spPr>
      </p:pic>
      <p:pic>
        <p:nvPicPr>
          <p:cNvPr id="880" name="図 879">
            <a:extLst>
              <a:ext uri="{FF2B5EF4-FFF2-40B4-BE49-F238E27FC236}">
                <a16:creationId xmlns:a16="http://schemas.microsoft.com/office/drawing/2014/main" id="{60B270FF-2EEF-539E-75AF-0C6E6946C7EB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27648990" y="29814384"/>
            <a:ext cx="7041490" cy="2450804"/>
          </a:xfrm>
          <a:prstGeom prst="rect">
            <a:avLst/>
          </a:prstGeom>
        </p:spPr>
      </p:pic>
      <p:pic>
        <p:nvPicPr>
          <p:cNvPr id="884" name="図 883">
            <a:extLst>
              <a:ext uri="{FF2B5EF4-FFF2-40B4-BE49-F238E27FC236}">
                <a16:creationId xmlns:a16="http://schemas.microsoft.com/office/drawing/2014/main" id="{D38D4E69-F37A-FA20-4D69-D643A056CC8F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27648990" y="33160718"/>
            <a:ext cx="7041490" cy="2450804"/>
          </a:xfrm>
          <a:prstGeom prst="rect">
            <a:avLst/>
          </a:prstGeom>
        </p:spPr>
      </p:pic>
      <p:pic>
        <p:nvPicPr>
          <p:cNvPr id="888" name="図 887">
            <a:extLst>
              <a:ext uri="{FF2B5EF4-FFF2-40B4-BE49-F238E27FC236}">
                <a16:creationId xmlns:a16="http://schemas.microsoft.com/office/drawing/2014/main" id="{1853FF9F-8A7E-1FF9-5839-498A97C8664D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35699587" y="2950197"/>
            <a:ext cx="7041490" cy="2450804"/>
          </a:xfrm>
          <a:prstGeom prst="rect">
            <a:avLst/>
          </a:prstGeom>
        </p:spPr>
      </p:pic>
      <p:pic>
        <p:nvPicPr>
          <p:cNvPr id="892" name="図 891">
            <a:extLst>
              <a:ext uri="{FF2B5EF4-FFF2-40B4-BE49-F238E27FC236}">
                <a16:creationId xmlns:a16="http://schemas.microsoft.com/office/drawing/2014/main" id="{95A6652F-CC29-8E9E-430E-9DFA66482482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35699587" y="6229463"/>
            <a:ext cx="7041490" cy="2450804"/>
          </a:xfrm>
          <a:prstGeom prst="rect">
            <a:avLst/>
          </a:prstGeom>
        </p:spPr>
      </p:pic>
      <p:pic>
        <p:nvPicPr>
          <p:cNvPr id="896" name="図 895">
            <a:extLst>
              <a:ext uri="{FF2B5EF4-FFF2-40B4-BE49-F238E27FC236}">
                <a16:creationId xmlns:a16="http://schemas.microsoft.com/office/drawing/2014/main" id="{EE8C7A86-238B-0164-2110-3238C8757E51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35699588" y="9609811"/>
            <a:ext cx="7053683" cy="2450804"/>
          </a:xfrm>
          <a:prstGeom prst="rect">
            <a:avLst/>
          </a:prstGeom>
        </p:spPr>
      </p:pic>
      <p:pic>
        <p:nvPicPr>
          <p:cNvPr id="900" name="図 899">
            <a:extLst>
              <a:ext uri="{FF2B5EF4-FFF2-40B4-BE49-F238E27FC236}">
                <a16:creationId xmlns:a16="http://schemas.microsoft.com/office/drawing/2014/main" id="{0F913EB2-1476-471D-BFAC-B5B56402724F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35699587" y="12990159"/>
            <a:ext cx="7035394" cy="2450804"/>
          </a:xfrm>
          <a:prstGeom prst="rect">
            <a:avLst/>
          </a:prstGeom>
        </p:spPr>
      </p:pic>
      <p:pic>
        <p:nvPicPr>
          <p:cNvPr id="904" name="図 903">
            <a:extLst>
              <a:ext uri="{FF2B5EF4-FFF2-40B4-BE49-F238E27FC236}">
                <a16:creationId xmlns:a16="http://schemas.microsoft.com/office/drawing/2014/main" id="{74FEE752-6945-A72E-29A2-AF34A34452FF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35699588" y="16202835"/>
            <a:ext cx="7047587" cy="2450804"/>
          </a:xfrm>
          <a:prstGeom prst="rect">
            <a:avLst/>
          </a:prstGeom>
        </p:spPr>
      </p:pic>
      <p:pic>
        <p:nvPicPr>
          <p:cNvPr id="908" name="図 907">
            <a:extLst>
              <a:ext uri="{FF2B5EF4-FFF2-40B4-BE49-F238E27FC236}">
                <a16:creationId xmlns:a16="http://schemas.microsoft.com/office/drawing/2014/main" id="{874A703A-BF60-808B-1BA8-14852C815212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35699587" y="19605393"/>
            <a:ext cx="7041490" cy="2450804"/>
          </a:xfrm>
          <a:prstGeom prst="rect">
            <a:avLst/>
          </a:prstGeom>
        </p:spPr>
      </p:pic>
      <p:pic>
        <p:nvPicPr>
          <p:cNvPr id="912" name="図 911">
            <a:extLst>
              <a:ext uri="{FF2B5EF4-FFF2-40B4-BE49-F238E27FC236}">
                <a16:creationId xmlns:a16="http://schemas.microsoft.com/office/drawing/2014/main" id="{5BDECC5A-BF93-0572-1483-39EEBD950B33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35699587" y="23035954"/>
            <a:ext cx="7041490" cy="2450804"/>
          </a:xfrm>
          <a:prstGeom prst="rect">
            <a:avLst/>
          </a:prstGeom>
        </p:spPr>
      </p:pic>
      <p:pic>
        <p:nvPicPr>
          <p:cNvPr id="916" name="図 915">
            <a:extLst>
              <a:ext uri="{FF2B5EF4-FFF2-40B4-BE49-F238E27FC236}">
                <a16:creationId xmlns:a16="http://schemas.microsoft.com/office/drawing/2014/main" id="{0F7CDFB2-2267-3F30-2D37-100916ED60CB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35699587" y="26426308"/>
            <a:ext cx="7035394" cy="2450804"/>
          </a:xfrm>
          <a:prstGeom prst="rect">
            <a:avLst/>
          </a:prstGeom>
        </p:spPr>
      </p:pic>
      <p:pic>
        <p:nvPicPr>
          <p:cNvPr id="920" name="図 919">
            <a:extLst>
              <a:ext uri="{FF2B5EF4-FFF2-40B4-BE49-F238E27FC236}">
                <a16:creationId xmlns:a16="http://schemas.microsoft.com/office/drawing/2014/main" id="{C1406985-4479-F6C0-DD03-AAE845DA21AD}"/>
              </a:ext>
            </a:extLst>
          </p:cNvPr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35699588" y="29814384"/>
            <a:ext cx="7047587" cy="2450804"/>
          </a:xfrm>
          <a:prstGeom prst="rect">
            <a:avLst/>
          </a:prstGeom>
        </p:spPr>
      </p:pic>
      <p:pic>
        <p:nvPicPr>
          <p:cNvPr id="924" name="図 923">
            <a:extLst>
              <a:ext uri="{FF2B5EF4-FFF2-40B4-BE49-F238E27FC236}">
                <a16:creationId xmlns:a16="http://schemas.microsoft.com/office/drawing/2014/main" id="{415945C2-0479-FF9A-80BD-19F45E9B0051}"/>
              </a:ext>
            </a:extLst>
          </p:cNvPr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35699588" y="33160718"/>
            <a:ext cx="7047587" cy="2450804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0D9CD0A-9241-8297-ECAA-194D7504AF95}"/>
              </a:ext>
            </a:extLst>
          </p:cNvPr>
          <p:cNvSpPr txBox="1"/>
          <p:nvPr/>
        </p:nvSpPr>
        <p:spPr>
          <a:xfrm>
            <a:off x="16547828" y="1620246"/>
            <a:ext cx="2254271" cy="1418081"/>
          </a:xfrm>
          <a:prstGeom prst="rect">
            <a:avLst/>
          </a:prstGeom>
          <a:noFill/>
        </p:spPr>
        <p:txBody>
          <a:bodyPr wrap="none" lIns="185166" tIns="92583" rIns="185166" bIns="92583" rtlCol="0">
            <a:spAutoFit/>
          </a:bodyPr>
          <a:lstStyle/>
          <a:p>
            <a:r>
              <a:rPr lang="en-US" sz="8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 B )</a:t>
            </a:r>
          </a:p>
        </p:txBody>
      </p:sp>
      <p:grpSp>
        <p:nvGrpSpPr>
          <p:cNvPr id="40" name="グループ化 39">
            <a:extLst>
              <a:ext uri="{FF2B5EF4-FFF2-40B4-BE49-F238E27FC236}">
                <a16:creationId xmlns:a16="http://schemas.microsoft.com/office/drawing/2014/main" id="{C82B9C35-EAFE-148A-C3E7-F61B4D386C88}"/>
              </a:ext>
            </a:extLst>
          </p:cNvPr>
          <p:cNvGrpSpPr/>
          <p:nvPr/>
        </p:nvGrpSpPr>
        <p:grpSpPr>
          <a:xfrm>
            <a:off x="4539637" y="4189508"/>
            <a:ext cx="9837517" cy="489885"/>
            <a:chOff x="966611" y="2383438"/>
            <a:chExt cx="1877807" cy="72000"/>
          </a:xfrm>
        </p:grpSpPr>
        <p:sp>
          <p:nvSpPr>
            <p:cNvPr id="41" name="正方形/長方形 40">
              <a:extLst>
                <a:ext uri="{FF2B5EF4-FFF2-40B4-BE49-F238E27FC236}">
                  <a16:creationId xmlns:a16="http://schemas.microsoft.com/office/drawing/2014/main" id="{EB03EE6B-C6E1-89A8-E780-7B9E2F8CFDB1}"/>
                </a:ext>
              </a:extLst>
            </p:cNvPr>
            <p:cNvSpPr/>
            <p:nvPr/>
          </p:nvSpPr>
          <p:spPr>
            <a:xfrm>
              <a:off x="1346063" y="2383438"/>
              <a:ext cx="360000" cy="72000"/>
            </a:xfrm>
            <a:prstGeom prst="rect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正方形/長方形 41">
              <a:extLst>
                <a:ext uri="{FF2B5EF4-FFF2-40B4-BE49-F238E27FC236}">
                  <a16:creationId xmlns:a16="http://schemas.microsoft.com/office/drawing/2014/main" id="{A72390D2-BD8C-961E-5011-794DECF971BC}"/>
                </a:ext>
              </a:extLst>
            </p:cNvPr>
            <p:cNvSpPr/>
            <p:nvPr/>
          </p:nvSpPr>
          <p:spPr>
            <a:xfrm>
              <a:off x="1725515" y="2383438"/>
              <a:ext cx="360000" cy="72000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正方形/長方形 42">
              <a:extLst>
                <a:ext uri="{FF2B5EF4-FFF2-40B4-BE49-F238E27FC236}">
                  <a16:creationId xmlns:a16="http://schemas.microsoft.com/office/drawing/2014/main" id="{3890210F-D5F5-210A-54A9-5334AB4E5437}"/>
                </a:ext>
              </a:extLst>
            </p:cNvPr>
            <p:cNvSpPr/>
            <p:nvPr/>
          </p:nvSpPr>
          <p:spPr>
            <a:xfrm>
              <a:off x="2104967" y="2383438"/>
              <a:ext cx="360000" cy="72000"/>
            </a:xfrm>
            <a:prstGeom prst="rect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正方形/長方形 43">
              <a:extLst>
                <a:ext uri="{FF2B5EF4-FFF2-40B4-BE49-F238E27FC236}">
                  <a16:creationId xmlns:a16="http://schemas.microsoft.com/office/drawing/2014/main" id="{3AA2DD7B-A52C-89D3-C7F6-A35A4FCD915E}"/>
                </a:ext>
              </a:extLst>
            </p:cNvPr>
            <p:cNvSpPr/>
            <p:nvPr/>
          </p:nvSpPr>
          <p:spPr>
            <a:xfrm>
              <a:off x="2484418" y="2383438"/>
              <a:ext cx="360000" cy="72000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正方形/長方形 44">
              <a:extLst>
                <a:ext uri="{FF2B5EF4-FFF2-40B4-BE49-F238E27FC236}">
                  <a16:creationId xmlns:a16="http://schemas.microsoft.com/office/drawing/2014/main" id="{530C2BB0-52D8-EAF3-44F0-E05428F09B62}"/>
                </a:ext>
              </a:extLst>
            </p:cNvPr>
            <p:cNvSpPr/>
            <p:nvPr/>
          </p:nvSpPr>
          <p:spPr>
            <a:xfrm>
              <a:off x="966611" y="2383438"/>
              <a:ext cx="360000" cy="72000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46" name="図 45" descr="グラフ が含まれている画像&#10;&#10;自動的に生成された説明">
            <a:extLst>
              <a:ext uri="{FF2B5EF4-FFF2-40B4-BE49-F238E27FC236}">
                <a16:creationId xmlns:a16="http://schemas.microsoft.com/office/drawing/2014/main" id="{AB695B4D-78D4-E5E9-FA5D-B89AF2F27931}"/>
              </a:ext>
            </a:extLst>
          </p:cNvPr>
          <p:cNvPicPr>
            <a:picLocks noChangeAspect="1"/>
          </p:cNvPicPr>
          <p:nvPr/>
        </p:nvPicPr>
        <p:blipFill>
          <a:blip r:embed="rId33"/>
          <a:srcRect t="10893" b="1"/>
          <a:stretch/>
        </p:blipFill>
        <p:spPr>
          <a:xfrm>
            <a:off x="686007" y="4822405"/>
            <a:ext cx="14058214" cy="19118556"/>
          </a:xfrm>
          <a:prstGeom prst="rect">
            <a:avLst/>
          </a:prstGeom>
        </p:spPr>
      </p:pic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21E155D2-C024-B2AE-3AD1-D97D00375D3D}"/>
              </a:ext>
            </a:extLst>
          </p:cNvPr>
          <p:cNvSpPr txBox="1"/>
          <p:nvPr/>
        </p:nvSpPr>
        <p:spPr>
          <a:xfrm>
            <a:off x="5095923" y="2938957"/>
            <a:ext cx="998991" cy="1446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endParaRPr kumimoji="1" lang="ja-JP" altLang="en-US" sz="8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6C86E89F-9F68-3B84-8AA5-29D7D96A60F3}"/>
              </a:ext>
            </a:extLst>
          </p:cNvPr>
          <p:cNvSpPr txBox="1"/>
          <p:nvPr/>
        </p:nvSpPr>
        <p:spPr>
          <a:xfrm>
            <a:off x="6748335" y="2938957"/>
            <a:ext cx="1377300" cy="1446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endParaRPr kumimoji="1" lang="ja-JP" altLang="en-US" sz="8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81FAC19E-0391-E3FA-6172-8AE7C3808500}"/>
              </a:ext>
            </a:extLst>
          </p:cNvPr>
          <p:cNvSpPr txBox="1"/>
          <p:nvPr/>
        </p:nvSpPr>
        <p:spPr>
          <a:xfrm>
            <a:off x="8779056" y="2938957"/>
            <a:ext cx="1377300" cy="1446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endParaRPr kumimoji="1" lang="ja-JP" altLang="en-US" sz="8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87EF4892-797D-6E35-0C25-D13A6826D4AE}"/>
              </a:ext>
            </a:extLst>
          </p:cNvPr>
          <p:cNvSpPr txBox="1"/>
          <p:nvPr/>
        </p:nvSpPr>
        <p:spPr>
          <a:xfrm>
            <a:off x="10809777" y="2938957"/>
            <a:ext cx="1377300" cy="1446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endParaRPr kumimoji="1" lang="ja-JP" altLang="en-US" sz="8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C9A181D5-5528-08F0-902A-14552939D7C0}"/>
              </a:ext>
            </a:extLst>
          </p:cNvPr>
          <p:cNvSpPr txBox="1"/>
          <p:nvPr/>
        </p:nvSpPr>
        <p:spPr>
          <a:xfrm>
            <a:off x="12840496" y="2938957"/>
            <a:ext cx="1377300" cy="1446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4</a:t>
            </a:r>
            <a:endParaRPr kumimoji="1" lang="ja-JP" altLang="en-US" sz="8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73E5AB64-E75A-868E-B5A9-7E60A189D772}"/>
              </a:ext>
            </a:extLst>
          </p:cNvPr>
          <p:cNvSpPr txBox="1"/>
          <p:nvPr/>
        </p:nvSpPr>
        <p:spPr>
          <a:xfrm>
            <a:off x="399984" y="1620246"/>
            <a:ext cx="2197140" cy="1418081"/>
          </a:xfrm>
          <a:prstGeom prst="rect">
            <a:avLst/>
          </a:prstGeom>
          <a:noFill/>
        </p:spPr>
        <p:txBody>
          <a:bodyPr wrap="none" lIns="185166" tIns="92583" rIns="185166" bIns="92583" rtlCol="0">
            <a:spAutoFit/>
          </a:bodyPr>
          <a:lstStyle/>
          <a:p>
            <a:r>
              <a:rPr lang="en-US" sz="8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 A )</a:t>
            </a:r>
          </a:p>
        </p:txBody>
      </p:sp>
      <p:sp>
        <p:nvSpPr>
          <p:cNvPr id="54" name="正方形/長方形 53">
            <a:extLst>
              <a:ext uri="{FF2B5EF4-FFF2-40B4-BE49-F238E27FC236}">
                <a16:creationId xmlns:a16="http://schemas.microsoft.com/office/drawing/2014/main" id="{2B4DA5D7-642A-8730-987C-AF1C2E1BA31D}"/>
              </a:ext>
            </a:extLst>
          </p:cNvPr>
          <p:cNvSpPr/>
          <p:nvPr/>
        </p:nvSpPr>
        <p:spPr>
          <a:xfrm>
            <a:off x="14915805" y="19605393"/>
            <a:ext cx="864095" cy="4233594"/>
          </a:xfrm>
          <a:prstGeom prst="rect">
            <a:avLst/>
          </a:prstGeom>
          <a:gradFill flip="none" rotWithShape="1">
            <a:gsLst>
              <a:gs pos="50000">
                <a:schemeClr val="tx1"/>
              </a:gs>
              <a:gs pos="0">
                <a:srgbClr val="FF0000"/>
              </a:gs>
              <a:gs pos="100000">
                <a:srgbClr val="00B050"/>
              </a:gs>
            </a:gsLst>
            <a:lin ang="5400000" scaled="1"/>
            <a:tileRect/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AAE92F34-0BDF-A5B9-1E55-55B50E0D72F8}"/>
              </a:ext>
            </a:extLst>
          </p:cNvPr>
          <p:cNvSpPr txBox="1"/>
          <p:nvPr/>
        </p:nvSpPr>
        <p:spPr>
          <a:xfrm>
            <a:off x="15951484" y="23387872"/>
            <a:ext cx="183554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4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</a:t>
            </a:r>
            <a:endParaRPr kumimoji="1" lang="ja-JP" altLang="en-US" sz="4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1C7B2F09-2433-85C6-650D-A04418A8562C}"/>
              </a:ext>
            </a:extLst>
          </p:cNvPr>
          <p:cNvSpPr txBox="1"/>
          <p:nvPr/>
        </p:nvSpPr>
        <p:spPr>
          <a:xfrm>
            <a:off x="15871234" y="19282227"/>
            <a:ext cx="1011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4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sz="4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1BEE9B4C-EB03-7FE3-597A-96E5E429D711}"/>
              </a:ext>
            </a:extLst>
          </p:cNvPr>
          <p:cNvSpPr txBox="1"/>
          <p:nvPr/>
        </p:nvSpPr>
        <p:spPr>
          <a:xfrm>
            <a:off x="15871234" y="21501314"/>
            <a:ext cx="183554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4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4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D347B35D-2CE1-4ED2-659B-AFA37EB1555A}"/>
              </a:ext>
            </a:extLst>
          </p:cNvPr>
          <p:cNvSpPr txBox="1"/>
          <p:nvPr/>
        </p:nvSpPr>
        <p:spPr>
          <a:xfrm>
            <a:off x="6037930" y="27509115"/>
            <a:ext cx="701602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-tumor tissue</a:t>
            </a:r>
            <a:endParaRPr kumimoji="1" lang="ja-JP" altLang="en-US" sz="7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C18AAC40-0236-5B8C-AFBE-7D6772BADCCC}"/>
              </a:ext>
            </a:extLst>
          </p:cNvPr>
          <p:cNvSpPr txBox="1"/>
          <p:nvPr/>
        </p:nvSpPr>
        <p:spPr>
          <a:xfrm>
            <a:off x="3150394" y="25725039"/>
            <a:ext cx="11565987" cy="1446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stology/Clinical stage</a:t>
            </a:r>
            <a:endParaRPr kumimoji="1" lang="ja-JP" altLang="en-US" sz="8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7" name="テキスト ボックス 896">
            <a:extLst>
              <a:ext uri="{FF2B5EF4-FFF2-40B4-BE49-F238E27FC236}">
                <a16:creationId xmlns:a16="http://schemas.microsoft.com/office/drawing/2014/main" id="{6AEC5011-F32B-E83C-2939-981C2F6EB77D}"/>
              </a:ext>
            </a:extLst>
          </p:cNvPr>
          <p:cNvSpPr txBox="1"/>
          <p:nvPr/>
        </p:nvSpPr>
        <p:spPr>
          <a:xfrm>
            <a:off x="6037930" y="28893858"/>
            <a:ext cx="8572731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 tissue: Stage I</a:t>
            </a:r>
            <a:endParaRPr kumimoji="1" lang="ja-JP" altLang="en-US" sz="7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1" name="テキスト ボックス 900">
            <a:extLst>
              <a:ext uri="{FF2B5EF4-FFF2-40B4-BE49-F238E27FC236}">
                <a16:creationId xmlns:a16="http://schemas.microsoft.com/office/drawing/2014/main" id="{70FB0982-2253-430E-AAAB-EC43769B1A1A}"/>
              </a:ext>
            </a:extLst>
          </p:cNvPr>
          <p:cNvSpPr txBox="1"/>
          <p:nvPr/>
        </p:nvSpPr>
        <p:spPr>
          <a:xfrm>
            <a:off x="6037930" y="30278601"/>
            <a:ext cx="8931804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 tissue: Stage II</a:t>
            </a:r>
            <a:endParaRPr kumimoji="1" lang="ja-JP" altLang="en-US" sz="7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2" name="テキスト ボックス 901">
            <a:extLst>
              <a:ext uri="{FF2B5EF4-FFF2-40B4-BE49-F238E27FC236}">
                <a16:creationId xmlns:a16="http://schemas.microsoft.com/office/drawing/2014/main" id="{6FC3C29F-811E-34D7-AB4E-B83350FF1199}"/>
              </a:ext>
            </a:extLst>
          </p:cNvPr>
          <p:cNvSpPr txBox="1"/>
          <p:nvPr/>
        </p:nvSpPr>
        <p:spPr>
          <a:xfrm>
            <a:off x="6037930" y="31663344"/>
            <a:ext cx="9290877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 tissue: Stage III</a:t>
            </a:r>
            <a:endParaRPr kumimoji="1" lang="ja-JP" altLang="en-US" sz="7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5" name="テキスト ボックス 904">
            <a:extLst>
              <a:ext uri="{FF2B5EF4-FFF2-40B4-BE49-F238E27FC236}">
                <a16:creationId xmlns:a16="http://schemas.microsoft.com/office/drawing/2014/main" id="{B9544693-E1CA-5C7E-57C0-A23B8B4FFD15}"/>
              </a:ext>
            </a:extLst>
          </p:cNvPr>
          <p:cNvSpPr txBox="1"/>
          <p:nvPr/>
        </p:nvSpPr>
        <p:spPr>
          <a:xfrm>
            <a:off x="6037930" y="33048087"/>
            <a:ext cx="9239581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 tissue: Stage IV</a:t>
            </a:r>
            <a:endParaRPr kumimoji="1" lang="ja-JP" altLang="en-US" sz="7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07" name="図 906">
            <a:extLst>
              <a:ext uri="{FF2B5EF4-FFF2-40B4-BE49-F238E27FC236}">
                <a16:creationId xmlns:a16="http://schemas.microsoft.com/office/drawing/2014/main" id="{7F7BD014-4C3A-08B9-72FE-1CF66BAA1474}"/>
              </a:ext>
            </a:extLst>
          </p:cNvPr>
          <p:cNvPicPr>
            <a:picLocks noChangeAspect="1"/>
          </p:cNvPicPr>
          <p:nvPr/>
        </p:nvPicPr>
        <p:blipFill>
          <a:blip r:embed="rId34"/>
          <a:stretch>
            <a:fillRect/>
          </a:stretch>
        </p:blipFill>
        <p:spPr>
          <a:xfrm>
            <a:off x="3526311" y="27476515"/>
            <a:ext cx="2446182" cy="6671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00808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9</TotalTime>
  <Words>105</Words>
  <Application>Microsoft Office PowerPoint</Application>
  <PresentationFormat>Custom</PresentationFormat>
  <Paragraphs>4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Times New Roman</vt:lpstr>
      <vt:lpstr>Office ​​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DELL</dc:creator>
  <cp:lastModifiedBy>MDPI</cp:lastModifiedBy>
  <cp:revision>28</cp:revision>
  <dcterms:created xsi:type="dcterms:W3CDTF">2024-09-08T05:49:26Z</dcterms:created>
  <dcterms:modified xsi:type="dcterms:W3CDTF">2025-08-12T08:17:30Z</dcterms:modified>
</cp:coreProperties>
</file>